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43" r:id="rId4"/>
  </p:sldMasterIdLst>
  <p:notesMasterIdLst>
    <p:notesMasterId r:id="rId8"/>
  </p:notesMasterIdLst>
  <p:handoutMasterIdLst>
    <p:handoutMasterId r:id="rId9"/>
  </p:handoutMasterIdLst>
  <p:sldIdLst>
    <p:sldId id="4430" r:id="rId5"/>
    <p:sldId id="4431" r:id="rId6"/>
    <p:sldId id="4432" r:id="rId7"/>
  </p:sldIdLst>
  <p:sldSz cx="16238538" cy="9134475"/>
  <p:notesSz cx="7010400" cy="9296400"/>
  <p:custDataLst>
    <p:tags r:id="rId10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86" userDrawn="1">
          <p15:clr>
            <a:srgbClr val="A4A3A4"/>
          </p15:clr>
        </p15:guide>
        <p15:guide id="2" pos="1151" userDrawn="1">
          <p15:clr>
            <a:srgbClr val="A4A3A4"/>
          </p15:clr>
        </p15:guide>
        <p15:guide id="4" orient="horz" pos="2270" userDrawn="1">
          <p15:clr>
            <a:srgbClr val="A4A3A4"/>
          </p15:clr>
        </p15:guide>
        <p15:guide id="5" pos="5785" userDrawn="1">
          <p15:clr>
            <a:srgbClr val="A4A3A4"/>
          </p15:clr>
        </p15:guide>
        <p15:guide id="6" orient="horz" pos="1758" userDrawn="1">
          <p15:clr>
            <a:srgbClr val="A4A3A4"/>
          </p15:clr>
        </p15:guide>
        <p15:guide id="7" pos="559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28" userDrawn="1">
          <p15:clr>
            <a:srgbClr val="A4A3A4"/>
          </p15:clr>
        </p15:guide>
        <p15:guide id="2" pos="2208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6F21364-928B-AEE5-9CD7-CB2F230590CC}" name="Fox, Elizabeth" initials="FE" userId="S::Elizabeth.Fox@fda.gov::c7619ef2-11a7-4c4f-9237-3743934715e8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enderson , Turi (US - Seattle)" initials="" lastIdx="4" clrIdx="0"/>
  <p:cmAuthor id="7" name="Limonte, Kelvin" initials="KL" lastIdx="2" clrIdx="5">
    <p:extLst>
      <p:ext uri="{19B8F6BF-5375-455C-9EA6-DF929625EA0E}">
        <p15:presenceInfo xmlns:p15="http://schemas.microsoft.com/office/powerpoint/2012/main" userId="Limonte, Kelvin" providerId="None"/>
      </p:ext>
    </p:extLst>
  </p:cmAuthor>
  <p:cmAuthor id="1" name="Youra, Ryan" initials="RY" lastIdx="60" clrIdx="1">
    <p:extLst>
      <p:ext uri="{19B8F6BF-5375-455C-9EA6-DF929625EA0E}">
        <p15:presenceInfo xmlns:p15="http://schemas.microsoft.com/office/powerpoint/2012/main" userId="Youra, Ryan" providerId="None"/>
      </p:ext>
    </p:extLst>
  </p:cmAuthor>
  <p:cmAuthor id="8" name="Administrator" initials="A" lastIdx="1" clrIdx="6">
    <p:extLst>
      <p:ext uri="{19B8F6BF-5375-455C-9EA6-DF929625EA0E}">
        <p15:presenceInfo xmlns:p15="http://schemas.microsoft.com/office/powerpoint/2012/main" userId="Administrator" providerId="None"/>
      </p:ext>
    </p:extLst>
  </p:cmAuthor>
  <p:cmAuthor id="2" name="Flores, Beth" initials="BF" lastIdx="6" clrIdx="2">
    <p:extLst>
      <p:ext uri="{19B8F6BF-5375-455C-9EA6-DF929625EA0E}">
        <p15:presenceInfo xmlns:p15="http://schemas.microsoft.com/office/powerpoint/2012/main" userId="Flores, Beth" providerId="None"/>
      </p:ext>
    </p:extLst>
  </p:cmAuthor>
  <p:cmAuthor id="9" name="Boghosian, Elissa *" initials="BE*" lastIdx="12" clrIdx="7">
    <p:extLst>
      <p:ext uri="{19B8F6BF-5375-455C-9EA6-DF929625EA0E}">
        <p15:presenceInfo xmlns:p15="http://schemas.microsoft.com/office/powerpoint/2012/main" userId="S-1-5-21-1078081533-606747145-839522115-435505" providerId="AD"/>
      </p:ext>
    </p:extLst>
  </p:cmAuthor>
  <p:cmAuthor id="3" name="Wilcox, Ellen" initials="EW" lastIdx="11" clrIdx="3">
    <p:extLst>
      <p:ext uri="{19B8F6BF-5375-455C-9EA6-DF929625EA0E}">
        <p15:presenceInfo xmlns:p15="http://schemas.microsoft.com/office/powerpoint/2012/main" userId="Wilcox, Ellen" providerId="None"/>
      </p:ext>
    </p:extLst>
  </p:cmAuthor>
  <p:cmAuthor id="10" name="Duncan, Ashley *" initials="DA*" lastIdx="4" clrIdx="8">
    <p:extLst>
      <p:ext uri="{19B8F6BF-5375-455C-9EA6-DF929625EA0E}">
        <p15:presenceInfo xmlns:p15="http://schemas.microsoft.com/office/powerpoint/2012/main" userId="S-1-5-21-1078081533-606747145-839522115-463334" providerId="AD"/>
      </p:ext>
    </p:extLst>
  </p:cmAuthor>
  <p:cmAuthor id="11" name="Boghosian, Elissa *" initials="BE* [2]" lastIdx="9" clrIdx="9">
    <p:extLst>
      <p:ext uri="{19B8F6BF-5375-455C-9EA6-DF929625EA0E}">
        <p15:presenceInfo xmlns:p15="http://schemas.microsoft.com/office/powerpoint/2012/main" userId="S::Elissa.Boghosian@fda.gov::5f47d4c4-a0c7-4fd1-b662-e5c56a970c8d" providerId="AD"/>
      </p:ext>
    </p:extLst>
  </p:cmAuthor>
  <p:cmAuthor id="6" name="Zaccack, Christine" initials="CZ" lastIdx="65" clrIdx="4">
    <p:extLst>
      <p:ext uri="{19B8F6BF-5375-455C-9EA6-DF929625EA0E}">
        <p15:presenceInfo xmlns:p15="http://schemas.microsoft.com/office/powerpoint/2012/main" userId="Zaccack, Christin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0C0"/>
    <a:srgbClr val="007CBB"/>
    <a:srgbClr val="003399"/>
    <a:srgbClr val="002060"/>
    <a:srgbClr val="0033CC"/>
    <a:srgbClr val="0041C4"/>
    <a:srgbClr val="CCECFF"/>
    <a:srgbClr val="99CCFF"/>
    <a:srgbClr val="0E94C4"/>
    <a:srgbClr val="0F9D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66B22D4-64C9-4994-ACFA-5FB4CEA10DC4}" v="44" dt="2025-03-19T15:45:30.3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715" y="58"/>
      </p:cViewPr>
      <p:guideLst>
        <p:guide orient="horz" pos="1886"/>
        <p:guide pos="1151"/>
        <p:guide orient="horz" pos="2270"/>
        <p:guide pos="5785"/>
        <p:guide orient="horz" pos="1758"/>
        <p:guide pos="5594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66" d="100"/>
          <a:sy n="66" d="100"/>
        </p:scale>
        <p:origin x="0" y="0"/>
      </p:cViewPr>
      <p:guideLst>
        <p:guide orient="horz" pos="2928"/>
        <p:guide pos="2208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tags" Target="tags/tag1.xml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ox, Elizabeth" userId="c7619ef2-11a7-4c4f-9237-3743934715e8" providerId="ADAL" clId="{066B22D4-64C9-4994-ACFA-5FB4CEA10DC4}"/>
    <pc:docChg chg="undo custSel addSld delSld modSld sldOrd delMainMaster">
      <pc:chgData name="Fox, Elizabeth" userId="c7619ef2-11a7-4c4f-9237-3743934715e8" providerId="ADAL" clId="{066B22D4-64C9-4994-ACFA-5FB4CEA10DC4}" dt="2025-03-14T20:15:21.597" v="1318" actId="478"/>
      <pc:docMkLst>
        <pc:docMk/>
      </pc:docMkLst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1115565229" sldId="260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717490579" sldId="269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63978595" sldId="270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1166788577" sldId="1488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454930851" sldId="4351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1578708997" sldId="4352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2533803363" sldId="4372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3916435092" sldId="4382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1723895395" sldId="4385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4122756299" sldId="4387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922301501" sldId="4389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3925640968" sldId="4390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2326119656" sldId="4391"/>
        </pc:sldMkLst>
      </pc:sldChg>
      <pc:sldChg chg="del">
        <pc:chgData name="Fox, Elizabeth" userId="c7619ef2-11a7-4c4f-9237-3743934715e8" providerId="ADAL" clId="{066B22D4-64C9-4994-ACFA-5FB4CEA10DC4}" dt="2025-03-14T19:36:56.699" v="814" actId="47"/>
        <pc:sldMkLst>
          <pc:docMk/>
          <pc:sldMk cId="2179818741" sldId="4395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1896079252" sldId="4402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4217333061" sldId="4403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495694577" sldId="4405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986193357" sldId="4408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848785027" sldId="4409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343874850" sldId="4410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873867675" sldId="4412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281256148" sldId="4413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46060928" sldId="4417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4068100942" sldId="4418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2180268214" sldId="4419"/>
        </pc:sldMkLst>
      </pc:sldChg>
      <pc:sldChg chg="del">
        <pc:chgData name="Fox, Elizabeth" userId="c7619ef2-11a7-4c4f-9237-3743934715e8" providerId="ADAL" clId="{066B22D4-64C9-4994-ACFA-5FB4CEA10DC4}" dt="2025-03-14T16:15:48.926" v="0" actId="47"/>
        <pc:sldMkLst>
          <pc:docMk/>
          <pc:sldMk cId="3958248049" sldId="4420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3819498997" sldId="4421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4270212549" sldId="4422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192437138" sldId="4423"/>
        </pc:sldMkLst>
      </pc:sldChg>
      <pc:sldChg chg="del">
        <pc:chgData name="Fox, Elizabeth" userId="c7619ef2-11a7-4c4f-9237-3743934715e8" providerId="ADAL" clId="{066B22D4-64C9-4994-ACFA-5FB4CEA10DC4}" dt="2025-03-14T16:18:22.215" v="1" actId="47"/>
        <pc:sldMkLst>
          <pc:docMk/>
          <pc:sldMk cId="1093226656" sldId="4424"/>
        </pc:sldMkLst>
      </pc:sldChg>
      <pc:sldChg chg="del ord">
        <pc:chgData name="Fox, Elizabeth" userId="c7619ef2-11a7-4c4f-9237-3743934715e8" providerId="ADAL" clId="{066B22D4-64C9-4994-ACFA-5FB4CEA10DC4}" dt="2025-03-14T19:36:59.838" v="815" actId="47"/>
        <pc:sldMkLst>
          <pc:docMk/>
          <pc:sldMk cId="1645337548" sldId="4428"/>
        </pc:sldMkLst>
      </pc:sldChg>
      <pc:sldChg chg="modSp del mod">
        <pc:chgData name="Fox, Elizabeth" userId="c7619ef2-11a7-4c4f-9237-3743934715e8" providerId="ADAL" clId="{066B22D4-64C9-4994-ACFA-5FB4CEA10DC4}" dt="2025-03-14T19:36:55.755" v="813" actId="47"/>
        <pc:sldMkLst>
          <pc:docMk/>
          <pc:sldMk cId="378010136" sldId="4429"/>
        </pc:sldMkLst>
        <pc:spChg chg="mod">
          <ac:chgData name="Fox, Elizabeth" userId="c7619ef2-11a7-4c4f-9237-3743934715e8" providerId="ADAL" clId="{066B22D4-64C9-4994-ACFA-5FB4CEA10DC4}" dt="2025-03-14T16:19:05.881" v="45" actId="20577"/>
          <ac:spMkLst>
            <pc:docMk/>
            <pc:sldMk cId="378010136" sldId="4429"/>
            <ac:spMk id="4" creationId="{9C4BE88C-C863-4034-91D9-C4B91D84C98A}"/>
          </ac:spMkLst>
        </pc:spChg>
      </pc:sldChg>
      <pc:sldChg chg="addSp delSp modSp mod ord">
        <pc:chgData name="Fox, Elizabeth" userId="c7619ef2-11a7-4c4f-9237-3743934715e8" providerId="ADAL" clId="{066B22D4-64C9-4994-ACFA-5FB4CEA10DC4}" dt="2025-03-14T19:11:34.540" v="610" actId="113"/>
        <pc:sldMkLst>
          <pc:docMk/>
          <pc:sldMk cId="572302540" sldId="4430"/>
        </pc:sldMkLst>
        <pc:spChg chg="add mod">
          <ac:chgData name="Fox, Elizabeth" userId="c7619ef2-11a7-4c4f-9237-3743934715e8" providerId="ADAL" clId="{066B22D4-64C9-4994-ACFA-5FB4CEA10DC4}" dt="2025-03-14T18:44:28.430" v="512" actId="1076"/>
          <ac:spMkLst>
            <pc:docMk/>
            <pc:sldMk cId="572302540" sldId="4430"/>
            <ac:spMk id="2" creationId="{48F0E557-EF5E-0B44-3985-0B7EE13321DE}"/>
          </ac:spMkLst>
        </pc:spChg>
        <pc:spChg chg="del mod">
          <ac:chgData name="Fox, Elizabeth" userId="c7619ef2-11a7-4c4f-9237-3743934715e8" providerId="ADAL" clId="{066B22D4-64C9-4994-ACFA-5FB4CEA10DC4}" dt="2025-03-14T16:45:03.535" v="354" actId="478"/>
          <ac:spMkLst>
            <pc:docMk/>
            <pc:sldMk cId="572302540" sldId="4430"/>
            <ac:spMk id="3" creationId="{7850BC81-6DB9-45FA-671D-E598E899E8F6}"/>
          </ac:spMkLst>
        </pc:spChg>
        <pc:spChg chg="add mod">
          <ac:chgData name="Fox, Elizabeth" userId="c7619ef2-11a7-4c4f-9237-3743934715e8" providerId="ADAL" clId="{066B22D4-64C9-4994-ACFA-5FB4CEA10DC4}" dt="2025-03-14T19:05:16.534" v="573" actId="1076"/>
          <ac:spMkLst>
            <pc:docMk/>
            <pc:sldMk cId="572302540" sldId="4430"/>
            <ac:spMk id="4" creationId="{BC9F2C6C-A622-6453-55B0-A93790119DEC}"/>
          </ac:spMkLst>
        </pc:spChg>
        <pc:spChg chg="del mod">
          <ac:chgData name="Fox, Elizabeth" userId="c7619ef2-11a7-4c4f-9237-3743934715e8" providerId="ADAL" clId="{066B22D4-64C9-4994-ACFA-5FB4CEA10DC4}" dt="2025-03-14T16:45:42.287" v="358" actId="478"/>
          <ac:spMkLst>
            <pc:docMk/>
            <pc:sldMk cId="572302540" sldId="4430"/>
            <ac:spMk id="5" creationId="{8AD0470B-C00C-4535-38A3-C9CA3EA1707B}"/>
          </ac:spMkLst>
        </pc:spChg>
        <pc:spChg chg="add mod">
          <ac:chgData name="Fox, Elizabeth" userId="c7619ef2-11a7-4c4f-9237-3743934715e8" providerId="ADAL" clId="{066B22D4-64C9-4994-ACFA-5FB4CEA10DC4}" dt="2025-03-14T18:45:32.504" v="518" actId="1076"/>
          <ac:spMkLst>
            <pc:docMk/>
            <pc:sldMk cId="572302540" sldId="4430"/>
            <ac:spMk id="7" creationId="{F87652BD-25F9-AF1E-4F74-3A0B357A1937}"/>
          </ac:spMkLst>
        </pc:spChg>
        <pc:spChg chg="add mod">
          <ac:chgData name="Fox, Elizabeth" userId="c7619ef2-11a7-4c4f-9237-3743934715e8" providerId="ADAL" clId="{066B22D4-64C9-4994-ACFA-5FB4CEA10DC4}" dt="2025-03-14T18:45:56.359" v="519" actId="1076"/>
          <ac:spMkLst>
            <pc:docMk/>
            <pc:sldMk cId="572302540" sldId="4430"/>
            <ac:spMk id="8" creationId="{29BDCD46-D6C0-0BDC-DAE7-76660CD41B02}"/>
          </ac:spMkLst>
        </pc:spChg>
        <pc:spChg chg="mod">
          <ac:chgData name="Fox, Elizabeth" userId="c7619ef2-11a7-4c4f-9237-3743934715e8" providerId="ADAL" clId="{066B22D4-64C9-4994-ACFA-5FB4CEA10DC4}" dt="2025-03-14T18:49:51.306" v="533" actId="3064"/>
          <ac:spMkLst>
            <pc:docMk/>
            <pc:sldMk cId="572302540" sldId="4430"/>
            <ac:spMk id="9" creationId="{95554766-1846-05A4-C9AA-7CC6DA28DE0F}"/>
          </ac:spMkLst>
        </pc:spChg>
        <pc:spChg chg="add del mod">
          <ac:chgData name="Fox, Elizabeth" userId="c7619ef2-11a7-4c4f-9237-3743934715e8" providerId="ADAL" clId="{066B22D4-64C9-4994-ACFA-5FB4CEA10DC4}" dt="2025-03-14T18:41:16.527" v="491" actId="478"/>
          <ac:spMkLst>
            <pc:docMk/>
            <pc:sldMk cId="572302540" sldId="4430"/>
            <ac:spMk id="13" creationId="{E992EF13-0A00-9C12-C815-D6E4E5386AC4}"/>
          </ac:spMkLst>
        </pc:spChg>
        <pc:spChg chg="add mod">
          <ac:chgData name="Fox, Elizabeth" userId="c7619ef2-11a7-4c4f-9237-3743934715e8" providerId="ADAL" clId="{066B22D4-64C9-4994-ACFA-5FB4CEA10DC4}" dt="2025-03-14T18:32:41.781" v="387" actId="1035"/>
          <ac:spMkLst>
            <pc:docMk/>
            <pc:sldMk cId="572302540" sldId="4430"/>
            <ac:spMk id="15" creationId="{8079A2E5-6894-C42A-EABD-69CEC6EB9004}"/>
          </ac:spMkLst>
        </pc:spChg>
        <pc:spChg chg="add mod">
          <ac:chgData name="Fox, Elizabeth" userId="c7619ef2-11a7-4c4f-9237-3743934715e8" providerId="ADAL" clId="{066B22D4-64C9-4994-ACFA-5FB4CEA10DC4}" dt="2025-03-14T18:50:02.035" v="538" actId="3064"/>
          <ac:spMkLst>
            <pc:docMk/>
            <pc:sldMk cId="572302540" sldId="4430"/>
            <ac:spMk id="16" creationId="{3E4024BC-582C-0DD9-C905-88F1CAC25C7B}"/>
          </ac:spMkLst>
        </pc:spChg>
        <pc:spChg chg="mod">
          <ac:chgData name="Fox, Elizabeth" userId="c7619ef2-11a7-4c4f-9237-3743934715e8" providerId="ADAL" clId="{066B22D4-64C9-4994-ACFA-5FB4CEA10DC4}" dt="2025-03-14T19:06:45.404" v="592" actId="1076"/>
          <ac:spMkLst>
            <pc:docMk/>
            <pc:sldMk cId="572302540" sldId="4430"/>
            <ac:spMk id="17" creationId="{7AF8CDC5-4C8B-EBEB-37CD-3256B7B5B461}"/>
          </ac:spMkLst>
        </pc:spChg>
        <pc:spChg chg="add mod">
          <ac:chgData name="Fox, Elizabeth" userId="c7619ef2-11a7-4c4f-9237-3743934715e8" providerId="ADAL" clId="{066B22D4-64C9-4994-ACFA-5FB4CEA10DC4}" dt="2025-03-14T18:50:07.938" v="541" actId="3064"/>
          <ac:spMkLst>
            <pc:docMk/>
            <pc:sldMk cId="572302540" sldId="4430"/>
            <ac:spMk id="18" creationId="{DA24E9AC-0EE4-EAED-7343-62085B26AE47}"/>
          </ac:spMkLst>
        </pc:spChg>
        <pc:spChg chg="add mod">
          <ac:chgData name="Fox, Elizabeth" userId="c7619ef2-11a7-4c4f-9237-3743934715e8" providerId="ADAL" clId="{066B22D4-64C9-4994-ACFA-5FB4CEA10DC4}" dt="2025-03-14T18:50:17.616" v="544" actId="3064"/>
          <ac:spMkLst>
            <pc:docMk/>
            <pc:sldMk cId="572302540" sldId="4430"/>
            <ac:spMk id="19" creationId="{243A0F6B-54E6-92E1-0799-A8CFD88E8E62}"/>
          </ac:spMkLst>
        </pc:spChg>
        <pc:spChg chg="add mod">
          <ac:chgData name="Fox, Elizabeth" userId="c7619ef2-11a7-4c4f-9237-3743934715e8" providerId="ADAL" clId="{066B22D4-64C9-4994-ACFA-5FB4CEA10DC4}" dt="2025-03-14T18:50:23.542" v="547" actId="3064"/>
          <ac:spMkLst>
            <pc:docMk/>
            <pc:sldMk cId="572302540" sldId="4430"/>
            <ac:spMk id="20" creationId="{032D2EFF-F023-1F5F-348A-8BDC99C3F6CF}"/>
          </ac:spMkLst>
        </pc:spChg>
        <pc:spChg chg="mod">
          <ac:chgData name="Fox, Elizabeth" userId="c7619ef2-11a7-4c4f-9237-3743934715e8" providerId="ADAL" clId="{066B22D4-64C9-4994-ACFA-5FB4CEA10DC4}" dt="2025-03-14T19:11:34.540" v="610" actId="113"/>
          <ac:spMkLst>
            <pc:docMk/>
            <pc:sldMk cId="572302540" sldId="4430"/>
            <ac:spMk id="23" creationId="{A2366861-2BAB-13B1-2693-49238BC4CF13}"/>
          </ac:spMkLst>
        </pc:spChg>
        <pc:spChg chg="add del mod">
          <ac:chgData name="Fox, Elizabeth" userId="c7619ef2-11a7-4c4f-9237-3743934715e8" providerId="ADAL" clId="{066B22D4-64C9-4994-ACFA-5FB4CEA10DC4}" dt="2025-03-14T19:01:36.282" v="550" actId="478"/>
          <ac:spMkLst>
            <pc:docMk/>
            <pc:sldMk cId="572302540" sldId="4430"/>
            <ac:spMk id="27" creationId="{566BF526-5270-7E17-394E-FCB6E15FA30A}"/>
          </ac:spMkLst>
        </pc:spChg>
        <pc:spChg chg="add del mod">
          <ac:chgData name="Fox, Elizabeth" userId="c7619ef2-11a7-4c4f-9237-3743934715e8" providerId="ADAL" clId="{066B22D4-64C9-4994-ACFA-5FB4CEA10DC4}" dt="2025-03-14T19:03:32.025" v="552" actId="478"/>
          <ac:spMkLst>
            <pc:docMk/>
            <pc:sldMk cId="572302540" sldId="4430"/>
            <ac:spMk id="28" creationId="{04E23E85-D02F-8A73-8C9C-F49D3907AF5C}"/>
          </ac:spMkLst>
        </pc:spChg>
        <pc:spChg chg="add del mod">
          <ac:chgData name="Fox, Elizabeth" userId="c7619ef2-11a7-4c4f-9237-3743934715e8" providerId="ADAL" clId="{066B22D4-64C9-4994-ACFA-5FB4CEA10DC4}" dt="2025-03-14T19:03:32.025" v="552" actId="478"/>
          <ac:spMkLst>
            <pc:docMk/>
            <pc:sldMk cId="572302540" sldId="4430"/>
            <ac:spMk id="29" creationId="{41C7ABC4-4345-E6FE-6B5C-7BD1B0A55A38}"/>
          </ac:spMkLst>
        </pc:spChg>
        <pc:spChg chg="mod ord">
          <ac:chgData name="Fox, Elizabeth" userId="c7619ef2-11a7-4c4f-9237-3743934715e8" providerId="ADAL" clId="{066B22D4-64C9-4994-ACFA-5FB4CEA10DC4}" dt="2025-03-14T18:44:37.063" v="513" actId="1076"/>
          <ac:spMkLst>
            <pc:docMk/>
            <pc:sldMk cId="572302540" sldId="4430"/>
            <ac:spMk id="30" creationId="{FA32D3DF-8446-5AE3-3D82-FCA6AA8F80B9}"/>
          </ac:spMkLst>
        </pc:spChg>
        <pc:spChg chg="add mod">
          <ac:chgData name="Fox, Elizabeth" userId="c7619ef2-11a7-4c4f-9237-3743934715e8" providerId="ADAL" clId="{066B22D4-64C9-4994-ACFA-5FB4CEA10DC4}" dt="2025-03-14T19:06:37.514" v="591" actId="14100"/>
          <ac:spMkLst>
            <pc:docMk/>
            <pc:sldMk cId="572302540" sldId="4430"/>
            <ac:spMk id="31" creationId="{6858FF28-828A-5D62-EFC1-BA776333B0D0}"/>
          </ac:spMkLst>
        </pc:spChg>
        <pc:spChg chg="del mod">
          <ac:chgData name="Fox, Elizabeth" userId="c7619ef2-11a7-4c4f-9237-3743934715e8" providerId="ADAL" clId="{066B22D4-64C9-4994-ACFA-5FB4CEA10DC4}" dt="2025-03-14T16:45:45.127" v="360" actId="478"/>
          <ac:spMkLst>
            <pc:docMk/>
            <pc:sldMk cId="572302540" sldId="4430"/>
            <ac:spMk id="87" creationId="{91148E0B-3D09-FAA1-BE0B-3E86E5F11A68}"/>
          </ac:spMkLst>
        </pc:spChg>
        <pc:spChg chg="del mod">
          <ac:chgData name="Fox, Elizabeth" userId="c7619ef2-11a7-4c4f-9237-3743934715e8" providerId="ADAL" clId="{066B22D4-64C9-4994-ACFA-5FB4CEA10DC4}" dt="2025-03-14T16:45:04.923" v="356" actId="478"/>
          <ac:spMkLst>
            <pc:docMk/>
            <pc:sldMk cId="572302540" sldId="4430"/>
            <ac:spMk id="88" creationId="{58A38280-650F-432C-6BC2-A682A7CE02F2}"/>
          </ac:spMkLst>
        </pc:spChg>
        <pc:spChg chg="del mod">
          <ac:chgData name="Fox, Elizabeth" userId="c7619ef2-11a7-4c4f-9237-3743934715e8" providerId="ADAL" clId="{066B22D4-64C9-4994-ACFA-5FB4CEA10DC4}" dt="2025-03-14T16:45:05.538" v="357" actId="478"/>
          <ac:spMkLst>
            <pc:docMk/>
            <pc:sldMk cId="572302540" sldId="4430"/>
            <ac:spMk id="89" creationId="{0F20CEDB-25DE-FDA0-6D62-F6B057E01F11}"/>
          </ac:spMkLst>
        </pc:spChg>
        <pc:spChg chg="del mod">
          <ac:chgData name="Fox, Elizabeth" userId="c7619ef2-11a7-4c4f-9237-3743934715e8" providerId="ADAL" clId="{066B22D4-64C9-4994-ACFA-5FB4CEA10DC4}" dt="2025-03-14T16:45:46.478" v="362" actId="478"/>
          <ac:spMkLst>
            <pc:docMk/>
            <pc:sldMk cId="572302540" sldId="4430"/>
            <ac:spMk id="91" creationId="{3995285A-6D15-32A7-9E85-876365E00BFE}"/>
          </ac:spMkLst>
        </pc:spChg>
        <pc:spChg chg="del mod">
          <ac:chgData name="Fox, Elizabeth" userId="c7619ef2-11a7-4c4f-9237-3743934715e8" providerId="ADAL" clId="{066B22D4-64C9-4994-ACFA-5FB4CEA10DC4}" dt="2025-03-14T16:26:07.382" v="178" actId="478"/>
          <ac:spMkLst>
            <pc:docMk/>
            <pc:sldMk cId="572302540" sldId="4430"/>
            <ac:spMk id="197" creationId="{B2350A9B-F8D2-31FD-9C56-A693A27D0A64}"/>
          </ac:spMkLst>
        </pc:spChg>
        <pc:spChg chg="del mod">
          <ac:chgData name="Fox, Elizabeth" userId="c7619ef2-11a7-4c4f-9237-3743934715e8" providerId="ADAL" clId="{066B22D4-64C9-4994-ACFA-5FB4CEA10DC4}" dt="2025-03-14T16:45:04.365" v="355" actId="478"/>
          <ac:spMkLst>
            <pc:docMk/>
            <pc:sldMk cId="572302540" sldId="4430"/>
            <ac:spMk id="211" creationId="{7052A565-2236-4315-6293-18E53A18285A}"/>
          </ac:spMkLst>
        </pc:spChg>
        <pc:spChg chg="del mod">
          <ac:chgData name="Fox, Elizabeth" userId="c7619ef2-11a7-4c4f-9237-3743934715e8" providerId="ADAL" clId="{066B22D4-64C9-4994-ACFA-5FB4CEA10DC4}" dt="2025-03-14T16:45:44.343" v="359" actId="478"/>
          <ac:spMkLst>
            <pc:docMk/>
            <pc:sldMk cId="572302540" sldId="4430"/>
            <ac:spMk id="212" creationId="{983E39B0-8760-56E9-9296-21D32DA55DEC}"/>
          </ac:spMkLst>
        </pc:spChg>
        <pc:spChg chg="del mod">
          <ac:chgData name="Fox, Elizabeth" userId="c7619ef2-11a7-4c4f-9237-3743934715e8" providerId="ADAL" clId="{066B22D4-64C9-4994-ACFA-5FB4CEA10DC4}" dt="2025-03-14T16:26:27.088" v="183" actId="478"/>
          <ac:spMkLst>
            <pc:docMk/>
            <pc:sldMk cId="572302540" sldId="4430"/>
            <ac:spMk id="214" creationId="{AE94A008-4704-2608-9257-BE2FA548A9BC}"/>
          </ac:spMkLst>
        </pc:spChg>
        <pc:spChg chg="del mod">
          <ac:chgData name="Fox, Elizabeth" userId="c7619ef2-11a7-4c4f-9237-3743934715e8" providerId="ADAL" clId="{066B22D4-64C9-4994-ACFA-5FB4CEA10DC4}" dt="2025-03-14T16:26:08.004" v="179" actId="478"/>
          <ac:spMkLst>
            <pc:docMk/>
            <pc:sldMk cId="572302540" sldId="4430"/>
            <ac:spMk id="215" creationId="{4DE9F3FC-A992-EE4D-C789-617171108FE9}"/>
          </ac:spMkLst>
        </pc:spChg>
        <pc:spChg chg="add mod">
          <ac:chgData name="Fox, Elizabeth" userId="c7619ef2-11a7-4c4f-9237-3743934715e8" providerId="ADAL" clId="{066B22D4-64C9-4994-ACFA-5FB4CEA10DC4}" dt="2025-03-14T19:05:38.494" v="579" actId="164"/>
          <ac:spMkLst>
            <pc:docMk/>
            <pc:sldMk cId="572302540" sldId="4430"/>
            <ac:spMk id="224" creationId="{2E529756-97A7-C052-BFFD-0643CD35AB72}"/>
          </ac:spMkLst>
        </pc:spChg>
        <pc:spChg chg="del mod">
          <ac:chgData name="Fox, Elizabeth" userId="c7619ef2-11a7-4c4f-9237-3743934715e8" providerId="ADAL" clId="{066B22D4-64C9-4994-ACFA-5FB4CEA10DC4}" dt="2025-03-14T16:26:05.962" v="177" actId="478"/>
          <ac:spMkLst>
            <pc:docMk/>
            <pc:sldMk cId="572302540" sldId="4430"/>
            <ac:spMk id="226" creationId="{4410CAC4-4A93-9EDF-4611-6CD0C70577D6}"/>
          </ac:spMkLst>
        </pc:spChg>
        <pc:spChg chg="del mod">
          <ac:chgData name="Fox, Elizabeth" userId="c7619ef2-11a7-4c4f-9237-3743934715e8" providerId="ADAL" clId="{066B22D4-64C9-4994-ACFA-5FB4CEA10DC4}" dt="2025-03-14T16:45:02.607" v="353" actId="478"/>
          <ac:spMkLst>
            <pc:docMk/>
            <pc:sldMk cId="572302540" sldId="4430"/>
            <ac:spMk id="234" creationId="{88B9C0F1-0C4E-8427-CE33-CFBFEC265CCE}"/>
          </ac:spMkLst>
        </pc:spChg>
        <pc:grpChg chg="add mod">
          <ac:chgData name="Fox, Elizabeth" userId="c7619ef2-11a7-4c4f-9237-3743934715e8" providerId="ADAL" clId="{066B22D4-64C9-4994-ACFA-5FB4CEA10DC4}" dt="2025-03-14T18:44:05.507" v="511" actId="408"/>
          <ac:grpSpMkLst>
            <pc:docMk/>
            <pc:sldMk cId="572302540" sldId="4430"/>
            <ac:grpSpMk id="26" creationId="{727C0FC1-44CB-FDAB-7E4B-44BB2BB18B1F}"/>
          </ac:grpSpMkLst>
        </pc:grpChg>
        <pc:grpChg chg="add mod">
          <ac:chgData name="Fox, Elizabeth" userId="c7619ef2-11a7-4c4f-9237-3743934715e8" providerId="ADAL" clId="{066B22D4-64C9-4994-ACFA-5FB4CEA10DC4}" dt="2025-03-14T19:05:44.967" v="580" actId="1076"/>
          <ac:grpSpMkLst>
            <pc:docMk/>
            <pc:sldMk cId="572302540" sldId="4430"/>
            <ac:grpSpMk id="232" creationId="{004B397F-5DBA-900D-DA4F-4781A3D8C52B}"/>
          </ac:grpSpMkLst>
        </pc:grpChg>
        <pc:picChg chg="add del mod">
          <ac:chgData name="Fox, Elizabeth" userId="c7619ef2-11a7-4c4f-9237-3743934715e8" providerId="ADAL" clId="{066B22D4-64C9-4994-ACFA-5FB4CEA10DC4}" dt="2025-03-14T19:05:02.287" v="568" actId="478"/>
          <ac:picMkLst>
            <pc:docMk/>
            <pc:sldMk cId="572302540" sldId="4430"/>
            <ac:picMk id="227" creationId="{82B85A71-D77D-9315-F0D7-8C461F4F3A59}"/>
          </ac:picMkLst>
        </pc:picChg>
        <pc:picChg chg="add mod">
          <ac:chgData name="Fox, Elizabeth" userId="c7619ef2-11a7-4c4f-9237-3743934715e8" providerId="ADAL" clId="{066B22D4-64C9-4994-ACFA-5FB4CEA10DC4}" dt="2025-03-14T19:05:58.394" v="582" actId="1076"/>
          <ac:picMkLst>
            <pc:docMk/>
            <pc:sldMk cId="572302540" sldId="4430"/>
            <ac:picMk id="230" creationId="{EBBF7018-51F6-3896-9C8C-C5DBB78E10D4}"/>
          </ac:picMkLst>
        </pc:picChg>
        <pc:cxnChg chg="mod">
          <ac:chgData name="Fox, Elizabeth" userId="c7619ef2-11a7-4c4f-9237-3743934715e8" providerId="ADAL" clId="{066B22D4-64C9-4994-ACFA-5FB4CEA10DC4}" dt="2025-03-14T18:44:05.507" v="511" actId="408"/>
          <ac:cxnSpMkLst>
            <pc:docMk/>
            <pc:sldMk cId="572302540" sldId="4430"/>
            <ac:cxnSpMk id="64" creationId="{893A8FFD-7E3E-93BA-5C84-EE4E396C3574}"/>
          </ac:cxnSpMkLst>
        </pc:cxnChg>
        <pc:cxnChg chg="mod">
          <ac:chgData name="Fox, Elizabeth" userId="c7619ef2-11a7-4c4f-9237-3743934715e8" providerId="ADAL" clId="{066B22D4-64C9-4994-ACFA-5FB4CEA10DC4}" dt="2025-03-14T16:44:54.898" v="352" actId="14100"/>
          <ac:cxnSpMkLst>
            <pc:docMk/>
            <pc:sldMk cId="572302540" sldId="4430"/>
            <ac:cxnSpMk id="65" creationId="{F1CC52F4-D306-948C-10EB-F71EE4AC3BE2}"/>
          </ac:cxnSpMkLst>
        </pc:cxnChg>
        <pc:cxnChg chg="mod">
          <ac:chgData name="Fox, Elizabeth" userId="c7619ef2-11a7-4c4f-9237-3743934715e8" providerId="ADAL" clId="{066B22D4-64C9-4994-ACFA-5FB4CEA10DC4}" dt="2025-03-14T18:43:31.442" v="509" actId="164"/>
          <ac:cxnSpMkLst>
            <pc:docMk/>
            <pc:sldMk cId="572302540" sldId="4430"/>
            <ac:cxnSpMk id="67" creationId="{D5C5F78D-1053-3BF6-8B1C-A29DAE3E8F78}"/>
          </ac:cxnSpMkLst>
        </pc:cxnChg>
        <pc:cxnChg chg="mod">
          <ac:chgData name="Fox, Elizabeth" userId="c7619ef2-11a7-4c4f-9237-3743934715e8" providerId="ADAL" clId="{066B22D4-64C9-4994-ACFA-5FB4CEA10DC4}" dt="2025-03-14T16:36:57.643" v="250" actId="1076"/>
          <ac:cxnSpMkLst>
            <pc:docMk/>
            <pc:sldMk cId="572302540" sldId="4430"/>
            <ac:cxnSpMk id="93" creationId="{CFBCFA57-450B-40A3-7C1C-08D15E1E68D0}"/>
          </ac:cxnSpMkLst>
        </pc:cxnChg>
        <pc:cxnChg chg="mod">
          <ac:chgData name="Fox, Elizabeth" userId="c7619ef2-11a7-4c4f-9237-3743934715e8" providerId="ADAL" clId="{066B22D4-64C9-4994-ACFA-5FB4CEA10DC4}" dt="2025-03-14T18:43:07.105" v="507" actId="14100"/>
          <ac:cxnSpMkLst>
            <pc:docMk/>
            <pc:sldMk cId="572302540" sldId="4430"/>
            <ac:cxnSpMk id="228" creationId="{2A015414-589A-CF9B-1E04-F708E576CEC6}"/>
          </ac:cxnSpMkLst>
        </pc:cxnChg>
        <pc:cxnChg chg="mod">
          <ac:chgData name="Fox, Elizabeth" userId="c7619ef2-11a7-4c4f-9237-3743934715e8" providerId="ADAL" clId="{066B22D4-64C9-4994-ACFA-5FB4CEA10DC4}" dt="2025-03-14T18:43:31.442" v="509" actId="164"/>
          <ac:cxnSpMkLst>
            <pc:docMk/>
            <pc:sldMk cId="572302540" sldId="4430"/>
            <ac:cxnSpMk id="231" creationId="{1DB2FD5F-B8F5-6651-368A-390D7F96CEA7}"/>
          </ac:cxnSpMkLst>
        </pc:cxnChg>
        <pc:cxnChg chg="mod">
          <ac:chgData name="Fox, Elizabeth" userId="c7619ef2-11a7-4c4f-9237-3743934715e8" providerId="ADAL" clId="{066B22D4-64C9-4994-ACFA-5FB4CEA10DC4}" dt="2025-03-14T18:44:05.507" v="511" actId="408"/>
          <ac:cxnSpMkLst>
            <pc:docMk/>
            <pc:sldMk cId="572302540" sldId="4430"/>
            <ac:cxnSpMk id="239" creationId="{197CCC73-C410-8799-7B9D-21EE0701032E}"/>
          </ac:cxnSpMkLst>
        </pc:cxnChg>
      </pc:sldChg>
      <pc:sldChg chg="add del">
        <pc:chgData name="Fox, Elizabeth" userId="c7619ef2-11a7-4c4f-9237-3743934715e8" providerId="ADAL" clId="{066B22D4-64C9-4994-ACFA-5FB4CEA10DC4}" dt="2025-03-14T18:32:57.490" v="389" actId="2890"/>
        <pc:sldMkLst>
          <pc:docMk/>
          <pc:sldMk cId="325664925" sldId="4431"/>
        </pc:sldMkLst>
      </pc:sldChg>
      <pc:sldChg chg="addSp delSp modSp add mod">
        <pc:chgData name="Fox, Elizabeth" userId="c7619ef2-11a7-4c4f-9237-3743934715e8" providerId="ADAL" clId="{066B22D4-64C9-4994-ACFA-5FB4CEA10DC4}" dt="2025-03-14T19:36:12.301" v="812" actId="1076"/>
        <pc:sldMkLst>
          <pc:docMk/>
          <pc:sldMk cId="2837062868" sldId="4431"/>
        </pc:sldMkLst>
        <pc:spChg chg="add del">
          <ac:chgData name="Fox, Elizabeth" userId="c7619ef2-11a7-4c4f-9237-3743934715e8" providerId="ADAL" clId="{066B22D4-64C9-4994-ACFA-5FB4CEA10DC4}" dt="2025-03-14T19:27:28.471" v="712" actId="478"/>
          <ac:spMkLst>
            <pc:docMk/>
            <pc:sldMk cId="2837062868" sldId="4431"/>
            <ac:spMk id="2" creationId="{48F0E557-EF5E-0B44-3985-0B7EE13321DE}"/>
          </ac:spMkLst>
        </pc:spChg>
        <pc:spChg chg="add del">
          <ac:chgData name="Fox, Elizabeth" userId="c7619ef2-11a7-4c4f-9237-3743934715e8" providerId="ADAL" clId="{066B22D4-64C9-4994-ACFA-5FB4CEA10DC4}" dt="2025-03-14T19:34:35.725" v="804" actId="478"/>
          <ac:spMkLst>
            <pc:docMk/>
            <pc:sldMk cId="2837062868" sldId="4431"/>
            <ac:spMk id="4" creationId="{BC9F2C6C-A622-6453-55B0-A93790119DEC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5" creationId="{A96782ED-77BF-CD6C-9547-F27B1C6776CB}"/>
          </ac:spMkLst>
        </pc:spChg>
        <pc:spChg chg="add del">
          <ac:chgData name="Fox, Elizabeth" userId="c7619ef2-11a7-4c4f-9237-3743934715e8" providerId="ADAL" clId="{066B22D4-64C9-4994-ACFA-5FB4CEA10DC4}" dt="2025-03-14T19:34:32.444" v="802" actId="478"/>
          <ac:spMkLst>
            <pc:docMk/>
            <pc:sldMk cId="2837062868" sldId="4431"/>
            <ac:spMk id="7" creationId="{F87652BD-25F9-AF1E-4F74-3A0B357A1937}"/>
          </ac:spMkLst>
        </pc:spChg>
        <pc:spChg chg="add del">
          <ac:chgData name="Fox, Elizabeth" userId="c7619ef2-11a7-4c4f-9237-3743934715e8" providerId="ADAL" clId="{066B22D4-64C9-4994-ACFA-5FB4CEA10DC4}" dt="2025-03-14T19:34:31.285" v="801" actId="478"/>
          <ac:spMkLst>
            <pc:docMk/>
            <pc:sldMk cId="2837062868" sldId="4431"/>
            <ac:spMk id="8" creationId="{29BDCD46-D6C0-0BDC-DAE7-76660CD41B02}"/>
          </ac:spMkLst>
        </pc:spChg>
        <pc:spChg chg="del">
          <ac:chgData name="Fox, Elizabeth" userId="c7619ef2-11a7-4c4f-9237-3743934715e8" providerId="ADAL" clId="{066B22D4-64C9-4994-ACFA-5FB4CEA10DC4}" dt="2025-03-14T19:26:19.832" v="676" actId="478"/>
          <ac:spMkLst>
            <pc:docMk/>
            <pc:sldMk cId="2837062868" sldId="4431"/>
            <ac:spMk id="9" creationId="{95554766-1846-05A4-C9AA-7CC6DA28DE0F}"/>
          </ac:spMkLst>
        </pc:spChg>
        <pc:spChg chg="add mod">
          <ac:chgData name="Fox, Elizabeth" userId="c7619ef2-11a7-4c4f-9237-3743934715e8" providerId="ADAL" clId="{066B22D4-64C9-4994-ACFA-5FB4CEA10DC4}" dt="2025-03-14T19:25:42.733" v="673" actId="1076"/>
          <ac:spMkLst>
            <pc:docMk/>
            <pc:sldMk cId="2837062868" sldId="4431"/>
            <ac:spMk id="10" creationId="{47612DF0-08DB-0FD6-4807-7B6C5DE93B5B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12" creationId="{2C17D492-3C4E-FEDB-0DF1-17E4C0723BEF}"/>
          </ac:spMkLst>
        </pc:spChg>
        <pc:spChg chg="del mod">
          <ac:chgData name="Fox, Elizabeth" userId="c7619ef2-11a7-4c4f-9237-3743934715e8" providerId="ADAL" clId="{066B22D4-64C9-4994-ACFA-5FB4CEA10DC4}" dt="2025-03-14T19:25:45.970" v="675" actId="478"/>
          <ac:spMkLst>
            <pc:docMk/>
            <pc:sldMk cId="2837062868" sldId="4431"/>
            <ac:spMk id="15" creationId="{8079A2E5-6894-C42A-EABD-69CEC6EB9004}"/>
          </ac:spMkLst>
        </pc:spChg>
        <pc:spChg chg="del">
          <ac:chgData name="Fox, Elizabeth" userId="c7619ef2-11a7-4c4f-9237-3743934715e8" providerId="ADAL" clId="{066B22D4-64C9-4994-ACFA-5FB4CEA10DC4}" dt="2025-03-14T19:26:55.576" v="695" actId="478"/>
          <ac:spMkLst>
            <pc:docMk/>
            <pc:sldMk cId="2837062868" sldId="4431"/>
            <ac:spMk id="16" creationId="{3E4024BC-582C-0DD9-C905-88F1CAC25C7B}"/>
          </ac:spMkLst>
        </pc:spChg>
        <pc:spChg chg="mod">
          <ac:chgData name="Fox, Elizabeth" userId="c7619ef2-11a7-4c4f-9237-3743934715e8" providerId="ADAL" clId="{066B22D4-64C9-4994-ACFA-5FB4CEA10DC4}" dt="2025-03-14T19:11:08.619" v="596" actId="20577"/>
          <ac:spMkLst>
            <pc:docMk/>
            <pc:sldMk cId="2837062868" sldId="4431"/>
            <ac:spMk id="17" creationId="{7AF8CDC5-4C8B-EBEB-37CD-3256B7B5B461}"/>
          </ac:spMkLst>
        </pc:spChg>
        <pc:spChg chg="del">
          <ac:chgData name="Fox, Elizabeth" userId="c7619ef2-11a7-4c4f-9237-3743934715e8" providerId="ADAL" clId="{066B22D4-64C9-4994-ACFA-5FB4CEA10DC4}" dt="2025-03-14T19:26:56.621" v="696" actId="478"/>
          <ac:spMkLst>
            <pc:docMk/>
            <pc:sldMk cId="2837062868" sldId="4431"/>
            <ac:spMk id="18" creationId="{DA24E9AC-0EE4-EAED-7343-62085B26AE47}"/>
          </ac:spMkLst>
        </pc:spChg>
        <pc:spChg chg="add del">
          <ac:chgData name="Fox, Elizabeth" userId="c7619ef2-11a7-4c4f-9237-3743934715e8" providerId="ADAL" clId="{066B22D4-64C9-4994-ACFA-5FB4CEA10DC4}" dt="2025-03-14T19:34:27.044" v="798" actId="478"/>
          <ac:spMkLst>
            <pc:docMk/>
            <pc:sldMk cId="2837062868" sldId="4431"/>
            <ac:spMk id="19" creationId="{243A0F6B-54E6-92E1-0799-A8CFD88E8E62}"/>
          </ac:spMkLst>
        </pc:spChg>
        <pc:spChg chg="add del">
          <ac:chgData name="Fox, Elizabeth" userId="c7619ef2-11a7-4c4f-9237-3743934715e8" providerId="ADAL" clId="{066B22D4-64C9-4994-ACFA-5FB4CEA10DC4}" dt="2025-03-14T19:34:28.520" v="799" actId="478"/>
          <ac:spMkLst>
            <pc:docMk/>
            <pc:sldMk cId="2837062868" sldId="4431"/>
            <ac:spMk id="20" creationId="{032D2EFF-F023-1F5F-348A-8BDC99C3F6CF}"/>
          </ac:spMkLst>
        </pc:spChg>
        <pc:spChg chg="del mod">
          <ac:chgData name="Fox, Elizabeth" userId="c7619ef2-11a7-4c4f-9237-3743934715e8" providerId="ADAL" clId="{066B22D4-64C9-4994-ACFA-5FB4CEA10DC4}" dt="2025-03-14T19:25:44.732" v="674" actId="478"/>
          <ac:spMkLst>
            <pc:docMk/>
            <pc:sldMk cId="2837062868" sldId="4431"/>
            <ac:spMk id="23" creationId="{A2366861-2BAB-13B1-2693-49238BC4CF13}"/>
          </ac:spMkLst>
        </pc:spChg>
        <pc:spChg chg="del">
          <ac:chgData name="Fox, Elizabeth" userId="c7619ef2-11a7-4c4f-9237-3743934715e8" providerId="ADAL" clId="{066B22D4-64C9-4994-ACFA-5FB4CEA10DC4}" dt="2025-03-14T19:26:57.552" v="697" actId="478"/>
          <ac:spMkLst>
            <pc:docMk/>
            <pc:sldMk cId="2837062868" sldId="4431"/>
            <ac:spMk id="30" creationId="{FA32D3DF-8446-5AE3-3D82-FCA6AA8F80B9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71" creationId="{8FFFC769-7969-9CC4-64A7-A8E4BD88F00A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72" creationId="{EE0F97DE-E5D5-B6B9-63BB-117093639A74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77" creationId="{9C2D28AA-9F31-1002-937A-FDA34773867B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78" creationId="{A6C5C9B5-C362-FC6C-CAAA-223A8E483E17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83" creationId="{B7AA7911-CAD2-475E-28E9-EBB0BD3A9315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84" creationId="{97CEE436-8E5E-3BB4-E977-27A82BD68440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89" creationId="{60CC2AD0-2C0C-7F57-388A-47F685BA3883}"/>
          </ac:spMkLst>
        </pc:spChg>
        <pc:spChg chg="add mod">
          <ac:chgData name="Fox, Elizabeth" userId="c7619ef2-11a7-4c4f-9237-3743934715e8" providerId="ADAL" clId="{066B22D4-64C9-4994-ACFA-5FB4CEA10DC4}" dt="2025-03-14T19:36:12.301" v="812" actId="1076"/>
          <ac:spMkLst>
            <pc:docMk/>
            <pc:sldMk cId="2837062868" sldId="4431"/>
            <ac:spMk id="90" creationId="{0A0F3AA3-DAB2-6A5C-FE05-3D71E1AA6761}"/>
          </ac:spMkLst>
        </pc:spChg>
        <pc:spChg chg="add mod">
          <ac:chgData name="Fox, Elizabeth" userId="c7619ef2-11a7-4c4f-9237-3743934715e8" providerId="ADAL" clId="{066B22D4-64C9-4994-ACFA-5FB4CEA10DC4}" dt="2025-03-14T19:33:06.913" v="787"/>
          <ac:spMkLst>
            <pc:docMk/>
            <pc:sldMk cId="2837062868" sldId="4431"/>
            <ac:spMk id="248" creationId="{15DF585A-5BDB-3668-E3F9-E3D4F7C3E518}"/>
          </ac:spMkLst>
        </pc:spChg>
        <pc:spChg chg="add mod">
          <ac:chgData name="Fox, Elizabeth" userId="c7619ef2-11a7-4c4f-9237-3743934715e8" providerId="ADAL" clId="{066B22D4-64C9-4994-ACFA-5FB4CEA10DC4}" dt="2025-03-14T19:33:06.913" v="787"/>
          <ac:spMkLst>
            <pc:docMk/>
            <pc:sldMk cId="2837062868" sldId="4431"/>
            <ac:spMk id="249" creationId="{7EF755E9-99C9-45BD-1C55-41AAD2776531}"/>
          </ac:spMkLst>
        </pc:spChg>
        <pc:spChg chg="add mod">
          <ac:chgData name="Fox, Elizabeth" userId="c7619ef2-11a7-4c4f-9237-3743934715e8" providerId="ADAL" clId="{066B22D4-64C9-4994-ACFA-5FB4CEA10DC4}" dt="2025-03-14T19:33:13.421" v="791"/>
          <ac:spMkLst>
            <pc:docMk/>
            <pc:sldMk cId="2837062868" sldId="4431"/>
            <ac:spMk id="254" creationId="{07949E39-E578-D7BA-17FE-A8A733D55890}"/>
          </ac:spMkLst>
        </pc:spChg>
        <pc:spChg chg="add mod">
          <ac:chgData name="Fox, Elizabeth" userId="c7619ef2-11a7-4c4f-9237-3743934715e8" providerId="ADAL" clId="{066B22D4-64C9-4994-ACFA-5FB4CEA10DC4}" dt="2025-03-14T19:33:13.421" v="791"/>
          <ac:spMkLst>
            <pc:docMk/>
            <pc:sldMk cId="2837062868" sldId="4431"/>
            <ac:spMk id="255" creationId="{55809912-032E-1443-F62D-2DC47CCDC481}"/>
          </ac:spMkLst>
        </pc:spChg>
        <pc:grpChg chg="del">
          <ac:chgData name="Fox, Elizabeth" userId="c7619ef2-11a7-4c4f-9237-3743934715e8" providerId="ADAL" clId="{066B22D4-64C9-4994-ACFA-5FB4CEA10DC4}" dt="2025-03-14T19:32:33.516" v="783" actId="165"/>
          <ac:grpSpMkLst>
            <pc:docMk/>
            <pc:sldMk cId="2837062868" sldId="4431"/>
            <ac:grpSpMk id="26" creationId="{727C0FC1-44CB-FDAB-7E4B-44BB2BB18B1F}"/>
          </ac:grpSpMkLst>
        </pc:grp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3" creationId="{EBCCE832-CE61-FEB7-102C-032689F22D30}"/>
          </ac:picMkLst>
        </pc:picChg>
        <pc:picChg chg="add mod">
          <ac:chgData name="Fox, Elizabeth" userId="c7619ef2-11a7-4c4f-9237-3743934715e8" providerId="ADAL" clId="{066B22D4-64C9-4994-ACFA-5FB4CEA10DC4}" dt="2025-03-14T19:25:42.733" v="673" actId="1076"/>
          <ac:picMkLst>
            <pc:docMk/>
            <pc:sldMk cId="2837062868" sldId="4431"/>
            <ac:picMk id="6" creationId="{7955F025-0FB4-3EBD-164B-9FA1320BAFE8}"/>
          </ac:picMkLst>
        </pc:picChg>
        <pc:picChg chg="add mod or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11" creationId="{D9559898-E952-6CEB-EDDD-3CFBACE74693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69" creationId="{D1AEE8A8-2ED9-5092-0745-10DD788C4711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70" creationId="{83EC4CAD-7BD6-AC35-45CE-6EDC1EAE9D6F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75" creationId="{2853FC31-A9AF-CCC6-C30E-CA4BD5F9F648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76" creationId="{3E8D5572-BF51-43B5-6286-0B0177DD0953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81" creationId="{93BB349F-48DA-55DC-1C76-A38753E6B9E0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82" creationId="{90E516A7-215C-8AD4-AF1F-D08523A2A0CB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87" creationId="{5C3F98B8-C288-DBF9-279C-09881CBB7FA0}"/>
          </ac:picMkLst>
        </pc:picChg>
        <pc:picChg chg="add mod">
          <ac:chgData name="Fox, Elizabeth" userId="c7619ef2-11a7-4c4f-9237-3743934715e8" providerId="ADAL" clId="{066B22D4-64C9-4994-ACFA-5FB4CEA10DC4}" dt="2025-03-14T19:36:12.301" v="812" actId="1076"/>
          <ac:picMkLst>
            <pc:docMk/>
            <pc:sldMk cId="2837062868" sldId="4431"/>
            <ac:picMk id="88" creationId="{01E4D9F3-1C4C-7C62-3A60-48569135EA9B}"/>
          </ac:picMkLst>
        </pc:picChg>
        <pc:picChg chg="add mod">
          <ac:chgData name="Fox, Elizabeth" userId="c7619ef2-11a7-4c4f-9237-3743934715e8" providerId="ADAL" clId="{066B22D4-64C9-4994-ACFA-5FB4CEA10DC4}" dt="2025-03-14T19:33:06.913" v="787"/>
          <ac:picMkLst>
            <pc:docMk/>
            <pc:sldMk cId="2837062868" sldId="4431"/>
            <ac:picMk id="246" creationId="{F98F53D1-964E-5EB6-7DDE-5D5D782E9A21}"/>
          </ac:picMkLst>
        </pc:picChg>
        <pc:picChg chg="add mod">
          <ac:chgData name="Fox, Elizabeth" userId="c7619ef2-11a7-4c4f-9237-3743934715e8" providerId="ADAL" clId="{066B22D4-64C9-4994-ACFA-5FB4CEA10DC4}" dt="2025-03-14T19:33:06.913" v="787"/>
          <ac:picMkLst>
            <pc:docMk/>
            <pc:sldMk cId="2837062868" sldId="4431"/>
            <ac:picMk id="247" creationId="{9196CF06-DE1C-AA11-AE40-A3513B8B880B}"/>
          </ac:picMkLst>
        </pc:picChg>
        <pc:picChg chg="add mod">
          <ac:chgData name="Fox, Elizabeth" userId="c7619ef2-11a7-4c4f-9237-3743934715e8" providerId="ADAL" clId="{066B22D4-64C9-4994-ACFA-5FB4CEA10DC4}" dt="2025-03-14T19:33:13.421" v="791"/>
          <ac:picMkLst>
            <pc:docMk/>
            <pc:sldMk cId="2837062868" sldId="4431"/>
            <ac:picMk id="252" creationId="{2EE666BE-D717-253C-C011-847B9331D898}"/>
          </ac:picMkLst>
        </pc:picChg>
        <pc:picChg chg="add mod">
          <ac:chgData name="Fox, Elizabeth" userId="c7619ef2-11a7-4c4f-9237-3743934715e8" providerId="ADAL" clId="{066B22D4-64C9-4994-ACFA-5FB4CEA10DC4}" dt="2025-03-14T19:33:13.421" v="791"/>
          <ac:picMkLst>
            <pc:docMk/>
            <pc:sldMk cId="2837062868" sldId="4431"/>
            <ac:picMk id="253" creationId="{5631E983-EE41-E32F-29C8-369A299E5705}"/>
          </ac:picMkLst>
        </pc:pic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13" creationId="{F7891745-69A5-91D9-FAE0-20FEE5759797}"/>
          </ac:cxnSpMkLst>
        </pc:cxnChg>
        <pc:cxnChg chg="del">
          <ac:chgData name="Fox, Elizabeth" userId="c7619ef2-11a7-4c4f-9237-3743934715e8" providerId="ADAL" clId="{066B22D4-64C9-4994-ACFA-5FB4CEA10DC4}" dt="2025-03-14T19:34:34.812" v="803" actId="478"/>
          <ac:cxnSpMkLst>
            <pc:docMk/>
            <pc:sldMk cId="2837062868" sldId="4431"/>
            <ac:cxnSpMk id="64" creationId="{893A8FFD-7E3E-93BA-5C84-EE4E396C3574}"/>
          </ac:cxnSpMkLst>
        </pc:cxnChg>
        <pc:cxnChg chg="del mod">
          <ac:chgData name="Fox, Elizabeth" userId="c7619ef2-11a7-4c4f-9237-3743934715e8" providerId="ADAL" clId="{066B22D4-64C9-4994-ACFA-5FB4CEA10DC4}" dt="2025-03-14T19:30:08.317" v="730" actId="478"/>
          <ac:cxnSpMkLst>
            <pc:docMk/>
            <pc:sldMk cId="2837062868" sldId="4431"/>
            <ac:cxnSpMk id="65" creationId="{F1CC52F4-D306-948C-10EB-F71EE4AC3BE2}"/>
          </ac:cxnSpMkLst>
        </pc:cxnChg>
        <pc:cxnChg chg="add mod">
          <ac:chgData name="Fox, Elizabeth" userId="c7619ef2-11a7-4c4f-9237-3743934715e8" providerId="ADAL" clId="{066B22D4-64C9-4994-ACFA-5FB4CEA10DC4}" dt="2025-03-14T19:33:13.421" v="791"/>
          <ac:cxnSpMkLst>
            <pc:docMk/>
            <pc:sldMk cId="2837062868" sldId="4431"/>
            <ac:cxnSpMk id="66" creationId="{2163A493-4D66-114B-E98A-3F6AEF384CF1}"/>
          </ac:cxnSpMkLst>
        </pc:cxnChg>
        <pc:cxnChg chg="mod topLvl">
          <ac:chgData name="Fox, Elizabeth" userId="c7619ef2-11a7-4c4f-9237-3743934715e8" providerId="ADAL" clId="{066B22D4-64C9-4994-ACFA-5FB4CEA10DC4}" dt="2025-03-14T19:35:31.630" v="811" actId="14100"/>
          <ac:cxnSpMkLst>
            <pc:docMk/>
            <pc:sldMk cId="2837062868" sldId="4431"/>
            <ac:cxnSpMk id="67" creationId="{D5C5F78D-1053-3BF6-8B1C-A29DAE3E8F78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68" creationId="{695EFDDB-1CE2-E8DE-6BF7-E9642D7165FC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73" creationId="{1F9635D1-35D3-EE68-9CE1-D3E08EA28E35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74" creationId="{1FFCB423-4FD6-1772-5B7B-5A70FFE172DF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79" creationId="{4A443FDC-2FF9-8E61-C85B-1E559E528281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80" creationId="{5207FB32-D034-0592-9819-7C33E2DC4D94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85" creationId="{3D50058A-DFA2-6531-EFDD-2C84C0BB2A31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86" creationId="{61E6ADB0-C1BE-242F-361A-E46322B6B0B5}"/>
          </ac:cxnSpMkLst>
        </pc:cxnChg>
        <pc:cxnChg chg="add 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91" creationId="{ED890302-505D-C20D-F180-C1F26A6B903C}"/>
          </ac:cxnSpMkLst>
        </pc:cxnChg>
        <pc:cxnChg chg="mo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93" creationId="{CFBCFA57-450B-40A3-7C1C-08D15E1E68D0}"/>
          </ac:cxnSpMkLst>
        </pc:cxnChg>
        <pc:cxnChg chg="del">
          <ac:chgData name="Fox, Elizabeth" userId="c7619ef2-11a7-4c4f-9237-3743934715e8" providerId="ADAL" clId="{066B22D4-64C9-4994-ACFA-5FB4CEA10DC4}" dt="2025-03-14T19:34:30.296" v="800" actId="478"/>
          <ac:cxnSpMkLst>
            <pc:docMk/>
            <pc:sldMk cId="2837062868" sldId="4431"/>
            <ac:cxnSpMk id="228" creationId="{2A015414-589A-CF9B-1E04-F708E576CEC6}"/>
          </ac:cxnSpMkLst>
        </pc:cxnChg>
        <pc:cxnChg chg="add mod ord">
          <ac:chgData name="Fox, Elizabeth" userId="c7619ef2-11a7-4c4f-9237-3743934715e8" providerId="ADAL" clId="{066B22D4-64C9-4994-ACFA-5FB4CEA10DC4}" dt="2025-03-14T19:36:12.301" v="812" actId="1076"/>
          <ac:cxnSpMkLst>
            <pc:docMk/>
            <pc:sldMk cId="2837062868" sldId="4431"/>
            <ac:cxnSpMk id="229" creationId="{66683748-14D5-BBFE-AEE9-DB0FC861C10D}"/>
          </ac:cxnSpMkLst>
        </pc:cxnChg>
        <pc:cxnChg chg="del mod topLvl">
          <ac:chgData name="Fox, Elizabeth" userId="c7619ef2-11a7-4c4f-9237-3743934715e8" providerId="ADAL" clId="{066B22D4-64C9-4994-ACFA-5FB4CEA10DC4}" dt="2025-03-14T19:34:37.351" v="805" actId="478"/>
          <ac:cxnSpMkLst>
            <pc:docMk/>
            <pc:sldMk cId="2837062868" sldId="4431"/>
            <ac:cxnSpMk id="231" creationId="{1DB2FD5F-B8F5-6651-368A-390D7F96CEA7}"/>
          </ac:cxnSpMkLst>
        </pc:cxnChg>
        <pc:cxnChg chg="del">
          <ac:chgData name="Fox, Elizabeth" userId="c7619ef2-11a7-4c4f-9237-3743934715e8" providerId="ADAL" clId="{066B22D4-64C9-4994-ACFA-5FB4CEA10DC4}" dt="2025-03-14T19:32:26.168" v="782" actId="478"/>
          <ac:cxnSpMkLst>
            <pc:docMk/>
            <pc:sldMk cId="2837062868" sldId="4431"/>
            <ac:cxnSpMk id="239" creationId="{197CCC73-C410-8799-7B9D-21EE0701032E}"/>
          </ac:cxnSpMkLst>
        </pc:cxnChg>
        <pc:cxnChg chg="add mod">
          <ac:chgData name="Fox, Elizabeth" userId="c7619ef2-11a7-4c4f-9237-3743934715e8" providerId="ADAL" clId="{066B22D4-64C9-4994-ACFA-5FB4CEA10DC4}" dt="2025-03-14T19:33:06.913" v="787"/>
          <ac:cxnSpMkLst>
            <pc:docMk/>
            <pc:sldMk cId="2837062868" sldId="4431"/>
            <ac:cxnSpMk id="245" creationId="{C65E16C9-C5B4-2E94-DE8F-8640E3DF3BCF}"/>
          </ac:cxnSpMkLst>
        </pc:cxnChg>
        <pc:cxnChg chg="add mod">
          <ac:chgData name="Fox, Elizabeth" userId="c7619ef2-11a7-4c4f-9237-3743934715e8" providerId="ADAL" clId="{066B22D4-64C9-4994-ACFA-5FB4CEA10DC4}" dt="2025-03-14T19:33:06.913" v="787"/>
          <ac:cxnSpMkLst>
            <pc:docMk/>
            <pc:sldMk cId="2837062868" sldId="4431"/>
            <ac:cxnSpMk id="250" creationId="{826A1AB0-FC51-FD5F-AB7F-6EFF7ACC2FE6}"/>
          </ac:cxnSpMkLst>
        </pc:cxnChg>
        <pc:cxnChg chg="add mod">
          <ac:chgData name="Fox, Elizabeth" userId="c7619ef2-11a7-4c4f-9237-3743934715e8" providerId="ADAL" clId="{066B22D4-64C9-4994-ACFA-5FB4CEA10DC4}" dt="2025-03-14T19:33:13.421" v="791"/>
          <ac:cxnSpMkLst>
            <pc:docMk/>
            <pc:sldMk cId="2837062868" sldId="4431"/>
            <ac:cxnSpMk id="251" creationId="{23F2EB9D-088D-C1F9-F202-BFF036342E57}"/>
          </ac:cxnSpMkLst>
        </pc:cxnChg>
      </pc:sldChg>
      <pc:sldChg chg="addSp delSp modSp add mod">
        <pc:chgData name="Fox, Elizabeth" userId="c7619ef2-11a7-4c4f-9237-3743934715e8" providerId="ADAL" clId="{066B22D4-64C9-4994-ACFA-5FB4CEA10DC4}" dt="2025-03-14T20:15:21.597" v="1318" actId="478"/>
        <pc:sldMkLst>
          <pc:docMk/>
          <pc:sldMk cId="853343324" sldId="4432"/>
        </pc:sldMkLst>
        <pc:spChg chg="mod">
          <ac:chgData name="Fox, Elizabeth" userId="c7619ef2-11a7-4c4f-9237-3743934715e8" providerId="ADAL" clId="{066B22D4-64C9-4994-ACFA-5FB4CEA10DC4}" dt="2025-03-14T20:12:36.065" v="1272"/>
          <ac:spMkLst>
            <pc:docMk/>
            <pc:sldMk cId="853343324" sldId="4432"/>
            <ac:spMk id="5" creationId="{A96782ED-77BF-CD6C-9547-F27B1C6776CB}"/>
          </ac:spMkLst>
        </pc:spChg>
        <pc:spChg chg="mod">
          <ac:chgData name="Fox, Elizabeth" userId="c7619ef2-11a7-4c4f-9237-3743934715e8" providerId="ADAL" clId="{066B22D4-64C9-4994-ACFA-5FB4CEA10DC4}" dt="2025-03-14T20:12:27.277" v="1268" actId="20577"/>
          <ac:spMkLst>
            <pc:docMk/>
            <pc:sldMk cId="853343324" sldId="4432"/>
            <ac:spMk id="10" creationId="{47612DF0-08DB-0FD6-4807-7B6C5DE93B5B}"/>
          </ac:spMkLst>
        </pc:spChg>
        <pc:spChg chg="mod">
          <ac:chgData name="Fox, Elizabeth" userId="c7619ef2-11a7-4c4f-9237-3743934715e8" providerId="ADAL" clId="{066B22D4-64C9-4994-ACFA-5FB4CEA10DC4}" dt="2025-03-14T20:12:33.242" v="1271"/>
          <ac:spMkLst>
            <pc:docMk/>
            <pc:sldMk cId="853343324" sldId="4432"/>
            <ac:spMk id="12" creationId="{2C17D492-3C4E-FEDB-0DF1-17E4C0723BEF}"/>
          </ac:spMkLst>
        </pc:spChg>
        <pc:spChg chg="mod">
          <ac:chgData name="Fox, Elizabeth" userId="c7619ef2-11a7-4c4f-9237-3743934715e8" providerId="ADAL" clId="{066B22D4-64C9-4994-ACFA-5FB4CEA10DC4}" dt="2025-03-14T19:46:55.502" v="911" actId="20577"/>
          <ac:spMkLst>
            <pc:docMk/>
            <pc:sldMk cId="853343324" sldId="4432"/>
            <ac:spMk id="17" creationId="{7AF8CDC5-4C8B-EBEB-37CD-3256B7B5B461}"/>
          </ac:spMkLst>
        </pc:spChg>
        <pc:spChg chg="add mod">
          <ac:chgData name="Fox, Elizabeth" userId="c7619ef2-11a7-4c4f-9237-3743934715e8" providerId="ADAL" clId="{066B22D4-64C9-4994-ACFA-5FB4CEA10DC4}" dt="2025-03-14T20:12:38.710" v="1273"/>
          <ac:spMkLst>
            <pc:docMk/>
            <pc:sldMk cId="853343324" sldId="4432"/>
            <ac:spMk id="22" creationId="{E6FD9625-DC72-86EF-8796-59D524D8D1A3}"/>
          </ac:spMkLst>
        </pc:spChg>
        <pc:spChg chg="add mod">
          <ac:chgData name="Fox, Elizabeth" userId="c7619ef2-11a7-4c4f-9237-3743934715e8" providerId="ADAL" clId="{066B22D4-64C9-4994-ACFA-5FB4CEA10DC4}" dt="2025-03-14T20:06:43.438" v="1196"/>
          <ac:spMkLst>
            <pc:docMk/>
            <pc:sldMk cId="853343324" sldId="4432"/>
            <ac:spMk id="29" creationId="{20BC3315-CF55-3607-B8B5-3154D2C398C3}"/>
          </ac:spMkLst>
        </pc:spChg>
        <pc:spChg chg="mod">
          <ac:chgData name="Fox, Elizabeth" userId="c7619ef2-11a7-4c4f-9237-3743934715e8" providerId="ADAL" clId="{066B22D4-64C9-4994-ACFA-5FB4CEA10DC4}" dt="2025-03-14T19:46:14.985" v="823" actId="20577"/>
          <ac:spMkLst>
            <pc:docMk/>
            <pc:sldMk cId="853343324" sldId="4432"/>
            <ac:spMk id="31" creationId="{6858FF28-828A-5D62-EFC1-BA776333B0D0}"/>
          </ac:spMkLst>
        </pc:spChg>
        <pc:spChg chg="del mod">
          <ac:chgData name="Fox, Elizabeth" userId="c7619ef2-11a7-4c4f-9237-3743934715e8" providerId="ADAL" clId="{066B22D4-64C9-4994-ACFA-5FB4CEA10DC4}" dt="2025-03-14T20:06:28.717" v="1194" actId="478"/>
          <ac:spMkLst>
            <pc:docMk/>
            <pc:sldMk cId="853343324" sldId="4432"/>
            <ac:spMk id="71" creationId="{8FFFC769-7969-9CC4-64A7-A8E4BD88F00A}"/>
          </ac:spMkLst>
        </pc:spChg>
        <pc:spChg chg="add del mod">
          <ac:chgData name="Fox, Elizabeth" userId="c7619ef2-11a7-4c4f-9237-3743934715e8" providerId="ADAL" clId="{066B22D4-64C9-4994-ACFA-5FB4CEA10DC4}" dt="2025-03-14T20:08:18.172" v="1212" actId="478"/>
          <ac:spMkLst>
            <pc:docMk/>
            <pc:sldMk cId="853343324" sldId="4432"/>
            <ac:spMk id="72" creationId="{EE0F97DE-E5D5-B6B9-63BB-117093639A74}"/>
          </ac:spMkLst>
        </pc:spChg>
        <pc:spChg chg="del">
          <ac:chgData name="Fox, Elizabeth" userId="c7619ef2-11a7-4c4f-9237-3743934715e8" providerId="ADAL" clId="{066B22D4-64C9-4994-ACFA-5FB4CEA10DC4}" dt="2025-03-14T20:06:49.405" v="1197" actId="478"/>
          <ac:spMkLst>
            <pc:docMk/>
            <pc:sldMk cId="853343324" sldId="4432"/>
            <ac:spMk id="77" creationId="{9C2D28AA-9F31-1002-937A-FDA34773867B}"/>
          </ac:spMkLst>
        </pc:spChg>
        <pc:spChg chg="mod">
          <ac:chgData name="Fox, Elizabeth" userId="c7619ef2-11a7-4c4f-9237-3743934715e8" providerId="ADAL" clId="{066B22D4-64C9-4994-ACFA-5FB4CEA10DC4}" dt="2025-03-14T20:12:49.412" v="1276"/>
          <ac:spMkLst>
            <pc:docMk/>
            <pc:sldMk cId="853343324" sldId="4432"/>
            <ac:spMk id="78" creationId="{A6C5C9B5-C362-FC6C-CAAA-223A8E483E17}"/>
          </ac:spMkLst>
        </pc:spChg>
        <pc:spChg chg="del">
          <ac:chgData name="Fox, Elizabeth" userId="c7619ef2-11a7-4c4f-9237-3743934715e8" providerId="ADAL" clId="{066B22D4-64C9-4994-ACFA-5FB4CEA10DC4}" dt="2025-03-14T20:07:50.542" v="1205" actId="478"/>
          <ac:spMkLst>
            <pc:docMk/>
            <pc:sldMk cId="853343324" sldId="4432"/>
            <ac:spMk id="83" creationId="{B7AA7911-CAD2-475E-28E9-EBB0BD3A9315}"/>
          </ac:spMkLst>
        </pc:spChg>
        <pc:spChg chg="del mod">
          <ac:chgData name="Fox, Elizabeth" userId="c7619ef2-11a7-4c4f-9237-3743934715e8" providerId="ADAL" clId="{066B22D4-64C9-4994-ACFA-5FB4CEA10DC4}" dt="2025-03-14T20:10:26.057" v="1261" actId="478"/>
          <ac:spMkLst>
            <pc:docMk/>
            <pc:sldMk cId="853343324" sldId="4432"/>
            <ac:spMk id="84" creationId="{97CEE436-8E5E-3BB4-E977-27A82BD68440}"/>
          </ac:spMkLst>
        </pc:spChg>
        <pc:spChg chg="del">
          <ac:chgData name="Fox, Elizabeth" userId="c7619ef2-11a7-4c4f-9237-3743934715e8" providerId="ADAL" clId="{066B22D4-64C9-4994-ACFA-5FB4CEA10DC4}" dt="2025-03-14T20:13:36.603" v="1303" actId="478"/>
          <ac:spMkLst>
            <pc:docMk/>
            <pc:sldMk cId="853343324" sldId="4432"/>
            <ac:spMk id="89" creationId="{60CC2AD0-2C0C-7F57-388A-47F685BA3883}"/>
          </ac:spMkLst>
        </pc:spChg>
        <pc:spChg chg="mod">
          <ac:chgData name="Fox, Elizabeth" userId="c7619ef2-11a7-4c4f-9237-3743934715e8" providerId="ADAL" clId="{066B22D4-64C9-4994-ACFA-5FB4CEA10DC4}" dt="2025-03-14T20:14:32.557" v="1314" actId="20577"/>
          <ac:spMkLst>
            <pc:docMk/>
            <pc:sldMk cId="853343324" sldId="4432"/>
            <ac:spMk id="90" creationId="{0A0F3AA3-DAB2-6A5C-FE05-3D71E1AA6761}"/>
          </ac:spMkLst>
        </pc:spChg>
        <pc:spChg chg="add mod">
          <ac:chgData name="Fox, Elizabeth" userId="c7619ef2-11a7-4c4f-9237-3743934715e8" providerId="ADAL" clId="{066B22D4-64C9-4994-ACFA-5FB4CEA10DC4}" dt="2025-03-14T20:06:43.438" v="1196"/>
          <ac:spMkLst>
            <pc:docMk/>
            <pc:sldMk cId="853343324" sldId="4432"/>
            <ac:spMk id="228" creationId="{BDFEBD76-7AC0-9B4C-EBBB-79420B5D7B7E}"/>
          </ac:spMkLst>
        </pc:spChg>
        <pc:spChg chg="add mod">
          <ac:chgData name="Fox, Elizabeth" userId="c7619ef2-11a7-4c4f-9237-3743934715e8" providerId="ADAL" clId="{066B22D4-64C9-4994-ACFA-5FB4CEA10DC4}" dt="2025-03-14T20:07:20.503" v="1202"/>
          <ac:spMkLst>
            <pc:docMk/>
            <pc:sldMk cId="853343324" sldId="4432"/>
            <ac:spMk id="233" creationId="{44447A57-B5F0-2EE6-7E47-7F8B3CA0F8CB}"/>
          </ac:spMkLst>
        </pc:spChg>
        <pc:spChg chg="add mod">
          <ac:chgData name="Fox, Elizabeth" userId="c7619ef2-11a7-4c4f-9237-3743934715e8" providerId="ADAL" clId="{066B22D4-64C9-4994-ACFA-5FB4CEA10DC4}" dt="2025-03-14T20:07:20.503" v="1202"/>
          <ac:spMkLst>
            <pc:docMk/>
            <pc:sldMk cId="853343324" sldId="4432"/>
            <ac:spMk id="238" creationId="{B76D3594-4CA1-9AE4-F468-C2BB541E26EF}"/>
          </ac:spMkLst>
        </pc:spChg>
        <pc:spChg chg="add mod">
          <ac:chgData name="Fox, Elizabeth" userId="c7619ef2-11a7-4c4f-9237-3743934715e8" providerId="ADAL" clId="{066B22D4-64C9-4994-ACFA-5FB4CEA10DC4}" dt="2025-03-14T20:12:41.436" v="1274"/>
          <ac:spMkLst>
            <pc:docMk/>
            <pc:sldMk cId="853343324" sldId="4432"/>
            <ac:spMk id="241" creationId="{0234E7A0-67D7-2321-5623-62A6521F9D50}"/>
          </ac:spMkLst>
        </pc:spChg>
        <pc:spChg chg="add mod">
          <ac:chgData name="Fox, Elizabeth" userId="c7619ef2-11a7-4c4f-9237-3743934715e8" providerId="ADAL" clId="{066B22D4-64C9-4994-ACFA-5FB4CEA10DC4}" dt="2025-03-14T20:12:46.150" v="1275"/>
          <ac:spMkLst>
            <pc:docMk/>
            <pc:sldMk cId="853343324" sldId="4432"/>
            <ac:spMk id="246" creationId="{CE0B283C-F038-42A7-EB48-4336FE62D2E8}"/>
          </ac:spMkLst>
        </pc:spChg>
        <pc:spChg chg="add mod">
          <ac:chgData name="Fox, Elizabeth" userId="c7619ef2-11a7-4c4f-9237-3743934715e8" providerId="ADAL" clId="{066B22D4-64C9-4994-ACFA-5FB4CEA10DC4}" dt="2025-03-14T20:15:12.906" v="1316" actId="1076"/>
          <ac:spMkLst>
            <pc:docMk/>
            <pc:sldMk cId="853343324" sldId="4432"/>
            <ac:spMk id="250" creationId="{B19C3410-31FE-39AE-5433-3732EAC75609}"/>
          </ac:spMkLst>
        </pc:spChg>
        <pc:picChg chg="mod">
          <ac:chgData name="Fox, Elizabeth" userId="c7619ef2-11a7-4c4f-9237-3743934715e8" providerId="ADAL" clId="{066B22D4-64C9-4994-ACFA-5FB4CEA10DC4}" dt="2025-03-14T19:55:08.198" v="1048" actId="1076"/>
          <ac:picMkLst>
            <pc:docMk/>
            <pc:sldMk cId="853343324" sldId="4432"/>
            <ac:picMk id="3" creationId="{EBCCE832-CE61-FEB7-102C-032689F22D30}"/>
          </ac:picMkLst>
        </pc:picChg>
        <pc:picChg chg="mod">
          <ac:chgData name="Fox, Elizabeth" userId="c7619ef2-11a7-4c4f-9237-3743934715e8" providerId="ADAL" clId="{066B22D4-64C9-4994-ACFA-5FB4CEA10DC4}" dt="2025-03-14T19:57:53.419" v="1069" actId="1076"/>
          <ac:picMkLst>
            <pc:docMk/>
            <pc:sldMk cId="853343324" sldId="4432"/>
            <ac:picMk id="11" creationId="{D9559898-E952-6CEB-EDDD-3CFBACE74693}"/>
          </ac:picMkLst>
        </pc:picChg>
        <pc:picChg chg="add mod">
          <ac:chgData name="Fox, Elizabeth" userId="c7619ef2-11a7-4c4f-9237-3743934715e8" providerId="ADAL" clId="{066B22D4-64C9-4994-ACFA-5FB4CEA10DC4}" dt="2025-03-14T20:09:47.973" v="1236" actId="1076"/>
          <ac:picMkLst>
            <pc:docMk/>
            <pc:sldMk cId="853343324" sldId="4432"/>
            <ac:picMk id="21" creationId="{0727C9E8-90B9-C996-C369-142906FFD63C}"/>
          </ac:picMkLst>
        </pc:picChg>
        <pc:picChg chg="add mod">
          <ac:chgData name="Fox, Elizabeth" userId="c7619ef2-11a7-4c4f-9237-3743934715e8" providerId="ADAL" clId="{066B22D4-64C9-4994-ACFA-5FB4CEA10DC4}" dt="2025-03-14T20:06:43.438" v="1196"/>
          <ac:picMkLst>
            <pc:docMk/>
            <pc:sldMk cId="853343324" sldId="4432"/>
            <ac:picMk id="28" creationId="{AECECA44-80A9-16E5-8482-2C6AAA66871D}"/>
          </ac:picMkLst>
        </pc:picChg>
        <pc:picChg chg="add del">
          <ac:chgData name="Fox, Elizabeth" userId="c7619ef2-11a7-4c4f-9237-3743934715e8" providerId="ADAL" clId="{066B22D4-64C9-4994-ACFA-5FB4CEA10DC4}" dt="2025-03-14T20:08:18.172" v="1212" actId="478"/>
          <ac:picMkLst>
            <pc:docMk/>
            <pc:sldMk cId="853343324" sldId="4432"/>
            <ac:picMk id="69" creationId="{D1AEE8A8-2ED9-5092-0745-10DD788C4711}"/>
          </ac:picMkLst>
        </pc:picChg>
        <pc:picChg chg="del mod">
          <ac:chgData name="Fox, Elizabeth" userId="c7619ef2-11a7-4c4f-9237-3743934715e8" providerId="ADAL" clId="{066B22D4-64C9-4994-ACFA-5FB4CEA10DC4}" dt="2025-03-14T20:06:28.717" v="1194" actId="478"/>
          <ac:picMkLst>
            <pc:docMk/>
            <pc:sldMk cId="853343324" sldId="4432"/>
            <ac:picMk id="70" creationId="{83EC4CAD-7BD6-AC35-45CE-6EDC1EAE9D6F}"/>
          </ac:picMkLst>
        </pc:picChg>
        <pc:picChg chg="del">
          <ac:chgData name="Fox, Elizabeth" userId="c7619ef2-11a7-4c4f-9237-3743934715e8" providerId="ADAL" clId="{066B22D4-64C9-4994-ACFA-5FB4CEA10DC4}" dt="2025-03-14T20:06:49.405" v="1197" actId="478"/>
          <ac:picMkLst>
            <pc:docMk/>
            <pc:sldMk cId="853343324" sldId="4432"/>
            <ac:picMk id="76" creationId="{3E8D5572-BF51-43B5-6286-0B0177DD0953}"/>
          </ac:picMkLst>
        </pc:picChg>
        <pc:picChg chg="del">
          <ac:chgData name="Fox, Elizabeth" userId="c7619ef2-11a7-4c4f-9237-3743934715e8" providerId="ADAL" clId="{066B22D4-64C9-4994-ACFA-5FB4CEA10DC4}" dt="2025-03-14T20:10:26.057" v="1261" actId="478"/>
          <ac:picMkLst>
            <pc:docMk/>
            <pc:sldMk cId="853343324" sldId="4432"/>
            <ac:picMk id="81" creationId="{93BB349F-48DA-55DC-1C76-A38753E6B9E0}"/>
          </ac:picMkLst>
        </pc:picChg>
        <pc:picChg chg="del">
          <ac:chgData name="Fox, Elizabeth" userId="c7619ef2-11a7-4c4f-9237-3743934715e8" providerId="ADAL" clId="{066B22D4-64C9-4994-ACFA-5FB4CEA10DC4}" dt="2025-03-14T20:07:50.542" v="1205" actId="478"/>
          <ac:picMkLst>
            <pc:docMk/>
            <pc:sldMk cId="853343324" sldId="4432"/>
            <ac:picMk id="82" creationId="{90E516A7-215C-8AD4-AF1F-D08523A2A0CB}"/>
          </ac:picMkLst>
        </pc:picChg>
        <pc:picChg chg="del">
          <ac:chgData name="Fox, Elizabeth" userId="c7619ef2-11a7-4c4f-9237-3743934715e8" providerId="ADAL" clId="{066B22D4-64C9-4994-ACFA-5FB4CEA10DC4}" dt="2025-03-14T20:13:35.812" v="1302" actId="478"/>
          <ac:picMkLst>
            <pc:docMk/>
            <pc:sldMk cId="853343324" sldId="4432"/>
            <ac:picMk id="88" creationId="{01E4D9F3-1C4C-7C62-3A60-48569135EA9B}"/>
          </ac:picMkLst>
        </pc:picChg>
        <pc:picChg chg="add mod">
          <ac:chgData name="Fox, Elizabeth" userId="c7619ef2-11a7-4c4f-9237-3743934715e8" providerId="ADAL" clId="{066B22D4-64C9-4994-ACFA-5FB4CEA10DC4}" dt="2025-03-14T20:06:43.438" v="1196"/>
          <ac:picMkLst>
            <pc:docMk/>
            <pc:sldMk cId="853343324" sldId="4432"/>
            <ac:picMk id="227" creationId="{EBF67475-21DE-E5FA-051A-0547A0C82C99}"/>
          </ac:picMkLst>
        </pc:picChg>
        <pc:picChg chg="add mod">
          <ac:chgData name="Fox, Elizabeth" userId="c7619ef2-11a7-4c4f-9237-3743934715e8" providerId="ADAL" clId="{066B22D4-64C9-4994-ACFA-5FB4CEA10DC4}" dt="2025-03-14T20:07:20.503" v="1202"/>
          <ac:picMkLst>
            <pc:docMk/>
            <pc:sldMk cId="853343324" sldId="4432"/>
            <ac:picMk id="231" creationId="{1EF9A750-55F2-FC03-883D-FCC6A413B711}"/>
          </ac:picMkLst>
        </pc:picChg>
        <pc:picChg chg="add mod">
          <ac:chgData name="Fox, Elizabeth" userId="c7619ef2-11a7-4c4f-9237-3743934715e8" providerId="ADAL" clId="{066B22D4-64C9-4994-ACFA-5FB4CEA10DC4}" dt="2025-03-14T20:07:20.503" v="1202"/>
          <ac:picMkLst>
            <pc:docMk/>
            <pc:sldMk cId="853343324" sldId="4432"/>
            <ac:picMk id="237" creationId="{53637442-06BE-E984-DA4A-9E783001C88F}"/>
          </ac:picMkLst>
        </pc:picChg>
        <pc:picChg chg="add mod">
          <ac:chgData name="Fox, Elizabeth" userId="c7619ef2-11a7-4c4f-9237-3743934715e8" providerId="ADAL" clId="{066B22D4-64C9-4994-ACFA-5FB4CEA10DC4}" dt="2025-03-14T20:09:15.484" v="1231" actId="1076"/>
          <ac:picMkLst>
            <pc:docMk/>
            <pc:sldMk cId="853343324" sldId="4432"/>
            <ac:picMk id="240" creationId="{E752F36C-3DBB-6AB7-948B-BCFCCF60C197}"/>
          </ac:picMkLst>
        </pc:picChg>
        <pc:picChg chg="add mod">
          <ac:chgData name="Fox, Elizabeth" userId="c7619ef2-11a7-4c4f-9237-3743934715e8" providerId="ADAL" clId="{066B22D4-64C9-4994-ACFA-5FB4CEA10DC4}" dt="2025-03-14T20:07:37.530" v="1204" actId="1076"/>
          <ac:picMkLst>
            <pc:docMk/>
            <pc:sldMk cId="853343324" sldId="4432"/>
            <ac:picMk id="245" creationId="{A0C9C8B3-7B81-B371-7001-67C6C79151F5}"/>
          </ac:picMkLst>
        </pc:picChg>
        <pc:picChg chg="add mod">
          <ac:chgData name="Fox, Elizabeth" userId="c7619ef2-11a7-4c4f-9237-3743934715e8" providerId="ADAL" clId="{066B22D4-64C9-4994-ACFA-5FB4CEA10DC4}" dt="2025-03-14T20:15:12.906" v="1316" actId="1076"/>
          <ac:picMkLst>
            <pc:docMk/>
            <pc:sldMk cId="853343324" sldId="4432"/>
            <ac:picMk id="249" creationId="{045839B6-9C34-F7F8-61D6-81E7910E0EB3}"/>
          </ac:picMkLst>
        </pc:picChg>
        <pc:cxnChg chg="add mod">
          <ac:chgData name="Fox, Elizabeth" userId="c7619ef2-11a7-4c4f-9237-3743934715e8" providerId="ADAL" clId="{066B22D4-64C9-4994-ACFA-5FB4CEA10DC4}" dt="2025-03-14T19:58:03.430" v="1070" actId="1076"/>
          <ac:cxnSpMkLst>
            <pc:docMk/>
            <pc:sldMk cId="853343324" sldId="4432"/>
            <ac:cxnSpMk id="2" creationId="{BC2C93DE-FB9B-9E2F-993B-F57F362F0F5F}"/>
          </ac:cxnSpMkLst>
        </pc:cxnChg>
        <pc:cxnChg chg="add mod">
          <ac:chgData name="Fox, Elizabeth" userId="c7619ef2-11a7-4c4f-9237-3743934715e8" providerId="ADAL" clId="{066B22D4-64C9-4994-ACFA-5FB4CEA10DC4}" dt="2025-03-14T19:57:19.322" v="1066" actId="14100"/>
          <ac:cxnSpMkLst>
            <pc:docMk/>
            <pc:sldMk cId="853343324" sldId="4432"/>
            <ac:cxnSpMk id="4" creationId="{F31E3D9E-24FF-B9D9-9DDA-C98D716CC969}"/>
          </ac:cxnSpMkLst>
        </pc:cxnChg>
        <pc:cxnChg chg="add del mod">
          <ac:chgData name="Fox, Elizabeth" userId="c7619ef2-11a7-4c4f-9237-3743934715e8" providerId="ADAL" clId="{066B22D4-64C9-4994-ACFA-5FB4CEA10DC4}" dt="2025-03-14T19:58:22.412" v="1072" actId="478"/>
          <ac:cxnSpMkLst>
            <pc:docMk/>
            <pc:sldMk cId="853343324" sldId="4432"/>
            <ac:cxnSpMk id="7" creationId="{C193BF86-4FA2-F21E-596F-8959D7B15299}"/>
          </ac:cxnSpMkLst>
        </pc:cxnChg>
        <pc:cxnChg chg="mod">
          <ac:chgData name="Fox, Elizabeth" userId="c7619ef2-11a7-4c4f-9237-3743934715e8" providerId="ADAL" clId="{066B22D4-64C9-4994-ACFA-5FB4CEA10DC4}" dt="2025-03-14T19:58:35.006" v="1073" actId="1076"/>
          <ac:cxnSpMkLst>
            <pc:docMk/>
            <pc:sldMk cId="853343324" sldId="4432"/>
            <ac:cxnSpMk id="13" creationId="{F7891745-69A5-91D9-FAE0-20FEE5759797}"/>
          </ac:cxnSpMkLst>
        </pc:cxnChg>
        <pc:cxnChg chg="add mod">
          <ac:chgData name="Fox, Elizabeth" userId="c7619ef2-11a7-4c4f-9237-3743934715e8" providerId="ADAL" clId="{066B22D4-64C9-4994-ACFA-5FB4CEA10DC4}" dt="2025-03-14T19:57:28.490" v="1068" actId="14100"/>
          <ac:cxnSpMkLst>
            <pc:docMk/>
            <pc:sldMk cId="853343324" sldId="4432"/>
            <ac:cxnSpMk id="19" creationId="{C065F943-B493-924A-1824-3D29FD6D4EAD}"/>
          </ac:cxnSpMkLst>
        </pc:cxnChg>
        <pc:cxnChg chg="add mod">
          <ac:chgData name="Fox, Elizabeth" userId="c7619ef2-11a7-4c4f-9237-3743934715e8" providerId="ADAL" clId="{066B22D4-64C9-4994-ACFA-5FB4CEA10DC4}" dt="2025-03-14T20:06:43.438" v="1196"/>
          <ac:cxnSpMkLst>
            <pc:docMk/>
            <pc:sldMk cId="853343324" sldId="4432"/>
            <ac:cxnSpMk id="30" creationId="{E0DC9176-90E9-5CBA-4B9B-380D70022131}"/>
          </ac:cxnSpMkLst>
        </pc:cxnChg>
        <pc:cxnChg chg="add del">
          <ac:chgData name="Fox, Elizabeth" userId="c7619ef2-11a7-4c4f-9237-3743934715e8" providerId="ADAL" clId="{066B22D4-64C9-4994-ACFA-5FB4CEA10DC4}" dt="2025-03-14T20:08:19.934" v="1213" actId="478"/>
          <ac:cxnSpMkLst>
            <pc:docMk/>
            <pc:sldMk cId="853343324" sldId="4432"/>
            <ac:cxnSpMk id="68" creationId="{695EFDDB-1CE2-E8DE-6BF7-E9642D7165FC}"/>
          </ac:cxnSpMkLst>
        </pc:cxnChg>
        <pc:cxnChg chg="add del">
          <ac:chgData name="Fox, Elizabeth" userId="c7619ef2-11a7-4c4f-9237-3743934715e8" providerId="ADAL" clId="{066B22D4-64C9-4994-ACFA-5FB4CEA10DC4}" dt="2025-03-14T20:08:20.321" v="1214" actId="478"/>
          <ac:cxnSpMkLst>
            <pc:docMk/>
            <pc:sldMk cId="853343324" sldId="4432"/>
            <ac:cxnSpMk id="73" creationId="{1F9635D1-35D3-EE68-9CE1-D3E08EA28E35}"/>
          </ac:cxnSpMkLst>
        </pc:cxnChg>
        <pc:cxnChg chg="del">
          <ac:chgData name="Fox, Elizabeth" userId="c7619ef2-11a7-4c4f-9237-3743934715e8" providerId="ADAL" clId="{066B22D4-64C9-4994-ACFA-5FB4CEA10DC4}" dt="2025-03-14T20:06:52.687" v="1198" actId="478"/>
          <ac:cxnSpMkLst>
            <pc:docMk/>
            <pc:sldMk cId="853343324" sldId="4432"/>
            <ac:cxnSpMk id="74" creationId="{1FFCB423-4FD6-1772-5B7B-5A70FFE172DF}"/>
          </ac:cxnSpMkLst>
        </pc:cxnChg>
        <pc:cxnChg chg="del">
          <ac:chgData name="Fox, Elizabeth" userId="c7619ef2-11a7-4c4f-9237-3743934715e8" providerId="ADAL" clId="{066B22D4-64C9-4994-ACFA-5FB4CEA10DC4}" dt="2025-03-14T20:10:26.057" v="1261" actId="478"/>
          <ac:cxnSpMkLst>
            <pc:docMk/>
            <pc:sldMk cId="853343324" sldId="4432"/>
            <ac:cxnSpMk id="80" creationId="{5207FB32-D034-0592-9819-7C33E2DC4D94}"/>
          </ac:cxnSpMkLst>
        </pc:cxnChg>
        <pc:cxnChg chg="del">
          <ac:chgData name="Fox, Elizabeth" userId="c7619ef2-11a7-4c4f-9237-3743934715e8" providerId="ADAL" clId="{066B22D4-64C9-4994-ACFA-5FB4CEA10DC4}" dt="2025-03-14T20:10:27.664" v="1262" actId="478"/>
          <ac:cxnSpMkLst>
            <pc:docMk/>
            <pc:sldMk cId="853343324" sldId="4432"/>
            <ac:cxnSpMk id="85" creationId="{3D50058A-DFA2-6531-EFDD-2C84C0BB2A31}"/>
          </ac:cxnSpMkLst>
        </pc:cxnChg>
        <pc:cxnChg chg="del">
          <ac:chgData name="Fox, Elizabeth" userId="c7619ef2-11a7-4c4f-9237-3743934715e8" providerId="ADAL" clId="{066B22D4-64C9-4994-ACFA-5FB4CEA10DC4}" dt="2025-03-14T20:13:34.399" v="1301" actId="478"/>
          <ac:cxnSpMkLst>
            <pc:docMk/>
            <pc:sldMk cId="853343324" sldId="4432"/>
            <ac:cxnSpMk id="86" creationId="{61E6ADB0-C1BE-242F-361A-E46322B6B0B5}"/>
          </ac:cxnSpMkLst>
        </pc:cxnChg>
        <pc:cxnChg chg="mod">
          <ac:chgData name="Fox, Elizabeth" userId="c7619ef2-11a7-4c4f-9237-3743934715e8" providerId="ADAL" clId="{066B22D4-64C9-4994-ACFA-5FB4CEA10DC4}" dt="2025-03-14T19:58:40.708" v="1074" actId="14100"/>
          <ac:cxnSpMkLst>
            <pc:docMk/>
            <pc:sldMk cId="853343324" sldId="4432"/>
            <ac:cxnSpMk id="93" creationId="{CFBCFA57-450B-40A3-7C1C-08D15E1E68D0}"/>
          </ac:cxnSpMkLst>
        </pc:cxnChg>
        <pc:cxnChg chg="add mod">
          <ac:chgData name="Fox, Elizabeth" userId="c7619ef2-11a7-4c4f-9237-3743934715e8" providerId="ADAL" clId="{066B22D4-64C9-4994-ACFA-5FB4CEA10DC4}" dt="2025-03-14T20:06:43.438" v="1196"/>
          <ac:cxnSpMkLst>
            <pc:docMk/>
            <pc:sldMk cId="853343324" sldId="4432"/>
            <ac:cxnSpMk id="225" creationId="{DA639ED0-90A1-BDC9-EB80-CEC4843080DD}"/>
          </ac:cxnSpMkLst>
        </pc:cxnChg>
        <pc:cxnChg chg="add mod">
          <ac:chgData name="Fox, Elizabeth" userId="c7619ef2-11a7-4c4f-9237-3743934715e8" providerId="ADAL" clId="{066B22D4-64C9-4994-ACFA-5FB4CEA10DC4}" dt="2025-03-14T20:06:43.438" v="1196"/>
          <ac:cxnSpMkLst>
            <pc:docMk/>
            <pc:sldMk cId="853343324" sldId="4432"/>
            <ac:cxnSpMk id="226" creationId="{072C2F7B-6C67-7EBF-A196-7970A8F59A90}"/>
          </ac:cxnSpMkLst>
        </pc:cxnChg>
        <pc:cxnChg chg="mod">
          <ac:chgData name="Fox, Elizabeth" userId="c7619ef2-11a7-4c4f-9237-3743934715e8" providerId="ADAL" clId="{066B22D4-64C9-4994-ACFA-5FB4CEA10DC4}" dt="2025-03-14T19:56:16.380" v="1053" actId="14100"/>
          <ac:cxnSpMkLst>
            <pc:docMk/>
            <pc:sldMk cId="853343324" sldId="4432"/>
            <ac:cxnSpMk id="229" creationId="{66683748-14D5-BBFE-AEE9-DB0FC861C10D}"/>
          </ac:cxnSpMkLst>
        </pc:cxnChg>
        <pc:cxnChg chg="add mod">
          <ac:chgData name="Fox, Elizabeth" userId="c7619ef2-11a7-4c4f-9237-3743934715e8" providerId="ADAL" clId="{066B22D4-64C9-4994-ACFA-5FB4CEA10DC4}" dt="2025-03-14T20:07:20.503" v="1202"/>
          <ac:cxnSpMkLst>
            <pc:docMk/>
            <pc:sldMk cId="853343324" sldId="4432"/>
            <ac:cxnSpMk id="234" creationId="{E42B19A5-844F-3020-9A8A-EA5E8C215B62}"/>
          </ac:cxnSpMkLst>
        </pc:cxnChg>
        <pc:cxnChg chg="add mod">
          <ac:chgData name="Fox, Elizabeth" userId="c7619ef2-11a7-4c4f-9237-3743934715e8" providerId="ADAL" clId="{066B22D4-64C9-4994-ACFA-5FB4CEA10DC4}" dt="2025-03-14T20:07:20.503" v="1202"/>
          <ac:cxnSpMkLst>
            <pc:docMk/>
            <pc:sldMk cId="853343324" sldId="4432"/>
            <ac:cxnSpMk id="235" creationId="{F4BE4C0D-A72C-42B2-7AEB-D6649B36930C}"/>
          </ac:cxnSpMkLst>
        </pc:cxnChg>
        <pc:cxnChg chg="add mod">
          <ac:chgData name="Fox, Elizabeth" userId="c7619ef2-11a7-4c4f-9237-3743934715e8" providerId="ADAL" clId="{066B22D4-64C9-4994-ACFA-5FB4CEA10DC4}" dt="2025-03-14T20:07:20.503" v="1202"/>
          <ac:cxnSpMkLst>
            <pc:docMk/>
            <pc:sldMk cId="853343324" sldId="4432"/>
            <ac:cxnSpMk id="236" creationId="{FE537159-129B-899E-49C9-AF6608F2628E}"/>
          </ac:cxnSpMkLst>
        </pc:cxnChg>
        <pc:cxnChg chg="add mod">
          <ac:chgData name="Fox, Elizabeth" userId="c7619ef2-11a7-4c4f-9237-3743934715e8" providerId="ADAL" clId="{066B22D4-64C9-4994-ACFA-5FB4CEA10DC4}" dt="2025-03-14T20:09:15.484" v="1231" actId="1076"/>
          <ac:cxnSpMkLst>
            <pc:docMk/>
            <pc:sldMk cId="853343324" sldId="4432"/>
            <ac:cxnSpMk id="239" creationId="{B69DD65D-7BC6-E631-0F4C-67602C4E2EF5}"/>
          </ac:cxnSpMkLst>
        </pc:cxnChg>
        <pc:cxnChg chg="add mod">
          <ac:chgData name="Fox, Elizabeth" userId="c7619ef2-11a7-4c4f-9237-3743934715e8" providerId="ADAL" clId="{066B22D4-64C9-4994-ACFA-5FB4CEA10DC4}" dt="2025-03-14T20:07:37.530" v="1204" actId="1076"/>
          <ac:cxnSpMkLst>
            <pc:docMk/>
            <pc:sldMk cId="853343324" sldId="4432"/>
            <ac:cxnSpMk id="242" creationId="{3831ED98-BAB3-FE5F-BEF8-6E92B5BADE08}"/>
          </ac:cxnSpMkLst>
        </pc:cxnChg>
        <pc:cxnChg chg="add mod">
          <ac:chgData name="Fox, Elizabeth" userId="c7619ef2-11a7-4c4f-9237-3743934715e8" providerId="ADAL" clId="{066B22D4-64C9-4994-ACFA-5FB4CEA10DC4}" dt="2025-03-14T20:09:25.329" v="1234" actId="1037"/>
          <ac:cxnSpMkLst>
            <pc:docMk/>
            <pc:sldMk cId="853343324" sldId="4432"/>
            <ac:cxnSpMk id="243" creationId="{B58379E2-ED71-8E70-EEF2-A02BB0AA7786}"/>
          </ac:cxnSpMkLst>
        </pc:cxnChg>
        <pc:cxnChg chg="add mod">
          <ac:chgData name="Fox, Elizabeth" userId="c7619ef2-11a7-4c4f-9237-3743934715e8" providerId="ADAL" clId="{066B22D4-64C9-4994-ACFA-5FB4CEA10DC4}" dt="2025-03-14T20:09:28.842" v="1235" actId="1037"/>
          <ac:cxnSpMkLst>
            <pc:docMk/>
            <pc:sldMk cId="853343324" sldId="4432"/>
            <ac:cxnSpMk id="244" creationId="{B860B393-C54F-B8ED-B11C-769C8839C728}"/>
          </ac:cxnSpMkLst>
        </pc:cxnChg>
        <pc:cxnChg chg="add del mod">
          <ac:chgData name="Fox, Elizabeth" userId="c7619ef2-11a7-4c4f-9237-3743934715e8" providerId="ADAL" clId="{066B22D4-64C9-4994-ACFA-5FB4CEA10DC4}" dt="2025-03-14T20:15:21.597" v="1318" actId="478"/>
          <ac:cxnSpMkLst>
            <pc:docMk/>
            <pc:sldMk cId="853343324" sldId="4432"/>
            <ac:cxnSpMk id="251" creationId="{1EED5C90-EE6B-7FAC-3E94-B84BA4582C31}"/>
          </ac:cxnSpMkLst>
        </pc:cxnChg>
        <pc:cxnChg chg="add mod">
          <ac:chgData name="Fox, Elizabeth" userId="c7619ef2-11a7-4c4f-9237-3743934715e8" providerId="ADAL" clId="{066B22D4-64C9-4994-ACFA-5FB4CEA10DC4}" dt="2025-03-14T20:15:15.506" v="1317" actId="14100"/>
          <ac:cxnSpMkLst>
            <pc:docMk/>
            <pc:sldMk cId="853343324" sldId="4432"/>
            <ac:cxnSpMk id="252" creationId="{9657527C-1979-D3D7-632B-B950CEF63108}"/>
          </ac:cxnSpMkLst>
        </pc:cxnChg>
      </pc:sldChg>
      <pc:sldMasterChg chg="del delSldLayout">
        <pc:chgData name="Fox, Elizabeth" userId="c7619ef2-11a7-4c4f-9237-3743934715e8" providerId="ADAL" clId="{066B22D4-64C9-4994-ACFA-5FB4CEA10DC4}" dt="2025-03-14T19:36:56.699" v="814" actId="47"/>
        <pc:sldMasterMkLst>
          <pc:docMk/>
          <pc:sldMasterMk cId="1259688045" sldId="2147483829"/>
        </pc:sldMasterMkLst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386215684" sldId="2147483830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1944672288" sldId="2147483831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2692861124" sldId="2147483832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1186506975" sldId="2147483833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291796535" sldId="2147483834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3283935312" sldId="2147483835"/>
          </pc:sldLayoutMkLst>
        </pc:sldLayoutChg>
        <pc:sldLayoutChg chg="del">
          <pc:chgData name="Fox, Elizabeth" userId="c7619ef2-11a7-4c4f-9237-3743934715e8" providerId="ADAL" clId="{066B22D4-64C9-4994-ACFA-5FB4CEA10DC4}" dt="2025-03-14T16:18:22.215" v="1" actId="47"/>
          <pc:sldLayoutMkLst>
            <pc:docMk/>
            <pc:sldMasterMk cId="1259688045" sldId="2147483829"/>
            <pc:sldLayoutMk cId="3163567179" sldId="2147483836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3590496551" sldId="2147483837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4294306012" sldId="2147483838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1132925006" sldId="2147483839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48084357" sldId="2147483840"/>
          </pc:sldLayoutMkLst>
        </pc:sldLayoutChg>
        <pc:sldLayoutChg chg="del">
          <pc:chgData name="Fox, Elizabeth" userId="c7619ef2-11a7-4c4f-9237-3743934715e8" providerId="ADAL" clId="{066B22D4-64C9-4994-ACFA-5FB4CEA10DC4}" dt="2025-03-14T16:18:22.215" v="1" actId="47"/>
          <pc:sldLayoutMkLst>
            <pc:docMk/>
            <pc:sldMasterMk cId="1259688045" sldId="2147483829"/>
            <pc:sldLayoutMk cId="3198493669" sldId="2147483841"/>
          </pc:sldLayoutMkLst>
        </pc:sldLayoutChg>
        <pc:sldLayoutChg chg="del">
          <pc:chgData name="Fox, Elizabeth" userId="c7619ef2-11a7-4c4f-9237-3743934715e8" providerId="ADAL" clId="{066B22D4-64C9-4994-ACFA-5FB4CEA10DC4}" dt="2025-03-14T19:36:56.699" v="814" actId="47"/>
          <pc:sldLayoutMkLst>
            <pc:docMk/>
            <pc:sldMasterMk cId="1259688045" sldId="2147483829"/>
            <pc:sldLayoutMk cId="3458629943" sldId="2147483842"/>
          </pc:sldLayoutMkLst>
        </pc:sldLayoutChg>
      </pc:sldMaster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53EEADE-084D-EF46-9E06-49157D51E4F3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70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70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425D719-9150-F743-805E-17E4DF1A37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850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8E03A04-0626-44D4-B6D6-43B9D98023FD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3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70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70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08A34052-12FB-4B01-8A2E-D87AD7371E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2105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70DC82-D323-1BFF-FCCA-C7DFA9DB39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029817" y="1494925"/>
            <a:ext cx="12178904" cy="3180151"/>
          </a:xfrm>
        </p:spPr>
        <p:txBody>
          <a:bodyPr anchor="b"/>
          <a:lstStyle>
            <a:lvl1pPr algn="ctr">
              <a:defRPr sz="799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B07225-203C-3902-2366-E7AE71FF80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029817" y="4797715"/>
            <a:ext cx="12178904" cy="2205383"/>
          </a:xfrm>
        </p:spPr>
        <p:txBody>
          <a:bodyPr/>
          <a:lstStyle>
            <a:lvl1pPr marL="0" indent="0" algn="ctr">
              <a:buNone/>
              <a:defRPr sz="3197"/>
            </a:lvl1pPr>
            <a:lvl2pPr marL="608945" indent="0" algn="ctr">
              <a:buNone/>
              <a:defRPr sz="2664"/>
            </a:lvl2pPr>
            <a:lvl3pPr marL="1217889" indent="0" algn="ctr">
              <a:buNone/>
              <a:defRPr sz="2397"/>
            </a:lvl3pPr>
            <a:lvl4pPr marL="1826834" indent="0" algn="ctr">
              <a:buNone/>
              <a:defRPr sz="2131"/>
            </a:lvl4pPr>
            <a:lvl5pPr marL="2435779" indent="0" algn="ctr">
              <a:buNone/>
              <a:defRPr sz="2131"/>
            </a:lvl5pPr>
            <a:lvl6pPr marL="3044723" indent="0" algn="ctr">
              <a:buNone/>
              <a:defRPr sz="2131"/>
            </a:lvl6pPr>
            <a:lvl7pPr marL="3653668" indent="0" algn="ctr">
              <a:buNone/>
              <a:defRPr sz="2131"/>
            </a:lvl7pPr>
            <a:lvl8pPr marL="4262613" indent="0" algn="ctr">
              <a:buNone/>
              <a:defRPr sz="2131"/>
            </a:lvl8pPr>
            <a:lvl9pPr marL="4871557" indent="0" algn="ctr">
              <a:buNone/>
              <a:defRPr sz="213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1798B-760B-5893-C045-3CF698C32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44AAE-1631-DA67-9817-12E3CD2FA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88C10-FEB3-2F49-C37D-7FCF842FB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017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1AE0B-43B4-4C5E-1A93-C879CB4316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756BFF-E2EE-74D5-EB24-B38626977B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7361E0-48FC-D255-02E3-E44421B65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4EE92-32E1-4E72-0202-6733FA103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D386FF-D8D4-C7FE-A954-334905012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22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01F148-7B43-7587-234F-462B801843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620704" y="486326"/>
            <a:ext cx="3501435" cy="774104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F8AE91-0351-93F8-CF3C-E964E2985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116399" y="486326"/>
            <a:ext cx="10301323" cy="774104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C0B2C4-88D6-59DF-7AFF-EDB1D13111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E8DFA6-104F-221A-F644-7D2730424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07AE4-EE74-DA73-3CCF-D4BF4A485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95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0691AB-A912-FCEC-DF39-7A0B7E2C5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B660E7-59D4-D130-33A4-837317DC7C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631468-3290-BBC9-4086-7B301F1AA1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150DD2-20CB-EA75-887E-34AC922E3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EA944-6179-6AB7-0779-03065C1C3B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183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BB888-2E56-1F5B-0F43-21AA4ECFC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7942" y="2277277"/>
            <a:ext cx="14005739" cy="3799687"/>
          </a:xfrm>
        </p:spPr>
        <p:txBody>
          <a:bodyPr anchor="b"/>
          <a:lstStyle>
            <a:lvl1pPr>
              <a:defRPr sz="799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7F75CC-C935-8A05-2BA0-60FBCCDDB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07942" y="6112910"/>
            <a:ext cx="14005739" cy="1998166"/>
          </a:xfrm>
        </p:spPr>
        <p:txBody>
          <a:bodyPr/>
          <a:lstStyle>
            <a:lvl1pPr marL="0" indent="0">
              <a:buNone/>
              <a:defRPr sz="3197">
                <a:solidFill>
                  <a:schemeClr val="tx1">
                    <a:tint val="75000"/>
                  </a:schemeClr>
                </a:solidFill>
              </a:defRPr>
            </a:lvl1pPr>
            <a:lvl2pPr marL="608945" indent="0">
              <a:buNone/>
              <a:defRPr sz="2664">
                <a:solidFill>
                  <a:schemeClr val="tx1">
                    <a:tint val="75000"/>
                  </a:schemeClr>
                </a:solidFill>
              </a:defRPr>
            </a:lvl2pPr>
            <a:lvl3pPr marL="1217889" indent="0">
              <a:buNone/>
              <a:defRPr sz="2397">
                <a:solidFill>
                  <a:schemeClr val="tx1">
                    <a:tint val="75000"/>
                  </a:schemeClr>
                </a:solidFill>
              </a:defRPr>
            </a:lvl3pPr>
            <a:lvl4pPr marL="1826834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4pPr>
            <a:lvl5pPr marL="2435779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5pPr>
            <a:lvl6pPr marL="3044723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6pPr>
            <a:lvl7pPr marL="3653668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7pPr>
            <a:lvl8pPr marL="4262613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8pPr>
            <a:lvl9pPr marL="4871557" indent="0">
              <a:buNone/>
              <a:defRPr sz="21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B199BA-1CB7-4029-40F5-824F54251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BAD4A-D374-F426-77F9-C14E040CF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582C49-802A-50EC-AC48-83BA3641A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596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B7DFF-2823-91D9-7DDF-155F2F867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9C1D18-BF8A-6B51-617E-81EF965890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116399" y="2431631"/>
            <a:ext cx="6901379" cy="57957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851C19-C4B1-652B-A38C-F4EF8BC28E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220760" y="2431631"/>
            <a:ext cx="6901379" cy="57957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B7A278-5911-0386-DBC0-25EC12EBC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325176-C417-D856-5273-FAA6569E3B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B23D76-6AD2-0646-7B67-6AFE5A594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171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575729-CDFE-44CE-98AA-00C0A8908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8515" y="486327"/>
            <a:ext cx="14005739" cy="176557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CCD179-0A3E-3329-A597-85EFB37965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18515" y="2239216"/>
            <a:ext cx="6869662" cy="1097405"/>
          </a:xfrm>
        </p:spPr>
        <p:txBody>
          <a:bodyPr anchor="b"/>
          <a:lstStyle>
            <a:lvl1pPr marL="0" indent="0">
              <a:buNone/>
              <a:defRPr sz="3197" b="1"/>
            </a:lvl1pPr>
            <a:lvl2pPr marL="608945" indent="0">
              <a:buNone/>
              <a:defRPr sz="2664" b="1"/>
            </a:lvl2pPr>
            <a:lvl3pPr marL="1217889" indent="0">
              <a:buNone/>
              <a:defRPr sz="2397" b="1"/>
            </a:lvl3pPr>
            <a:lvl4pPr marL="1826834" indent="0">
              <a:buNone/>
              <a:defRPr sz="2131" b="1"/>
            </a:lvl4pPr>
            <a:lvl5pPr marL="2435779" indent="0">
              <a:buNone/>
              <a:defRPr sz="2131" b="1"/>
            </a:lvl5pPr>
            <a:lvl6pPr marL="3044723" indent="0">
              <a:buNone/>
              <a:defRPr sz="2131" b="1"/>
            </a:lvl6pPr>
            <a:lvl7pPr marL="3653668" indent="0">
              <a:buNone/>
              <a:defRPr sz="2131" b="1"/>
            </a:lvl7pPr>
            <a:lvl8pPr marL="4262613" indent="0">
              <a:buNone/>
              <a:defRPr sz="2131" b="1"/>
            </a:lvl8pPr>
            <a:lvl9pPr marL="4871557" indent="0">
              <a:buNone/>
              <a:defRPr sz="213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A1D8AE-E4A3-2631-0181-24B568DAE0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118515" y="3336620"/>
            <a:ext cx="6869662" cy="490766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423F16-0652-1585-749F-173F29EFC5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8220760" y="2239216"/>
            <a:ext cx="6903494" cy="1097405"/>
          </a:xfrm>
        </p:spPr>
        <p:txBody>
          <a:bodyPr anchor="b"/>
          <a:lstStyle>
            <a:lvl1pPr marL="0" indent="0">
              <a:buNone/>
              <a:defRPr sz="3197" b="1"/>
            </a:lvl1pPr>
            <a:lvl2pPr marL="608945" indent="0">
              <a:buNone/>
              <a:defRPr sz="2664" b="1"/>
            </a:lvl2pPr>
            <a:lvl3pPr marL="1217889" indent="0">
              <a:buNone/>
              <a:defRPr sz="2397" b="1"/>
            </a:lvl3pPr>
            <a:lvl4pPr marL="1826834" indent="0">
              <a:buNone/>
              <a:defRPr sz="2131" b="1"/>
            </a:lvl4pPr>
            <a:lvl5pPr marL="2435779" indent="0">
              <a:buNone/>
              <a:defRPr sz="2131" b="1"/>
            </a:lvl5pPr>
            <a:lvl6pPr marL="3044723" indent="0">
              <a:buNone/>
              <a:defRPr sz="2131" b="1"/>
            </a:lvl6pPr>
            <a:lvl7pPr marL="3653668" indent="0">
              <a:buNone/>
              <a:defRPr sz="2131" b="1"/>
            </a:lvl7pPr>
            <a:lvl8pPr marL="4262613" indent="0">
              <a:buNone/>
              <a:defRPr sz="2131" b="1"/>
            </a:lvl8pPr>
            <a:lvl9pPr marL="4871557" indent="0">
              <a:buNone/>
              <a:defRPr sz="213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ED5CB5-345D-3923-4CD8-F6601CAA37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8220760" y="3336620"/>
            <a:ext cx="6903494" cy="490766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0B2D1C-AE73-9183-9075-278259F3E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B87C096-B4B2-EF5B-4C4F-697A83DCE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A181B5A-1676-71DA-9439-33C680B16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141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C9FE7-0C01-0DB4-3ABA-E99E8257AA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7DC105-569D-5522-C96B-D9E76D7526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547E53-7D97-2AD9-EDA5-32D3D216A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494F00-A5BE-5FFE-08A9-E0F310699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570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A4AFAD-CDE6-D8FA-0757-A633AF179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8EA5F2-850A-E4F3-60A4-D7E34A360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87C069-9AEC-4FEB-1914-67CBFD998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289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189AF-D1A8-B487-3FD6-15812DE1F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8515" y="608965"/>
            <a:ext cx="5237351" cy="2131378"/>
          </a:xfrm>
        </p:spPr>
        <p:txBody>
          <a:bodyPr anchor="b"/>
          <a:lstStyle>
            <a:lvl1pPr>
              <a:defRPr sz="426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82FB70-6A35-F475-60DD-B65287CAD8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903494" y="1315196"/>
            <a:ext cx="8220760" cy="6491398"/>
          </a:xfrm>
        </p:spPr>
        <p:txBody>
          <a:bodyPr/>
          <a:lstStyle>
            <a:lvl1pPr>
              <a:defRPr sz="4262"/>
            </a:lvl1pPr>
            <a:lvl2pPr>
              <a:defRPr sz="3729"/>
            </a:lvl2pPr>
            <a:lvl3pPr>
              <a:defRPr sz="3197"/>
            </a:lvl3pPr>
            <a:lvl4pPr>
              <a:defRPr sz="2664"/>
            </a:lvl4pPr>
            <a:lvl5pPr>
              <a:defRPr sz="2664"/>
            </a:lvl5pPr>
            <a:lvl6pPr>
              <a:defRPr sz="2664"/>
            </a:lvl6pPr>
            <a:lvl7pPr>
              <a:defRPr sz="2664"/>
            </a:lvl7pPr>
            <a:lvl8pPr>
              <a:defRPr sz="2664"/>
            </a:lvl8pPr>
            <a:lvl9pPr>
              <a:defRPr sz="266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676DB6-D3AC-AE29-4ADE-196C39532E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18515" y="2740343"/>
            <a:ext cx="5237351" cy="5076823"/>
          </a:xfrm>
        </p:spPr>
        <p:txBody>
          <a:bodyPr/>
          <a:lstStyle>
            <a:lvl1pPr marL="0" indent="0">
              <a:buNone/>
              <a:defRPr sz="2131"/>
            </a:lvl1pPr>
            <a:lvl2pPr marL="608945" indent="0">
              <a:buNone/>
              <a:defRPr sz="1865"/>
            </a:lvl2pPr>
            <a:lvl3pPr marL="1217889" indent="0">
              <a:buNone/>
              <a:defRPr sz="1598"/>
            </a:lvl3pPr>
            <a:lvl4pPr marL="1826834" indent="0">
              <a:buNone/>
              <a:defRPr sz="1332"/>
            </a:lvl4pPr>
            <a:lvl5pPr marL="2435779" indent="0">
              <a:buNone/>
              <a:defRPr sz="1332"/>
            </a:lvl5pPr>
            <a:lvl6pPr marL="3044723" indent="0">
              <a:buNone/>
              <a:defRPr sz="1332"/>
            </a:lvl6pPr>
            <a:lvl7pPr marL="3653668" indent="0">
              <a:buNone/>
              <a:defRPr sz="1332"/>
            </a:lvl7pPr>
            <a:lvl8pPr marL="4262613" indent="0">
              <a:buNone/>
              <a:defRPr sz="1332"/>
            </a:lvl8pPr>
            <a:lvl9pPr marL="4871557" indent="0">
              <a:buNone/>
              <a:defRPr sz="133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B2D277-46ED-27DB-9405-D8F0563D9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125C05-047A-C21C-B513-DB9281D0A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6BEDA1-E583-2758-E254-21AC024C3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868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F0674-4670-5556-39DD-32AB9131F2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8515" y="608965"/>
            <a:ext cx="5237351" cy="2131378"/>
          </a:xfrm>
        </p:spPr>
        <p:txBody>
          <a:bodyPr anchor="b"/>
          <a:lstStyle>
            <a:lvl1pPr>
              <a:defRPr sz="4262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1624FD-A146-EE24-B6AA-AE761E0DA6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903494" y="1315196"/>
            <a:ext cx="8220760" cy="6491398"/>
          </a:xfrm>
        </p:spPr>
        <p:txBody>
          <a:bodyPr/>
          <a:lstStyle>
            <a:lvl1pPr marL="0" indent="0">
              <a:buNone/>
              <a:defRPr sz="4262"/>
            </a:lvl1pPr>
            <a:lvl2pPr marL="608945" indent="0">
              <a:buNone/>
              <a:defRPr sz="3729"/>
            </a:lvl2pPr>
            <a:lvl3pPr marL="1217889" indent="0">
              <a:buNone/>
              <a:defRPr sz="3197"/>
            </a:lvl3pPr>
            <a:lvl4pPr marL="1826834" indent="0">
              <a:buNone/>
              <a:defRPr sz="2664"/>
            </a:lvl4pPr>
            <a:lvl5pPr marL="2435779" indent="0">
              <a:buNone/>
              <a:defRPr sz="2664"/>
            </a:lvl5pPr>
            <a:lvl6pPr marL="3044723" indent="0">
              <a:buNone/>
              <a:defRPr sz="2664"/>
            </a:lvl6pPr>
            <a:lvl7pPr marL="3653668" indent="0">
              <a:buNone/>
              <a:defRPr sz="2664"/>
            </a:lvl7pPr>
            <a:lvl8pPr marL="4262613" indent="0">
              <a:buNone/>
              <a:defRPr sz="2664"/>
            </a:lvl8pPr>
            <a:lvl9pPr marL="4871557" indent="0">
              <a:buNone/>
              <a:defRPr sz="2664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B26EA5-36D5-91C9-8258-42940E655F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18515" y="2740343"/>
            <a:ext cx="5237351" cy="5076823"/>
          </a:xfrm>
        </p:spPr>
        <p:txBody>
          <a:bodyPr/>
          <a:lstStyle>
            <a:lvl1pPr marL="0" indent="0">
              <a:buNone/>
              <a:defRPr sz="2131"/>
            </a:lvl1pPr>
            <a:lvl2pPr marL="608945" indent="0">
              <a:buNone/>
              <a:defRPr sz="1865"/>
            </a:lvl2pPr>
            <a:lvl3pPr marL="1217889" indent="0">
              <a:buNone/>
              <a:defRPr sz="1598"/>
            </a:lvl3pPr>
            <a:lvl4pPr marL="1826834" indent="0">
              <a:buNone/>
              <a:defRPr sz="1332"/>
            </a:lvl4pPr>
            <a:lvl5pPr marL="2435779" indent="0">
              <a:buNone/>
              <a:defRPr sz="1332"/>
            </a:lvl5pPr>
            <a:lvl6pPr marL="3044723" indent="0">
              <a:buNone/>
              <a:defRPr sz="1332"/>
            </a:lvl6pPr>
            <a:lvl7pPr marL="3653668" indent="0">
              <a:buNone/>
              <a:defRPr sz="1332"/>
            </a:lvl7pPr>
            <a:lvl8pPr marL="4262613" indent="0">
              <a:buNone/>
              <a:defRPr sz="1332"/>
            </a:lvl8pPr>
            <a:lvl9pPr marL="4871557" indent="0">
              <a:buNone/>
              <a:defRPr sz="133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2FB0C9-187A-7F52-F0E5-61C7DAF59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1A0210-0511-7CA3-AA3E-3032FDDEF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4B2854-1814-F441-C711-4391A6E77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708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9B9B9BE-9BD3-6D7E-B84B-F1E9172C25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16400" y="486327"/>
            <a:ext cx="14005739" cy="17655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F51B23-FC44-FB63-359D-940DD7BFF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16400" y="2431631"/>
            <a:ext cx="14005739" cy="57957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53687C-18FE-E245-E807-3CC7C9961F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116400" y="8466306"/>
            <a:ext cx="3653671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561CCF-4303-43C7-A92D-9EA6BE73865B}" type="datetimeFigureOut">
              <a:rPr lang="en-US" smtClean="0"/>
              <a:t>3/1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A859F7-31CA-A72A-BC21-4A6175841B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379016" y="8466306"/>
            <a:ext cx="5480507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ED5F7A-E757-0774-0E51-A3F8397EFC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468467" y="8466306"/>
            <a:ext cx="3653671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05579-1345-4293-83DF-03A99A73F7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758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4" r:id="rId1"/>
    <p:sldLayoutId id="2147483845" r:id="rId2"/>
    <p:sldLayoutId id="2147483846" r:id="rId3"/>
    <p:sldLayoutId id="2147483847" r:id="rId4"/>
    <p:sldLayoutId id="2147483848" r:id="rId5"/>
    <p:sldLayoutId id="2147483849" r:id="rId6"/>
    <p:sldLayoutId id="2147483850" r:id="rId7"/>
    <p:sldLayoutId id="2147483851" r:id="rId8"/>
    <p:sldLayoutId id="2147483852" r:id="rId9"/>
    <p:sldLayoutId id="2147483853" r:id="rId10"/>
    <p:sldLayoutId id="2147483854" r:id="rId11"/>
  </p:sldLayoutIdLst>
  <p:txStyles>
    <p:titleStyle>
      <a:lvl1pPr algn="l" defTabSz="1217889" rtl="0" eaLnBrk="1" latinLnBrk="0" hangingPunct="1">
        <a:lnSpc>
          <a:spcPct val="90000"/>
        </a:lnSpc>
        <a:spcBef>
          <a:spcPct val="0"/>
        </a:spcBef>
        <a:buNone/>
        <a:defRPr sz="5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472" indent="-304472" algn="l" defTabSz="1217889" rtl="0" eaLnBrk="1" latinLnBrk="0" hangingPunct="1">
        <a:lnSpc>
          <a:spcPct val="90000"/>
        </a:lnSpc>
        <a:spcBef>
          <a:spcPts val="1332"/>
        </a:spcBef>
        <a:buFont typeface="Arial" panose="020B0604020202020204" pitchFamily="34" charset="0"/>
        <a:buChar char="•"/>
        <a:defRPr sz="3729" kern="1200">
          <a:solidFill>
            <a:schemeClr val="tx1"/>
          </a:solidFill>
          <a:latin typeface="+mn-lt"/>
          <a:ea typeface="+mn-ea"/>
          <a:cs typeface="+mn-cs"/>
        </a:defRPr>
      </a:lvl1pPr>
      <a:lvl2pPr marL="913417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3197" kern="1200">
          <a:solidFill>
            <a:schemeClr val="tx1"/>
          </a:solidFill>
          <a:latin typeface="+mn-lt"/>
          <a:ea typeface="+mn-ea"/>
          <a:cs typeface="+mn-cs"/>
        </a:defRPr>
      </a:lvl2pPr>
      <a:lvl3pPr marL="1522362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664" kern="1200">
          <a:solidFill>
            <a:schemeClr val="tx1"/>
          </a:solidFill>
          <a:latin typeface="+mn-lt"/>
          <a:ea typeface="+mn-ea"/>
          <a:cs typeface="+mn-cs"/>
        </a:defRPr>
      </a:lvl3pPr>
      <a:lvl4pPr marL="2131306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4pPr>
      <a:lvl5pPr marL="2740251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5pPr>
      <a:lvl6pPr marL="3349196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6pPr>
      <a:lvl7pPr marL="3958140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7pPr>
      <a:lvl8pPr marL="4567085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8pPr>
      <a:lvl9pPr marL="5176030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1pPr>
      <a:lvl2pPr marL="608945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2pPr>
      <a:lvl3pPr marL="1217889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3pPr>
      <a:lvl4pPr marL="1826834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4pPr>
      <a:lvl5pPr marL="2435779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5pPr>
      <a:lvl6pPr marL="3044723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6pPr>
      <a:lvl7pPr marL="3653668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7pPr>
      <a:lvl8pPr marL="4262613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8pPr>
      <a:lvl9pPr marL="4871557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Relationship Id="rId6" Type="http://schemas.openxmlformats.org/officeDocument/2006/relationships/image" Target="../media/image2.svg"/><Relationship Id="rId5" Type="http://schemas.openxmlformats.org/officeDocument/2006/relationships/image" Target="../media/image1.png"/><Relationship Id="rId4" Type="http://schemas.openxmlformats.org/officeDocument/2006/relationships/image" Target="../media/image4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Relationship Id="rId6" Type="http://schemas.openxmlformats.org/officeDocument/2006/relationships/image" Target="../media/image2.svg"/><Relationship Id="rId5" Type="http://schemas.openxmlformats.org/officeDocument/2006/relationships/image" Target="../media/image1.png"/><Relationship Id="rId4" Type="http://schemas.openxmlformats.org/officeDocument/2006/relationships/image" Target="../media/image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2A015414-589A-CF9B-1E04-F708E576CEC6}"/>
              </a:ext>
            </a:extLst>
          </p:cNvPr>
          <p:cNvCxnSpPr>
            <a:cxnSpLocks/>
          </p:cNvCxnSpPr>
          <p:nvPr/>
        </p:nvCxnSpPr>
        <p:spPr>
          <a:xfrm>
            <a:off x="14229329" y="3294913"/>
            <a:ext cx="0" cy="311876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893A8FFD-7E3E-93BA-5C84-EE4E396C3574}"/>
              </a:ext>
            </a:extLst>
          </p:cNvPr>
          <p:cNvCxnSpPr>
            <a:cxnSpLocks/>
          </p:cNvCxnSpPr>
          <p:nvPr/>
        </p:nvCxnSpPr>
        <p:spPr>
          <a:xfrm>
            <a:off x="11174985" y="3292489"/>
            <a:ext cx="0" cy="323336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F1CC52F4-D306-948C-10EB-F71EE4AC3BE2}"/>
              </a:ext>
            </a:extLst>
          </p:cNvPr>
          <p:cNvCxnSpPr>
            <a:cxnSpLocks/>
          </p:cNvCxnSpPr>
          <p:nvPr/>
        </p:nvCxnSpPr>
        <p:spPr>
          <a:xfrm>
            <a:off x="2011956" y="3279143"/>
            <a:ext cx="0" cy="312784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6" name="Group 25">
            <a:extLst>
              <a:ext uri="{FF2B5EF4-FFF2-40B4-BE49-F238E27FC236}">
                <a16:creationId xmlns:a16="http://schemas.microsoft.com/office/drawing/2014/main" id="{727C0FC1-44CB-FDAB-7E4B-44BB2BB18B1F}"/>
              </a:ext>
            </a:extLst>
          </p:cNvPr>
          <p:cNvGrpSpPr/>
          <p:nvPr/>
        </p:nvGrpSpPr>
        <p:grpSpPr>
          <a:xfrm>
            <a:off x="8120642" y="2517939"/>
            <a:ext cx="0" cy="4007915"/>
            <a:chOff x="8174871" y="2517939"/>
            <a:chExt cx="0" cy="4007915"/>
          </a:xfrm>
        </p:grpSpPr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D5C5F78D-1053-3BF6-8B1C-A29DAE3E8F78}"/>
                </a:ext>
              </a:extLst>
            </p:cNvPr>
            <p:cNvCxnSpPr>
              <a:cxnSpLocks/>
            </p:cNvCxnSpPr>
            <p:nvPr/>
          </p:nvCxnSpPr>
          <p:spPr>
            <a:xfrm>
              <a:off x="8174871" y="2517939"/>
              <a:ext cx="0" cy="9936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1" name="Straight Connector 230">
              <a:extLst>
                <a:ext uri="{FF2B5EF4-FFF2-40B4-BE49-F238E27FC236}">
                  <a16:creationId xmlns:a16="http://schemas.microsoft.com/office/drawing/2014/main" id="{1DB2FD5F-B8F5-6651-368A-390D7F96CEA7}"/>
                </a:ext>
              </a:extLst>
            </p:cNvPr>
            <p:cNvCxnSpPr>
              <a:cxnSpLocks/>
            </p:cNvCxnSpPr>
            <p:nvPr/>
          </p:nvCxnSpPr>
          <p:spPr>
            <a:xfrm>
              <a:off x="8174871" y="3302003"/>
              <a:ext cx="0" cy="3223851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95554766-1846-05A4-C9AA-7CC6DA28DE0F}"/>
              </a:ext>
            </a:extLst>
          </p:cNvPr>
          <p:cNvSpPr/>
          <p:nvPr/>
        </p:nvSpPr>
        <p:spPr>
          <a:xfrm>
            <a:off x="580584" y="6406990"/>
            <a:ext cx="2862743" cy="2029323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45720" rtlCol="0" anchor="t" anchorCtr="0"/>
          <a:lstStyle/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1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2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3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4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5]</a:t>
            </a:r>
          </a:p>
        </p:txBody>
      </p:sp>
      <p:sp>
        <p:nvSpPr>
          <p:cNvPr id="17" name="Title 3">
            <a:extLst>
              <a:ext uri="{FF2B5EF4-FFF2-40B4-BE49-F238E27FC236}">
                <a16:creationId xmlns:a16="http://schemas.microsoft.com/office/drawing/2014/main" id="{7AF8CDC5-4C8B-EBEB-37CD-3256B7B5B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514" y="734247"/>
            <a:ext cx="6276713" cy="639372"/>
          </a:xfrm>
        </p:spPr>
        <p:txBody>
          <a:bodyPr>
            <a:noAutofit/>
          </a:bodyPr>
          <a:lstStyle/>
          <a:p>
            <a:pPr algn="ctr"/>
            <a:r>
              <a:rPr lang="en-US" sz="2664" b="1" dirty="0">
                <a:latin typeface="+mn-lt"/>
                <a:cs typeface="Arial" panose="020B0604020202020204" pitchFamily="34" charset="0"/>
              </a:rPr>
              <a:t>[Company Name], [Laboratory Name] Organizational Structure</a:t>
            </a:r>
            <a:endParaRPr lang="en-US" sz="1865" b="1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A2366861-2BAB-13B1-2693-49238BC4CF13}"/>
              </a:ext>
            </a:extLst>
          </p:cNvPr>
          <p:cNvSpPr/>
          <p:nvPr/>
        </p:nvSpPr>
        <p:spPr>
          <a:xfrm>
            <a:off x="6611321" y="897778"/>
            <a:ext cx="3136578" cy="1616317"/>
          </a:xfrm>
          <a:prstGeom prst="round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 defTabSz="1217889"/>
            <a:r>
              <a:rPr lang="en-US" b="1" dirty="0">
                <a:solidFill>
                  <a:prstClr val="white"/>
                </a:solidFill>
                <a:latin typeface="Arial Narrow" panose="020B0606020202030204" pitchFamily="34" charset="0"/>
              </a:rPr>
              <a:t>[Company/Branch/Division Name]</a:t>
            </a: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197CCC73-C410-8799-7B9D-21EE0701032E}"/>
              </a:ext>
            </a:extLst>
          </p:cNvPr>
          <p:cNvCxnSpPr>
            <a:cxnSpLocks/>
          </p:cNvCxnSpPr>
          <p:nvPr/>
        </p:nvCxnSpPr>
        <p:spPr>
          <a:xfrm>
            <a:off x="5066299" y="3282387"/>
            <a:ext cx="0" cy="31355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FBCFA57-450B-40A3-7C1C-08D15E1E68D0}"/>
              </a:ext>
            </a:extLst>
          </p:cNvPr>
          <p:cNvCxnSpPr>
            <a:cxnSpLocks/>
          </p:cNvCxnSpPr>
          <p:nvPr/>
        </p:nvCxnSpPr>
        <p:spPr>
          <a:xfrm>
            <a:off x="2011956" y="3282196"/>
            <a:ext cx="12217373" cy="1980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48F0E557-EF5E-0B44-3985-0B7EE13321DE}"/>
              </a:ext>
            </a:extLst>
          </p:cNvPr>
          <p:cNvSpPr/>
          <p:nvPr/>
        </p:nvSpPr>
        <p:spPr>
          <a:xfrm>
            <a:off x="764860" y="4321654"/>
            <a:ext cx="2485497" cy="1042825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 defTabSz="1217889"/>
            <a:r>
              <a:rPr lang="en-US" dirty="0">
                <a:solidFill>
                  <a:prstClr val="white"/>
                </a:solidFill>
                <a:latin typeface="Arial Narrow"/>
              </a:rPr>
              <a:t>[Department 1]</a:t>
            </a:r>
          </a:p>
          <a:p>
            <a:pPr algn="ctr" defTabSz="1217889"/>
            <a:r>
              <a:rPr lang="en-US" sz="1600" dirty="0">
                <a:solidFill>
                  <a:prstClr val="white"/>
                </a:solidFill>
                <a:latin typeface="Arial Narrow"/>
              </a:rPr>
              <a:t>[Management Role]: [Name]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BC9F2C6C-A622-6453-55B0-A93790119DEC}"/>
              </a:ext>
            </a:extLst>
          </p:cNvPr>
          <p:cNvSpPr/>
          <p:nvPr/>
        </p:nvSpPr>
        <p:spPr>
          <a:xfrm>
            <a:off x="6879344" y="4314986"/>
            <a:ext cx="2485497" cy="1042825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 defTabSz="1217889"/>
            <a:r>
              <a:rPr lang="en-US" dirty="0">
                <a:solidFill>
                  <a:prstClr val="white"/>
                </a:solidFill>
                <a:latin typeface="Arial Narrow"/>
              </a:rPr>
              <a:t>[Laboratory Name]</a:t>
            </a:r>
          </a:p>
          <a:p>
            <a:pPr algn="ctr" defTabSz="1217889"/>
            <a:r>
              <a:rPr lang="en-US" sz="1600" dirty="0">
                <a:solidFill>
                  <a:prstClr val="white"/>
                </a:solidFill>
                <a:latin typeface="Arial Narrow"/>
              </a:rPr>
              <a:t>[Management Role]: [Name]</a:t>
            </a:r>
          </a:p>
        </p:txBody>
      </p: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FA32D3DF-8446-5AE3-3D82-FCA6AA8F80B9}"/>
              </a:ext>
            </a:extLst>
          </p:cNvPr>
          <p:cNvSpPr/>
          <p:nvPr/>
        </p:nvSpPr>
        <p:spPr>
          <a:xfrm>
            <a:off x="3822102" y="4321653"/>
            <a:ext cx="2485497" cy="1042825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 defTabSz="1217889"/>
            <a:r>
              <a:rPr lang="en-US" dirty="0">
                <a:solidFill>
                  <a:prstClr val="white"/>
                </a:solidFill>
                <a:latin typeface="Arial Narrow"/>
              </a:rPr>
              <a:t>[Department 2]</a:t>
            </a:r>
          </a:p>
          <a:p>
            <a:pPr algn="ctr" defTabSz="1217889"/>
            <a:r>
              <a:rPr lang="en-US" sz="1600" dirty="0">
                <a:solidFill>
                  <a:prstClr val="white"/>
                </a:solidFill>
                <a:latin typeface="Arial Narrow"/>
              </a:rPr>
              <a:t>[Management Role]: [Name]</a:t>
            </a: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F87652BD-25F9-AF1E-4F74-3A0B357A1937}"/>
              </a:ext>
            </a:extLst>
          </p:cNvPr>
          <p:cNvSpPr/>
          <p:nvPr/>
        </p:nvSpPr>
        <p:spPr>
          <a:xfrm>
            <a:off x="9925143" y="4321652"/>
            <a:ext cx="2485497" cy="1042825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 defTabSz="1217889"/>
            <a:r>
              <a:rPr lang="en-US" dirty="0">
                <a:solidFill>
                  <a:prstClr val="white"/>
                </a:solidFill>
                <a:latin typeface="Arial Narrow"/>
              </a:rPr>
              <a:t>[Department 3]:</a:t>
            </a:r>
          </a:p>
          <a:p>
            <a:pPr algn="ctr" defTabSz="1217889"/>
            <a:r>
              <a:rPr lang="en-US" sz="1600" dirty="0">
                <a:solidFill>
                  <a:prstClr val="white"/>
                </a:solidFill>
                <a:latin typeface="Arial Narrow"/>
              </a:rPr>
              <a:t>[Management Role]: [Name]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29BDCD46-D6C0-0BDC-DAE7-76660CD41B02}"/>
              </a:ext>
            </a:extLst>
          </p:cNvPr>
          <p:cNvSpPr/>
          <p:nvPr/>
        </p:nvSpPr>
        <p:spPr>
          <a:xfrm>
            <a:off x="12988181" y="4339353"/>
            <a:ext cx="2485497" cy="1042825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 defTabSz="1217889"/>
            <a:r>
              <a:rPr lang="en-US" dirty="0">
                <a:solidFill>
                  <a:prstClr val="white"/>
                </a:solidFill>
                <a:latin typeface="Arial Narrow"/>
              </a:rPr>
              <a:t>[Department 4]</a:t>
            </a:r>
          </a:p>
          <a:p>
            <a:pPr algn="ctr" defTabSz="1217889"/>
            <a:r>
              <a:rPr lang="en-US" sz="1600" dirty="0">
                <a:solidFill>
                  <a:prstClr val="white"/>
                </a:solidFill>
                <a:latin typeface="Arial Narrow"/>
              </a:rPr>
              <a:t>[Management Role]: [Name]</a:t>
            </a:r>
          </a:p>
        </p:txBody>
      </p:sp>
      <p:sp>
        <p:nvSpPr>
          <p:cNvPr id="15" name="Star: 5 Points 14">
            <a:extLst>
              <a:ext uri="{FF2B5EF4-FFF2-40B4-BE49-F238E27FC236}">
                <a16:creationId xmlns:a16="http://schemas.microsoft.com/office/drawing/2014/main" id="{8079A2E5-6894-C42A-EABD-69CEC6EB9004}"/>
              </a:ext>
            </a:extLst>
          </p:cNvPr>
          <p:cNvSpPr/>
          <p:nvPr/>
        </p:nvSpPr>
        <p:spPr>
          <a:xfrm>
            <a:off x="7015207" y="4439602"/>
            <a:ext cx="225665" cy="225665"/>
          </a:xfrm>
          <a:prstGeom prst="star5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3E4024BC-582C-0DD9-C905-88F1CAC25C7B}"/>
              </a:ext>
            </a:extLst>
          </p:cNvPr>
          <p:cNvSpPr/>
          <p:nvPr/>
        </p:nvSpPr>
        <p:spPr>
          <a:xfrm>
            <a:off x="3634926" y="6422882"/>
            <a:ext cx="2862743" cy="2029323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45720" rtlCol="0" anchor="t" anchorCtr="0"/>
          <a:lstStyle/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1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2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3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4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5]</a:t>
            </a:r>
          </a:p>
        </p:txBody>
      </p:sp>
      <p:sp>
        <p:nvSpPr>
          <p:cNvPr id="18" name="Rectangle: Rounded Corners 17">
            <a:extLst>
              <a:ext uri="{FF2B5EF4-FFF2-40B4-BE49-F238E27FC236}">
                <a16:creationId xmlns:a16="http://schemas.microsoft.com/office/drawing/2014/main" id="{DA24E9AC-0EE4-EAED-7343-62085B26AE47}"/>
              </a:ext>
            </a:extLst>
          </p:cNvPr>
          <p:cNvSpPr/>
          <p:nvPr/>
        </p:nvSpPr>
        <p:spPr>
          <a:xfrm>
            <a:off x="6682179" y="6419528"/>
            <a:ext cx="2862743" cy="2029323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45720" rtlCol="0" anchor="t" anchorCtr="0"/>
          <a:lstStyle/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1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2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3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4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5]</a:t>
            </a:r>
          </a:p>
        </p:txBody>
      </p:sp>
      <p:sp>
        <p:nvSpPr>
          <p:cNvPr id="19" name="Rectangle: Rounded Corners 18">
            <a:extLst>
              <a:ext uri="{FF2B5EF4-FFF2-40B4-BE49-F238E27FC236}">
                <a16:creationId xmlns:a16="http://schemas.microsoft.com/office/drawing/2014/main" id="{243A0F6B-54E6-92E1-0799-A8CFD88E8E62}"/>
              </a:ext>
            </a:extLst>
          </p:cNvPr>
          <p:cNvSpPr/>
          <p:nvPr/>
        </p:nvSpPr>
        <p:spPr>
          <a:xfrm>
            <a:off x="9736521" y="6422881"/>
            <a:ext cx="2862743" cy="2029323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45720" rtlCol="0" anchor="t" anchorCtr="0"/>
          <a:lstStyle/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1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2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3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4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5]</a:t>
            </a:r>
          </a:p>
        </p:txBody>
      </p:sp>
      <p:sp>
        <p:nvSpPr>
          <p:cNvPr id="20" name="Rectangle: Rounded Corners 19">
            <a:extLst>
              <a:ext uri="{FF2B5EF4-FFF2-40B4-BE49-F238E27FC236}">
                <a16:creationId xmlns:a16="http://schemas.microsoft.com/office/drawing/2014/main" id="{032D2EFF-F023-1F5F-348A-8BDC99C3F6CF}"/>
              </a:ext>
            </a:extLst>
          </p:cNvPr>
          <p:cNvSpPr/>
          <p:nvPr/>
        </p:nvSpPr>
        <p:spPr>
          <a:xfrm>
            <a:off x="12797955" y="6406989"/>
            <a:ext cx="2862743" cy="2029323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45720" rtlCol="0" anchor="t" anchorCtr="0"/>
          <a:lstStyle/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1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2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3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4]</a:t>
            </a:r>
          </a:p>
          <a:p>
            <a:pPr marL="91440" indent="-137160" defTabSz="1217889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prstClr val="white"/>
                </a:solidFill>
                <a:latin typeface="Arial Narrow" panose="020B0606020202030204" pitchFamily="34" charset="0"/>
              </a:rPr>
              <a:t>[Operating function  5]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858FF28-828A-5D62-EFC1-BA776333B0D0}"/>
              </a:ext>
            </a:extLst>
          </p:cNvPr>
          <p:cNvSpPr/>
          <p:nvPr/>
        </p:nvSpPr>
        <p:spPr>
          <a:xfrm flipH="1">
            <a:off x="175245" y="150393"/>
            <a:ext cx="12969254" cy="441195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mplat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004B397F-5DBA-900D-DA4F-4781A3D8C52B}"/>
              </a:ext>
            </a:extLst>
          </p:cNvPr>
          <p:cNvGrpSpPr/>
          <p:nvPr/>
        </p:nvGrpSpPr>
        <p:grpSpPr>
          <a:xfrm>
            <a:off x="13009667" y="147073"/>
            <a:ext cx="3053624" cy="1182290"/>
            <a:chOff x="1930437" y="1778484"/>
            <a:chExt cx="3053624" cy="1182290"/>
          </a:xfrm>
        </p:grpSpPr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2E529756-97A7-C052-BFFD-0643CD35AB72}"/>
                </a:ext>
              </a:extLst>
            </p:cNvPr>
            <p:cNvSpPr/>
            <p:nvPr/>
          </p:nvSpPr>
          <p:spPr>
            <a:xfrm>
              <a:off x="1930437" y="1778484"/>
              <a:ext cx="3053624" cy="1182290"/>
            </a:xfrm>
            <a:prstGeom prst="rect">
              <a:avLst/>
            </a:prstGeom>
            <a:solidFill>
              <a:srgbClr val="027CBA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ompany Logo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230" name="Graphic 229" descr="Image with solid fill">
              <a:extLst>
                <a:ext uri="{FF2B5EF4-FFF2-40B4-BE49-F238E27FC236}">
                  <a16:creationId xmlns:a16="http://schemas.microsoft.com/office/drawing/2014/main" id="{EBBF7018-51F6-3896-9C8C-C5DBB78E1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3136520" y="1889817"/>
              <a:ext cx="641457" cy="641457"/>
            </a:xfrm>
            <a:prstGeom prst="rect">
              <a:avLst/>
            </a:prstGeom>
          </p:spPr>
        </p:pic>
      </p:grpSp>
    </p:spTree>
    <p:custDataLst>
      <p:tags r:id="rId1"/>
    </p:custDataLst>
    <p:extLst>
      <p:ext uri="{BB962C8B-B14F-4D97-AF65-F5344CB8AC3E}">
        <p14:creationId xmlns:p14="http://schemas.microsoft.com/office/powerpoint/2010/main" val="572302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66683748-14D5-BBFE-AEE9-DB0FC861C10D}"/>
              </a:ext>
            </a:extLst>
          </p:cNvPr>
          <p:cNvCxnSpPr>
            <a:cxnSpLocks/>
          </p:cNvCxnSpPr>
          <p:nvPr/>
        </p:nvCxnSpPr>
        <p:spPr>
          <a:xfrm>
            <a:off x="2503766" y="6021592"/>
            <a:ext cx="0" cy="959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7" descr="User with solid fill">
            <a:extLst>
              <a:ext uri="{FF2B5EF4-FFF2-40B4-BE49-F238E27FC236}">
                <a16:creationId xmlns:a16="http://schemas.microsoft.com/office/drawing/2014/main" id="{D9559898-E952-6CEB-EDDD-3CFBACE746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966825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D5C5F78D-1053-3BF6-8B1C-A29DAE3E8F78}"/>
              </a:ext>
            </a:extLst>
          </p:cNvPr>
          <p:cNvCxnSpPr>
            <a:cxnSpLocks/>
          </p:cNvCxnSpPr>
          <p:nvPr/>
        </p:nvCxnSpPr>
        <p:spPr>
          <a:xfrm>
            <a:off x="8120642" y="2517939"/>
            <a:ext cx="0" cy="7470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itle 3">
            <a:extLst>
              <a:ext uri="{FF2B5EF4-FFF2-40B4-BE49-F238E27FC236}">
                <a16:creationId xmlns:a16="http://schemas.microsoft.com/office/drawing/2014/main" id="{7AF8CDC5-4C8B-EBEB-37CD-3256B7B5B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514" y="734247"/>
            <a:ext cx="6276713" cy="639372"/>
          </a:xfrm>
        </p:spPr>
        <p:txBody>
          <a:bodyPr>
            <a:noAutofit/>
          </a:bodyPr>
          <a:lstStyle/>
          <a:p>
            <a:pPr algn="ctr"/>
            <a:r>
              <a:rPr lang="en-US" sz="2664" b="1" dirty="0">
                <a:latin typeface="+mn-lt"/>
                <a:cs typeface="Arial" panose="020B0604020202020204" pitchFamily="34" charset="0"/>
              </a:rPr>
              <a:t>[Laboratory Name] </a:t>
            </a:r>
            <a:br>
              <a:rPr lang="en-US" sz="2664" b="1" dirty="0">
                <a:latin typeface="+mn-lt"/>
                <a:cs typeface="Arial" panose="020B0604020202020204" pitchFamily="34" charset="0"/>
              </a:rPr>
            </a:br>
            <a:r>
              <a:rPr lang="en-US" sz="2664" b="1" dirty="0">
                <a:latin typeface="+mn-lt"/>
                <a:cs typeface="Arial" panose="020B0604020202020204" pitchFamily="34" charset="0"/>
              </a:rPr>
              <a:t>Organizational Structure</a:t>
            </a:r>
            <a:endParaRPr lang="en-US" sz="1865" b="1" dirty="0">
              <a:latin typeface="+mn-lt"/>
              <a:cs typeface="Arial" panose="020B0604020202020204" pitchFamily="34" charset="0"/>
            </a:endParaRP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FBCFA57-450B-40A3-7C1C-08D15E1E68D0}"/>
              </a:ext>
            </a:extLst>
          </p:cNvPr>
          <p:cNvCxnSpPr>
            <a:cxnSpLocks/>
          </p:cNvCxnSpPr>
          <p:nvPr/>
        </p:nvCxnSpPr>
        <p:spPr>
          <a:xfrm flipV="1">
            <a:off x="2510859" y="3266158"/>
            <a:ext cx="11214076" cy="446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6858FF28-828A-5D62-EFC1-BA776333B0D0}"/>
              </a:ext>
            </a:extLst>
          </p:cNvPr>
          <p:cNvSpPr/>
          <p:nvPr/>
        </p:nvSpPr>
        <p:spPr>
          <a:xfrm flipH="1">
            <a:off x="175245" y="150393"/>
            <a:ext cx="12969254" cy="441195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emplat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004B397F-5DBA-900D-DA4F-4781A3D8C52B}"/>
              </a:ext>
            </a:extLst>
          </p:cNvPr>
          <p:cNvGrpSpPr/>
          <p:nvPr/>
        </p:nvGrpSpPr>
        <p:grpSpPr>
          <a:xfrm>
            <a:off x="13009667" y="147073"/>
            <a:ext cx="3053624" cy="1182290"/>
            <a:chOff x="1930437" y="1778484"/>
            <a:chExt cx="3053624" cy="1182290"/>
          </a:xfrm>
        </p:grpSpPr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2E529756-97A7-C052-BFFD-0643CD35AB72}"/>
                </a:ext>
              </a:extLst>
            </p:cNvPr>
            <p:cNvSpPr/>
            <p:nvPr/>
          </p:nvSpPr>
          <p:spPr>
            <a:xfrm>
              <a:off x="1930437" y="1778484"/>
              <a:ext cx="3053624" cy="1182290"/>
            </a:xfrm>
            <a:prstGeom prst="rect">
              <a:avLst/>
            </a:prstGeom>
            <a:solidFill>
              <a:srgbClr val="027CBA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ompany Logo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230" name="Graphic 229" descr="Image with solid fill">
              <a:extLst>
                <a:ext uri="{FF2B5EF4-FFF2-40B4-BE49-F238E27FC236}">
                  <a16:creationId xmlns:a16="http://schemas.microsoft.com/office/drawing/2014/main" id="{EBBF7018-51F6-3896-9C8C-C5DBB78E1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3136520" y="1889817"/>
              <a:ext cx="641457" cy="641457"/>
            </a:xfrm>
            <a:prstGeom prst="rect">
              <a:avLst/>
            </a:prstGeom>
          </p:spPr>
        </p:pic>
      </p:grpSp>
      <p:pic>
        <p:nvPicPr>
          <p:cNvPr id="3" name="Picture 17" descr="User with solid fill">
            <a:extLst>
              <a:ext uri="{FF2B5EF4-FFF2-40B4-BE49-F238E27FC236}">
                <a16:creationId xmlns:a16="http://schemas.microsoft.com/office/drawing/2014/main" id="{EBCCE832-CE61-FEB7-102C-032689F22D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966825" y="69905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A96782ED-77BF-CD6C-9547-F27B1C6776CB}"/>
              </a:ext>
            </a:extLst>
          </p:cNvPr>
          <p:cNvSpPr/>
          <p:nvPr/>
        </p:nvSpPr>
        <p:spPr>
          <a:xfrm>
            <a:off x="1227418" y="814229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17" descr="User with solid fill">
            <a:extLst>
              <a:ext uri="{FF2B5EF4-FFF2-40B4-BE49-F238E27FC236}">
                <a16:creationId xmlns:a16="http://schemas.microsoft.com/office/drawing/2014/main" id="{7955F025-0FB4-3EBD-164B-9FA1320BAF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7509137" y="928958"/>
            <a:ext cx="1220264" cy="1198800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47612DF0-08DB-0FD6-4807-7B6C5DE93B5B}"/>
              </a:ext>
            </a:extLst>
          </p:cNvPr>
          <p:cNvSpPr/>
          <p:nvPr/>
        </p:nvSpPr>
        <p:spPr>
          <a:xfrm>
            <a:off x="6172159" y="2257233"/>
            <a:ext cx="3894221" cy="687592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US" b="1" dirty="0">
                <a:solidFill>
                  <a:prstClr val="white"/>
                </a:solidFill>
                <a:latin typeface="Arial Narrow" panose="020B0606020202030204" pitchFamily="34" charset="0"/>
              </a:rPr>
              <a:t>[Director/Manager/Supervisor Name]</a:t>
            </a:r>
          </a:p>
          <a:p>
            <a:pPr algn="ctr"/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2C17D492-3C4E-FEDB-0DF1-17E4C0723BEF}"/>
              </a:ext>
            </a:extLst>
          </p:cNvPr>
          <p:cNvSpPr/>
          <p:nvPr/>
        </p:nvSpPr>
        <p:spPr>
          <a:xfrm>
            <a:off x="1227418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7891745-69A5-91D9-FAE0-20FEE5759797}"/>
              </a:ext>
            </a:extLst>
          </p:cNvPr>
          <p:cNvCxnSpPr>
            <a:cxnSpLocks/>
          </p:cNvCxnSpPr>
          <p:nvPr/>
        </p:nvCxnSpPr>
        <p:spPr>
          <a:xfrm>
            <a:off x="2510859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695EFDDB-1CE2-E8DE-6BF7-E9642D7165FC}"/>
              </a:ext>
            </a:extLst>
          </p:cNvPr>
          <p:cNvCxnSpPr>
            <a:cxnSpLocks/>
          </p:cNvCxnSpPr>
          <p:nvPr/>
        </p:nvCxnSpPr>
        <p:spPr>
          <a:xfrm>
            <a:off x="5307285" y="6021592"/>
            <a:ext cx="0" cy="959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17" descr="User with solid fill">
            <a:extLst>
              <a:ext uri="{FF2B5EF4-FFF2-40B4-BE49-F238E27FC236}">
                <a16:creationId xmlns:a16="http://schemas.microsoft.com/office/drawing/2014/main" id="{D1AEE8A8-2ED9-5092-0745-10DD788C47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4770344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pic>
        <p:nvPicPr>
          <p:cNvPr id="70" name="Picture 17" descr="User with solid fill">
            <a:extLst>
              <a:ext uri="{FF2B5EF4-FFF2-40B4-BE49-F238E27FC236}">
                <a16:creationId xmlns:a16="http://schemas.microsoft.com/office/drawing/2014/main" id="{83EC4CAD-7BD6-AC35-45CE-6EDC1EAE9D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4770344" y="69905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71" name="Rectangle: Rounded Corners 70">
            <a:extLst>
              <a:ext uri="{FF2B5EF4-FFF2-40B4-BE49-F238E27FC236}">
                <a16:creationId xmlns:a16="http://schemas.microsoft.com/office/drawing/2014/main" id="{8FFFC769-7969-9CC4-64A7-A8E4BD88F00A}"/>
              </a:ext>
            </a:extLst>
          </p:cNvPr>
          <p:cNvSpPr/>
          <p:nvPr/>
        </p:nvSpPr>
        <p:spPr>
          <a:xfrm>
            <a:off x="4030937" y="814229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Rectangle: Rounded Corners 71">
            <a:extLst>
              <a:ext uri="{FF2B5EF4-FFF2-40B4-BE49-F238E27FC236}">
                <a16:creationId xmlns:a16="http://schemas.microsoft.com/office/drawing/2014/main" id="{EE0F97DE-E5D5-B6B9-63BB-117093639A74}"/>
              </a:ext>
            </a:extLst>
          </p:cNvPr>
          <p:cNvSpPr/>
          <p:nvPr/>
        </p:nvSpPr>
        <p:spPr>
          <a:xfrm>
            <a:off x="4030937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1F9635D1-35D3-EE68-9CE1-D3E08EA28E35}"/>
              </a:ext>
            </a:extLst>
          </p:cNvPr>
          <p:cNvCxnSpPr>
            <a:cxnSpLocks/>
          </p:cNvCxnSpPr>
          <p:nvPr/>
        </p:nvCxnSpPr>
        <p:spPr>
          <a:xfrm>
            <a:off x="5314378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1FFCB423-4FD6-1772-5B7B-5A70FFE172DF}"/>
              </a:ext>
            </a:extLst>
          </p:cNvPr>
          <p:cNvCxnSpPr>
            <a:cxnSpLocks/>
          </p:cNvCxnSpPr>
          <p:nvPr/>
        </p:nvCxnSpPr>
        <p:spPr>
          <a:xfrm>
            <a:off x="8110804" y="6021592"/>
            <a:ext cx="0" cy="959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5" name="Picture 17" descr="User with solid fill">
            <a:extLst>
              <a:ext uri="{FF2B5EF4-FFF2-40B4-BE49-F238E27FC236}">
                <a16:creationId xmlns:a16="http://schemas.microsoft.com/office/drawing/2014/main" id="{2853FC31-A9AF-CCC6-C30E-CA4BD5F9F6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7573863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pic>
        <p:nvPicPr>
          <p:cNvPr id="76" name="Picture 17" descr="User with solid fill">
            <a:extLst>
              <a:ext uri="{FF2B5EF4-FFF2-40B4-BE49-F238E27FC236}">
                <a16:creationId xmlns:a16="http://schemas.microsoft.com/office/drawing/2014/main" id="{3E8D5572-BF51-43B5-6286-0B0177DD095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7573863" y="69905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77" name="Rectangle: Rounded Corners 76">
            <a:extLst>
              <a:ext uri="{FF2B5EF4-FFF2-40B4-BE49-F238E27FC236}">
                <a16:creationId xmlns:a16="http://schemas.microsoft.com/office/drawing/2014/main" id="{9C2D28AA-9F31-1002-937A-FDA34773867B}"/>
              </a:ext>
            </a:extLst>
          </p:cNvPr>
          <p:cNvSpPr/>
          <p:nvPr/>
        </p:nvSpPr>
        <p:spPr>
          <a:xfrm>
            <a:off x="6834456" y="814229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: Rounded Corners 77">
            <a:extLst>
              <a:ext uri="{FF2B5EF4-FFF2-40B4-BE49-F238E27FC236}">
                <a16:creationId xmlns:a16="http://schemas.microsoft.com/office/drawing/2014/main" id="{A6C5C9B5-C362-FC6C-CAAA-223A8E483E17}"/>
              </a:ext>
            </a:extLst>
          </p:cNvPr>
          <p:cNvSpPr/>
          <p:nvPr/>
        </p:nvSpPr>
        <p:spPr>
          <a:xfrm>
            <a:off x="6834456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A443FDC-2FF9-8E61-C85B-1E559E528281}"/>
              </a:ext>
            </a:extLst>
          </p:cNvPr>
          <p:cNvCxnSpPr>
            <a:cxnSpLocks/>
          </p:cNvCxnSpPr>
          <p:nvPr/>
        </p:nvCxnSpPr>
        <p:spPr>
          <a:xfrm>
            <a:off x="8117897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5207FB32-D034-0592-9819-7C33E2DC4D94}"/>
              </a:ext>
            </a:extLst>
          </p:cNvPr>
          <p:cNvCxnSpPr>
            <a:cxnSpLocks/>
          </p:cNvCxnSpPr>
          <p:nvPr/>
        </p:nvCxnSpPr>
        <p:spPr>
          <a:xfrm>
            <a:off x="10914323" y="6021592"/>
            <a:ext cx="0" cy="959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1" name="Picture 17" descr="User with solid fill">
            <a:extLst>
              <a:ext uri="{FF2B5EF4-FFF2-40B4-BE49-F238E27FC236}">
                <a16:creationId xmlns:a16="http://schemas.microsoft.com/office/drawing/2014/main" id="{93BB349F-48DA-55DC-1C76-A38753E6B9E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0377382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pic>
        <p:nvPicPr>
          <p:cNvPr id="82" name="Picture 17" descr="User with solid fill">
            <a:extLst>
              <a:ext uri="{FF2B5EF4-FFF2-40B4-BE49-F238E27FC236}">
                <a16:creationId xmlns:a16="http://schemas.microsoft.com/office/drawing/2014/main" id="{90E516A7-215C-8AD4-AF1F-D08523A2A0C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0377382" y="69905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83" name="Rectangle: Rounded Corners 82">
            <a:extLst>
              <a:ext uri="{FF2B5EF4-FFF2-40B4-BE49-F238E27FC236}">
                <a16:creationId xmlns:a16="http://schemas.microsoft.com/office/drawing/2014/main" id="{B7AA7911-CAD2-475E-28E9-EBB0BD3A9315}"/>
              </a:ext>
            </a:extLst>
          </p:cNvPr>
          <p:cNvSpPr/>
          <p:nvPr/>
        </p:nvSpPr>
        <p:spPr>
          <a:xfrm>
            <a:off x="9637975" y="814229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ectangle: Rounded Corners 83">
            <a:extLst>
              <a:ext uri="{FF2B5EF4-FFF2-40B4-BE49-F238E27FC236}">
                <a16:creationId xmlns:a16="http://schemas.microsoft.com/office/drawing/2014/main" id="{97CEE436-8E5E-3BB4-E977-27A82BD68440}"/>
              </a:ext>
            </a:extLst>
          </p:cNvPr>
          <p:cNvSpPr/>
          <p:nvPr/>
        </p:nvSpPr>
        <p:spPr>
          <a:xfrm>
            <a:off x="9637975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3D50058A-DFA2-6531-EFDD-2C84C0BB2A31}"/>
              </a:ext>
            </a:extLst>
          </p:cNvPr>
          <p:cNvCxnSpPr>
            <a:cxnSpLocks/>
          </p:cNvCxnSpPr>
          <p:nvPr/>
        </p:nvCxnSpPr>
        <p:spPr>
          <a:xfrm>
            <a:off x="10921416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61E6ADB0-C1BE-242F-361A-E46322B6B0B5}"/>
              </a:ext>
            </a:extLst>
          </p:cNvPr>
          <p:cNvCxnSpPr>
            <a:cxnSpLocks/>
          </p:cNvCxnSpPr>
          <p:nvPr/>
        </p:nvCxnSpPr>
        <p:spPr>
          <a:xfrm>
            <a:off x="13717842" y="6021592"/>
            <a:ext cx="0" cy="9594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7" name="Picture 17" descr="User with solid fill">
            <a:extLst>
              <a:ext uri="{FF2B5EF4-FFF2-40B4-BE49-F238E27FC236}">
                <a16:creationId xmlns:a16="http://schemas.microsoft.com/office/drawing/2014/main" id="{5C3F98B8-C288-DBF9-279C-09881CBB7F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3180901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pic>
        <p:nvPicPr>
          <p:cNvPr id="88" name="Picture 17" descr="User with solid fill">
            <a:extLst>
              <a:ext uri="{FF2B5EF4-FFF2-40B4-BE49-F238E27FC236}">
                <a16:creationId xmlns:a16="http://schemas.microsoft.com/office/drawing/2014/main" id="{01E4D9F3-1C4C-7C62-3A60-48569135EA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3180901" y="69905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89" name="Rectangle: Rounded Corners 88">
            <a:extLst>
              <a:ext uri="{FF2B5EF4-FFF2-40B4-BE49-F238E27FC236}">
                <a16:creationId xmlns:a16="http://schemas.microsoft.com/office/drawing/2014/main" id="{60CC2AD0-2C0C-7F57-388A-47F685BA3883}"/>
              </a:ext>
            </a:extLst>
          </p:cNvPr>
          <p:cNvSpPr/>
          <p:nvPr/>
        </p:nvSpPr>
        <p:spPr>
          <a:xfrm>
            <a:off x="12441494" y="814229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: Rounded Corners 89">
            <a:extLst>
              <a:ext uri="{FF2B5EF4-FFF2-40B4-BE49-F238E27FC236}">
                <a16:creationId xmlns:a16="http://schemas.microsoft.com/office/drawing/2014/main" id="{0A0F3AA3-DAB2-6A5C-FE05-3D71E1AA6761}"/>
              </a:ext>
            </a:extLst>
          </p:cNvPr>
          <p:cNvSpPr/>
          <p:nvPr/>
        </p:nvSpPr>
        <p:spPr>
          <a:xfrm>
            <a:off x="12441494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[Role]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ED890302-505D-C20D-F180-C1F26A6B903C}"/>
              </a:ext>
            </a:extLst>
          </p:cNvPr>
          <p:cNvCxnSpPr>
            <a:cxnSpLocks/>
          </p:cNvCxnSpPr>
          <p:nvPr/>
        </p:nvCxnSpPr>
        <p:spPr>
          <a:xfrm>
            <a:off x="13724935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28370628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29" name="Straight Connector 228">
            <a:extLst>
              <a:ext uri="{FF2B5EF4-FFF2-40B4-BE49-F238E27FC236}">
                <a16:creationId xmlns:a16="http://schemas.microsoft.com/office/drawing/2014/main" id="{66683748-14D5-BBFE-AEE9-DB0FC861C10D}"/>
              </a:ext>
            </a:extLst>
          </p:cNvPr>
          <p:cNvCxnSpPr>
            <a:cxnSpLocks/>
          </p:cNvCxnSpPr>
          <p:nvPr/>
        </p:nvCxnSpPr>
        <p:spPr>
          <a:xfrm>
            <a:off x="1451593" y="6757529"/>
            <a:ext cx="0" cy="383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7" descr="User with solid fill">
            <a:extLst>
              <a:ext uri="{FF2B5EF4-FFF2-40B4-BE49-F238E27FC236}">
                <a16:creationId xmlns:a16="http://schemas.microsoft.com/office/drawing/2014/main" id="{D9559898-E952-6CEB-EDDD-3CFBACE746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2329669" y="4351573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D5C5F78D-1053-3BF6-8B1C-A29DAE3E8F78}"/>
              </a:ext>
            </a:extLst>
          </p:cNvPr>
          <p:cNvCxnSpPr>
            <a:cxnSpLocks/>
          </p:cNvCxnSpPr>
          <p:nvPr/>
        </p:nvCxnSpPr>
        <p:spPr>
          <a:xfrm>
            <a:off x="8120642" y="2517939"/>
            <a:ext cx="0" cy="7470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itle 3">
            <a:extLst>
              <a:ext uri="{FF2B5EF4-FFF2-40B4-BE49-F238E27FC236}">
                <a16:creationId xmlns:a16="http://schemas.microsoft.com/office/drawing/2014/main" id="{7AF8CDC5-4C8B-EBEB-37CD-3256B7B5B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514" y="734247"/>
            <a:ext cx="6276713" cy="639372"/>
          </a:xfrm>
        </p:spPr>
        <p:txBody>
          <a:bodyPr>
            <a:noAutofit/>
          </a:bodyPr>
          <a:lstStyle/>
          <a:p>
            <a:pPr algn="ctr"/>
            <a:r>
              <a:rPr lang="en-US" sz="2664" b="1" dirty="0">
                <a:latin typeface="+mn-lt"/>
                <a:cs typeface="Arial" panose="020B0604020202020204" pitchFamily="34" charset="0"/>
              </a:rPr>
              <a:t>Quality Control Laboratory</a:t>
            </a:r>
            <a:br>
              <a:rPr lang="en-US" sz="2664" b="1" dirty="0">
                <a:latin typeface="+mn-lt"/>
                <a:cs typeface="Arial" panose="020B0604020202020204" pitchFamily="34" charset="0"/>
              </a:rPr>
            </a:br>
            <a:r>
              <a:rPr lang="en-US" sz="2664" b="1" dirty="0">
                <a:latin typeface="+mn-lt"/>
                <a:cs typeface="Arial" panose="020B0604020202020204" pitchFamily="34" charset="0"/>
              </a:rPr>
              <a:t>Organizational Structure</a:t>
            </a:r>
            <a:endParaRPr lang="en-US" sz="1865" b="1" dirty="0">
              <a:latin typeface="+mn-lt"/>
              <a:cs typeface="Arial" panose="020B0604020202020204" pitchFamily="34" charset="0"/>
            </a:endParaRP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CFBCFA57-450B-40A3-7C1C-08D15E1E68D0}"/>
              </a:ext>
            </a:extLst>
          </p:cNvPr>
          <p:cNvCxnSpPr>
            <a:cxnSpLocks/>
          </p:cNvCxnSpPr>
          <p:nvPr/>
        </p:nvCxnSpPr>
        <p:spPr>
          <a:xfrm flipV="1">
            <a:off x="2865044" y="3266158"/>
            <a:ext cx="10859891" cy="2074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6858FF28-828A-5D62-EFC1-BA776333B0D0}"/>
              </a:ext>
            </a:extLst>
          </p:cNvPr>
          <p:cNvSpPr/>
          <p:nvPr/>
        </p:nvSpPr>
        <p:spPr>
          <a:xfrm flipH="1">
            <a:off x="175245" y="150393"/>
            <a:ext cx="12969254" cy="441195"/>
          </a:xfrm>
          <a:prstGeom prst="rect">
            <a:avLst/>
          </a:prstGeom>
          <a:gradFill flip="none" rotWithShape="1">
            <a:gsLst>
              <a:gs pos="2000">
                <a:srgbClr val="027CBA"/>
              </a:gs>
              <a:gs pos="94000">
                <a:schemeClr val="accent1">
                  <a:lumMod val="5000"/>
                  <a:lumOff val="95000"/>
                </a:schemeClr>
              </a:gs>
            </a:gsLst>
            <a:lin ang="10800000" scaled="0"/>
            <a:tileRect/>
          </a:gra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xample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004B397F-5DBA-900D-DA4F-4781A3D8C52B}"/>
              </a:ext>
            </a:extLst>
          </p:cNvPr>
          <p:cNvGrpSpPr/>
          <p:nvPr/>
        </p:nvGrpSpPr>
        <p:grpSpPr>
          <a:xfrm>
            <a:off x="13009667" y="147073"/>
            <a:ext cx="3053624" cy="1182290"/>
            <a:chOff x="1930437" y="1778484"/>
            <a:chExt cx="3053624" cy="1182290"/>
          </a:xfrm>
        </p:grpSpPr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2E529756-97A7-C052-BFFD-0643CD35AB72}"/>
                </a:ext>
              </a:extLst>
            </p:cNvPr>
            <p:cNvSpPr/>
            <p:nvPr/>
          </p:nvSpPr>
          <p:spPr>
            <a:xfrm>
              <a:off x="1930437" y="1778484"/>
              <a:ext cx="3053624" cy="1182290"/>
            </a:xfrm>
            <a:prstGeom prst="rect">
              <a:avLst/>
            </a:prstGeom>
            <a:solidFill>
              <a:srgbClr val="027CBA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endParaRPr lang="en-US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solidFill>
                    <a:srgbClr val="FFFFFF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</a:rPr>
                <a:t>Company Logo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230" name="Graphic 229" descr="Image with solid fill">
              <a:extLst>
                <a:ext uri="{FF2B5EF4-FFF2-40B4-BE49-F238E27FC236}">
                  <a16:creationId xmlns:a16="http://schemas.microsoft.com/office/drawing/2014/main" id="{EBBF7018-51F6-3896-9C8C-C5DBB78E1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3136520" y="1889817"/>
              <a:ext cx="641457" cy="641457"/>
            </a:xfrm>
            <a:prstGeom prst="rect">
              <a:avLst/>
            </a:prstGeom>
          </p:spPr>
        </p:pic>
      </p:grpSp>
      <p:pic>
        <p:nvPicPr>
          <p:cNvPr id="3" name="Picture 17" descr="User with solid fill">
            <a:extLst>
              <a:ext uri="{FF2B5EF4-FFF2-40B4-BE49-F238E27FC236}">
                <a16:creationId xmlns:a16="http://schemas.microsoft.com/office/drawing/2014/main" id="{EBCCE832-CE61-FEB7-102C-032689F22D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914652" y="715089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A96782ED-77BF-CD6C-9547-F27B1C6776CB}"/>
              </a:ext>
            </a:extLst>
          </p:cNvPr>
          <p:cNvSpPr/>
          <p:nvPr/>
        </p:nvSpPr>
        <p:spPr>
          <a:xfrm>
            <a:off x="175245" y="830264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Microbiologi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17" descr="User with solid fill">
            <a:extLst>
              <a:ext uri="{FF2B5EF4-FFF2-40B4-BE49-F238E27FC236}">
                <a16:creationId xmlns:a16="http://schemas.microsoft.com/office/drawing/2014/main" id="{7955F025-0FB4-3EBD-164B-9FA1320BAF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7509137" y="928958"/>
            <a:ext cx="1220264" cy="1198800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47612DF0-08DB-0FD6-4807-7B6C5DE93B5B}"/>
              </a:ext>
            </a:extLst>
          </p:cNvPr>
          <p:cNvSpPr/>
          <p:nvPr/>
        </p:nvSpPr>
        <p:spPr>
          <a:xfrm>
            <a:off x="6172159" y="2257233"/>
            <a:ext cx="3894221" cy="687592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en-US" b="1" dirty="0">
                <a:solidFill>
                  <a:prstClr val="white"/>
                </a:solidFill>
                <a:latin typeface="Arial Narrow" panose="020B0606020202030204" pitchFamily="34" charset="0"/>
              </a:rPr>
              <a:t>[Name]</a:t>
            </a:r>
          </a:p>
          <a:p>
            <a:pPr algn="ctr"/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Quality Control Laboratory Manager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2C17D492-3C4E-FEDB-0DF1-17E4C0723BEF}"/>
              </a:ext>
            </a:extLst>
          </p:cNvPr>
          <p:cNvSpPr/>
          <p:nvPr/>
        </p:nvSpPr>
        <p:spPr>
          <a:xfrm>
            <a:off x="1590262" y="5512848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Microbiology Superviso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F7891745-69A5-91D9-FAE0-20FEE5759797}"/>
              </a:ext>
            </a:extLst>
          </p:cNvPr>
          <p:cNvCxnSpPr>
            <a:cxnSpLocks/>
          </p:cNvCxnSpPr>
          <p:nvPr/>
        </p:nvCxnSpPr>
        <p:spPr>
          <a:xfrm>
            <a:off x="2865044" y="3292601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5" name="Picture 17" descr="User with solid fill">
            <a:extLst>
              <a:ext uri="{FF2B5EF4-FFF2-40B4-BE49-F238E27FC236}">
                <a16:creationId xmlns:a16="http://schemas.microsoft.com/office/drawing/2014/main" id="{2853FC31-A9AF-CCC6-C30E-CA4BD5F9F6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7573863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78" name="Rectangle: Rounded Corners 77">
            <a:extLst>
              <a:ext uri="{FF2B5EF4-FFF2-40B4-BE49-F238E27FC236}">
                <a16:creationId xmlns:a16="http://schemas.microsoft.com/office/drawing/2014/main" id="{A6C5C9B5-C362-FC6C-CAAA-223A8E483E17}"/>
              </a:ext>
            </a:extLst>
          </p:cNvPr>
          <p:cNvSpPr/>
          <p:nvPr/>
        </p:nvSpPr>
        <p:spPr>
          <a:xfrm>
            <a:off x="6834456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Chemistry Superviso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A443FDC-2FF9-8E61-C85B-1E559E528281}"/>
              </a:ext>
            </a:extLst>
          </p:cNvPr>
          <p:cNvCxnSpPr>
            <a:cxnSpLocks/>
          </p:cNvCxnSpPr>
          <p:nvPr/>
        </p:nvCxnSpPr>
        <p:spPr>
          <a:xfrm>
            <a:off x="8117897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7" name="Picture 17" descr="User with solid fill">
            <a:extLst>
              <a:ext uri="{FF2B5EF4-FFF2-40B4-BE49-F238E27FC236}">
                <a16:creationId xmlns:a16="http://schemas.microsoft.com/office/drawing/2014/main" id="{5C3F98B8-C288-DBF9-279C-09881CBB7FA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3180901" y="4328444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90" name="Rectangle: Rounded Corners 89">
            <a:extLst>
              <a:ext uri="{FF2B5EF4-FFF2-40B4-BE49-F238E27FC236}">
                <a16:creationId xmlns:a16="http://schemas.microsoft.com/office/drawing/2014/main" id="{0A0F3AA3-DAB2-6A5C-FE05-3D71E1AA6761}"/>
              </a:ext>
            </a:extLst>
          </p:cNvPr>
          <p:cNvSpPr/>
          <p:nvPr/>
        </p:nvSpPr>
        <p:spPr>
          <a:xfrm>
            <a:off x="12441494" y="5489719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enior QC Analy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ED890302-505D-C20D-F180-C1F26A6B903C}"/>
              </a:ext>
            </a:extLst>
          </p:cNvPr>
          <p:cNvCxnSpPr>
            <a:cxnSpLocks/>
          </p:cNvCxnSpPr>
          <p:nvPr/>
        </p:nvCxnSpPr>
        <p:spPr>
          <a:xfrm>
            <a:off x="13724935" y="3280272"/>
            <a:ext cx="0" cy="103584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BC2C93DE-FB9B-9E2F-993B-F57F362F0F5F}"/>
              </a:ext>
            </a:extLst>
          </p:cNvPr>
          <p:cNvCxnSpPr>
            <a:cxnSpLocks/>
          </p:cNvCxnSpPr>
          <p:nvPr/>
        </p:nvCxnSpPr>
        <p:spPr>
          <a:xfrm>
            <a:off x="2811311" y="6010439"/>
            <a:ext cx="0" cy="7470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31E3D9E-24FF-B9D9-9DDA-C98D716CC969}"/>
              </a:ext>
            </a:extLst>
          </p:cNvPr>
          <p:cNvCxnSpPr>
            <a:cxnSpLocks/>
          </p:cNvCxnSpPr>
          <p:nvPr/>
        </p:nvCxnSpPr>
        <p:spPr>
          <a:xfrm flipV="1">
            <a:off x="1451593" y="6757529"/>
            <a:ext cx="2701307" cy="112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065F943-B493-924A-1824-3D29FD6D4EAD}"/>
              </a:ext>
            </a:extLst>
          </p:cNvPr>
          <p:cNvCxnSpPr>
            <a:cxnSpLocks/>
          </p:cNvCxnSpPr>
          <p:nvPr/>
        </p:nvCxnSpPr>
        <p:spPr>
          <a:xfrm>
            <a:off x="4152900" y="6757529"/>
            <a:ext cx="0" cy="3584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17" descr="User with solid fill">
            <a:extLst>
              <a:ext uri="{FF2B5EF4-FFF2-40B4-BE49-F238E27FC236}">
                <a16:creationId xmlns:a16="http://schemas.microsoft.com/office/drawing/2014/main" id="{0727C9E8-90B9-C996-C369-142906FFD63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3591832" y="7141371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E6FD9625-DC72-86EF-8796-59D524D8D1A3}"/>
              </a:ext>
            </a:extLst>
          </p:cNvPr>
          <p:cNvSpPr/>
          <p:nvPr/>
        </p:nvSpPr>
        <p:spPr>
          <a:xfrm>
            <a:off x="2861854" y="8293121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Microbiologi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9" name="Straight Connector 238">
            <a:extLst>
              <a:ext uri="{FF2B5EF4-FFF2-40B4-BE49-F238E27FC236}">
                <a16:creationId xmlns:a16="http://schemas.microsoft.com/office/drawing/2014/main" id="{B69DD65D-7BC6-E631-0F4C-67602C4E2EF5}"/>
              </a:ext>
            </a:extLst>
          </p:cNvPr>
          <p:cNvCxnSpPr>
            <a:cxnSpLocks/>
          </p:cNvCxnSpPr>
          <p:nvPr/>
        </p:nvCxnSpPr>
        <p:spPr>
          <a:xfrm>
            <a:off x="6824309" y="6757529"/>
            <a:ext cx="0" cy="3838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0" name="Picture 17" descr="User with solid fill">
            <a:extLst>
              <a:ext uri="{FF2B5EF4-FFF2-40B4-BE49-F238E27FC236}">
                <a16:creationId xmlns:a16="http://schemas.microsoft.com/office/drawing/2014/main" id="{E752F36C-3DBB-6AB7-948B-BCFCCF60C1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6287368" y="715089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241" name="Rectangle: Rounded Corners 240">
            <a:extLst>
              <a:ext uri="{FF2B5EF4-FFF2-40B4-BE49-F238E27FC236}">
                <a16:creationId xmlns:a16="http://schemas.microsoft.com/office/drawing/2014/main" id="{0234E7A0-67D7-2321-5623-62A6521F9D50}"/>
              </a:ext>
            </a:extLst>
          </p:cNvPr>
          <p:cNvSpPr/>
          <p:nvPr/>
        </p:nvSpPr>
        <p:spPr>
          <a:xfrm>
            <a:off x="5548463" y="830264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Chemi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2" name="Straight Connector 241">
            <a:extLst>
              <a:ext uri="{FF2B5EF4-FFF2-40B4-BE49-F238E27FC236}">
                <a16:creationId xmlns:a16="http://schemas.microsoft.com/office/drawing/2014/main" id="{3831ED98-BAB3-FE5F-BEF8-6E92B5BADE08}"/>
              </a:ext>
            </a:extLst>
          </p:cNvPr>
          <p:cNvCxnSpPr>
            <a:cxnSpLocks/>
          </p:cNvCxnSpPr>
          <p:nvPr/>
        </p:nvCxnSpPr>
        <p:spPr>
          <a:xfrm>
            <a:off x="8119868" y="6010439"/>
            <a:ext cx="0" cy="74709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3" name="Straight Connector 242">
            <a:extLst>
              <a:ext uri="{FF2B5EF4-FFF2-40B4-BE49-F238E27FC236}">
                <a16:creationId xmlns:a16="http://schemas.microsoft.com/office/drawing/2014/main" id="{B58379E2-ED71-8E70-EEF2-A02BB0AA7786}"/>
              </a:ext>
            </a:extLst>
          </p:cNvPr>
          <p:cNvCxnSpPr>
            <a:cxnSpLocks/>
          </p:cNvCxnSpPr>
          <p:nvPr/>
        </p:nvCxnSpPr>
        <p:spPr>
          <a:xfrm>
            <a:off x="6821756" y="6757529"/>
            <a:ext cx="262700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B860B393-C54F-B8ED-B11C-769C8839C728}"/>
              </a:ext>
            </a:extLst>
          </p:cNvPr>
          <p:cNvCxnSpPr>
            <a:cxnSpLocks/>
          </p:cNvCxnSpPr>
          <p:nvPr/>
        </p:nvCxnSpPr>
        <p:spPr>
          <a:xfrm>
            <a:off x="9448757" y="6757529"/>
            <a:ext cx="0" cy="3584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5" name="Picture 17" descr="User with solid fill">
            <a:extLst>
              <a:ext uri="{FF2B5EF4-FFF2-40B4-BE49-F238E27FC236}">
                <a16:creationId xmlns:a16="http://schemas.microsoft.com/office/drawing/2014/main" id="{A0C9C8B3-7B81-B371-7001-67C6C79151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8942149" y="7141371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246" name="Rectangle: Rounded Corners 245">
            <a:extLst>
              <a:ext uri="{FF2B5EF4-FFF2-40B4-BE49-F238E27FC236}">
                <a16:creationId xmlns:a16="http://schemas.microsoft.com/office/drawing/2014/main" id="{CE0B283C-F038-42A7-EB48-4336FE62D2E8}"/>
              </a:ext>
            </a:extLst>
          </p:cNvPr>
          <p:cNvSpPr/>
          <p:nvPr/>
        </p:nvSpPr>
        <p:spPr>
          <a:xfrm>
            <a:off x="8235072" y="8302646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QC Chemist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9" name="Picture 17" descr="User with solid fill">
            <a:extLst>
              <a:ext uri="{FF2B5EF4-FFF2-40B4-BE49-F238E27FC236}">
                <a16:creationId xmlns:a16="http://schemas.microsoft.com/office/drawing/2014/main" id="{045839B6-9C34-F7F8-61D6-81E7910E0E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879" b="879"/>
          <a:stretch/>
        </p:blipFill>
        <p:spPr>
          <a:xfrm>
            <a:off x="13180901" y="7131846"/>
            <a:ext cx="1102251" cy="1082863"/>
          </a:xfrm>
          <a:prstGeom prst="roundRect">
            <a:avLst/>
          </a:prstGeom>
          <a:ln w="28575">
            <a:solidFill>
              <a:srgbClr val="007CBB"/>
            </a:solidFill>
          </a:ln>
        </p:spPr>
      </p:pic>
      <p:sp>
        <p:nvSpPr>
          <p:cNvPr id="250" name="Rectangle: Rounded Corners 249">
            <a:extLst>
              <a:ext uri="{FF2B5EF4-FFF2-40B4-BE49-F238E27FC236}">
                <a16:creationId xmlns:a16="http://schemas.microsoft.com/office/drawing/2014/main" id="{B19C3410-31FE-39AE-5433-3732EAC75609}"/>
              </a:ext>
            </a:extLst>
          </p:cNvPr>
          <p:cNvSpPr/>
          <p:nvPr/>
        </p:nvSpPr>
        <p:spPr>
          <a:xfrm>
            <a:off x="12441494" y="8293121"/>
            <a:ext cx="2552696" cy="524946"/>
          </a:xfrm>
          <a:prstGeom prst="roundRect">
            <a:avLst/>
          </a:prstGeom>
          <a:solidFill>
            <a:srgbClr val="007CBB"/>
          </a:solidFill>
          <a:ln>
            <a:solidFill>
              <a:srgbClr val="007CBB"/>
            </a:solidFill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[Name]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Laboratory Technicia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9657527C-1979-D3D7-632B-B950CEF63108}"/>
              </a:ext>
            </a:extLst>
          </p:cNvPr>
          <p:cNvCxnSpPr>
            <a:cxnSpLocks/>
            <a:endCxn id="249" idx="0"/>
          </p:cNvCxnSpPr>
          <p:nvPr/>
        </p:nvCxnSpPr>
        <p:spPr>
          <a:xfrm>
            <a:off x="13717842" y="6021592"/>
            <a:ext cx="14185" cy="11102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85334332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PERSISTENCEDATA" val="MMPROD_UIPERSISTENCEDATA"/>
  <p:tag name="MMPROD_UIDATA" val="&lt;database version=&quot;11.0&quot;&gt;&lt;object type=&quot;1&quot; unique_id=&quot;10001&quot;&gt;&lt;object type=&quot;2&quot; unique_id=&quot;147014&quot;&gt;&lt;object type=&quot;3&quot; unique_id=&quot;166385&quot;&gt;&lt;property id=&quot;20148&quot; value=&quot;5&quot;/&gt;&lt;property id=&quot;20300&quot; value=&quot;Slide 1 - &amp;quot;Ethnographic Field Research Findings:  Site #1, Millington, TN&amp;quot;&quot;/&gt;&lt;property id=&quot;20307&quot; value=&quot;507&quot;/&gt;&lt;/object&gt;&lt;object type=&quot;3&quot; unique_id=&quot;166386&quot;&gt;&lt;property id=&quot;20148&quot; value=&quot;5&quot;/&gt;&lt;property id=&quot;20300&quot; value=&quot;Slide 2 - &amp;quot;Table of Contents&amp;quot;&quot;/&gt;&lt;property id=&quot;20307&quot; value=&quot;508&quot;/&gt;&lt;/object&gt;&lt;object type=&quot;3&quot; unique_id=&quot;166387&quot;&gt;&lt;property id=&quot;20148&quot; value=&quot;5&quot;/&gt;&lt;property id=&quot;20300&quot; value=&quot;Slide 3 - &amp;quot;Week Overview&amp;quot;&quot;/&gt;&lt;property id=&quot;20307&quot; value=&quot;515&quot;/&gt;&lt;/object&gt;&lt;object type=&quot;3&quot; unique_id=&quot;166390&quot;&gt;&lt;property id=&quot;20148&quot; value=&quot;5&quot;/&gt;&lt;property id=&quot;20300&quot; value=&quot;Slide 7 - &amp;quot;Soundbites from Millington&amp;quot;&quot;/&gt;&lt;property id=&quot;20307&quot; value=&quot;518&quot;/&gt;&lt;/object&gt;&lt;object type=&quot;3&quot; unique_id=&quot;166391&quot;&gt;&lt;property id=&quot;20148&quot; value=&quot;5&quot;/&gt;&lt;property id=&quot;20300&quot; value=&quot;Slide 8 - &amp;quot;Postcards from the Field&amp;quot;&quot;/&gt;&lt;property id=&quot;20307&quot; value=&quot;510&quot;/&gt;&lt;/object&gt;&lt;object type=&quot;3&quot; unique_id=&quot;166393&quot;&gt;&lt;property id=&quot;20148&quot; value=&quot;5&quot;/&gt;&lt;property id=&quot;20300&quot; value=&quot;Slide 9 - &amp;quot;Next Week: Home Research &amp;amp; Synthesis Week&amp;quot;&quot;/&gt;&lt;property id=&quot;20307&quot; value=&quot;519&quot;/&gt;&lt;/object&gt;&lt;object type=&quot;3&quot; unique_id=&quot;166394&quot;&gt;&lt;property id=&quot;20148&quot; value=&quot;5&quot;/&gt;&lt;property id=&quot;20300&quot; value=&quot;Slide 13 - &amp;quot;Appendix&amp;quot;&quot;/&gt;&lt;property id=&quot;20307&quot; value=&quot;511&quot;/&gt;&lt;/object&gt;&lt;object type=&quot;3&quot; unique_id=&quot;166395&quot;&gt;&lt;property id=&quot;20148&quot; value=&quot;5&quot;/&gt;&lt;property id=&quot;20300&quot; value=&quot;Slide 14 - &amp;quot;Quick Note on Ethnographic Research&amp;quot;&quot;/&gt;&lt;property id=&quot;20307&quot; value=&quot;512&quot;/&gt;&lt;/object&gt;&lt;object type=&quot;3&quot; unique_id=&quot;904643&quot;&gt;&lt;property id=&quot;20148&quot; value=&quot;5&quot;/&gt;&lt;property id=&quot;20300&quot; value=&quot;Slide 6 - &amp;quot;Early Findings from Millington (3 of 3)&amp;quot;&quot;/&gt;&lt;property id=&quot;20307&quot; value=&quot;525&quot;/&gt;&lt;/object&gt;&lt;object type=&quot;3&quot; unique_id=&quot;904644&quot;&gt;&lt;property id=&quot;20148&quot; value=&quot;5&quot;/&gt;&lt;property id=&quot;20300&quot; value=&quot;Slide 10 - &amp;quot;Updated Performance Analysis Timeline (1 of 3)&amp;quot;&quot;/&gt;&lt;property id=&quot;20307&quot; value=&quot;522&quot;/&gt;&lt;/object&gt;&lt;object type=&quot;3&quot; unique_id=&quot;904645&quot;&gt;&lt;property id=&quot;20148&quot; value=&quot;5&quot;/&gt;&lt;property id=&quot;20300&quot; value=&quot;Slide 11 - &amp;quot;Updated Performance Analysis Timeline (2 of 3)&amp;quot;&quot;/&gt;&lt;property id=&quot;20307&quot; value=&quot;523&quot;/&gt;&lt;/object&gt;&lt;object type=&quot;3&quot; unique_id=&quot;904646&quot;&gt;&lt;property id=&quot;20148&quot; value=&quot;5&quot;/&gt;&lt;property id=&quot;20300&quot; value=&quot;Slide 12 - &amp;quot;Updated Performance Analysis Timeline (3 of 3)&amp;quot;&quot;/&gt;&lt;property id=&quot;20307&quot; value=&quot;524&quot;/&gt;&lt;/object&gt;&lt;object type=&quot;3&quot; unique_id=&quot;904762&quot;&gt;&lt;property id=&quot;20148&quot; value=&quot;5&quot;/&gt;&lt;property id=&quot;20300&quot; value=&quot;Slide 4 - &amp;quot;Early Findings from Millington (1 of 3)&amp;quot;&quot;/&gt;&lt;property id=&quot;20307&quot; value=&quot;526&quot;/&gt;&lt;/object&gt;&lt;object type=&quot;3&quot; unique_id=&quot;904763&quot;&gt;&lt;property id=&quot;20148&quot; value=&quot;5&quot;/&gt;&lt;property id=&quot;20300&quot; value=&quot;Slide 5 - &amp;quot;Early Findings from Millington (2 of 3)&amp;quot;&quot;/&gt;&lt;property id=&quot;20307&quot; value=&quot;527&quot;/&gt;&lt;/object&gt;&lt;/object&gt;&lt;object type=&quot;8&quot; unique_id=&quot;147216&quot;&gt;&lt;/object&gt;&lt;/object&gt;&lt;/database&gt;"/>
  <p:tag name="SECTOMILLISECCONVERTED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0867c8d-1cc9-4acd-a073-94634f6a764f" xsi:nil="true"/>
    <lcf76f155ced4ddcb4097134ff3c332f xmlns="bc6fc9a0-8cf0-435b-a5c3-787b2fe5bedd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D24004269783F4484DD1848A00DFD3B" ma:contentTypeVersion="14" ma:contentTypeDescription="Create a new document." ma:contentTypeScope="" ma:versionID="949d91f85b0396c07df2e601f29e3eab">
  <xsd:schema xmlns:xsd="http://www.w3.org/2001/XMLSchema" xmlns:xs="http://www.w3.org/2001/XMLSchema" xmlns:p="http://schemas.microsoft.com/office/2006/metadata/properties" xmlns:ns2="bc6fc9a0-8cf0-435b-a5c3-787b2fe5bedd" xmlns:ns3="20867c8d-1cc9-4acd-a073-94634f6a764f" targetNamespace="http://schemas.microsoft.com/office/2006/metadata/properties" ma:root="true" ma:fieldsID="9dc925c5a342fbd71a3badc790b9c820" ns2:_="" ns3:_="">
    <xsd:import namespace="bc6fc9a0-8cf0-435b-a5c3-787b2fe5bedd"/>
    <xsd:import namespace="20867c8d-1cc9-4acd-a073-94634f6a764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LengthInSecond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c6fc9a0-8cf0-435b-a5c3-787b2fe5bed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79cf906e-e933-44a8-8421-1c91ada6f122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0867c8d-1cc9-4acd-a073-94634f6a764f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bf2d2cf4-37d0-44af-aad9-3d314cc6947a}" ma:internalName="TaxCatchAll" ma:showField="CatchAllData" ma:web="7467b07a-63e4-4526-818f-48c6a4d2dc7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7425232-6F52-4FCC-A15E-AFEE21E7653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DE3A1B6-05E9-4C78-AFA4-D86EC54658AA}">
  <ds:schemaRefs>
    <ds:schemaRef ds:uri="http://purl.org/dc/elements/1.1/"/>
    <ds:schemaRef ds:uri="20867c8d-1cc9-4acd-a073-94634f6a764f"/>
    <ds:schemaRef ds:uri="http://schemas.microsoft.com/office/infopath/2007/PartnerControls"/>
    <ds:schemaRef ds:uri="bc6fc9a0-8cf0-435b-a5c3-787b2fe5bedd"/>
    <ds:schemaRef ds:uri="http://purl.org/dc/terms/"/>
    <ds:schemaRef ds:uri="http://schemas.microsoft.com/office/2006/metadata/properties"/>
    <ds:schemaRef ds:uri="http://schemas.microsoft.com/office/2006/documentManagement/typ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B44C0A0A-D577-45D7-AD5E-F8F33BB6A3B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c6fc9a0-8cf0-435b-a5c3-787b2fe5bedd"/>
    <ds:schemaRef ds:uri="20867c8d-1cc9-4acd-a073-94634f6a764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7d2fdb41-339c-4257-87f2-a665730b31fc}" enabled="0" method="" siteId="{7d2fdb41-339c-4257-87f2-a665730b31f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DD-PresentationTemplate_16x9</Template>
  <TotalTime>532</TotalTime>
  <Words>341</Words>
  <Application>Microsoft Office PowerPoint</Application>
  <PresentationFormat>Custom</PresentationFormat>
  <Paragraphs>9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Arial Narrow</vt:lpstr>
      <vt:lpstr>Calibri</vt:lpstr>
      <vt:lpstr>Calibri Light</vt:lpstr>
      <vt:lpstr>Times New Roman</vt:lpstr>
      <vt:lpstr>Office Theme</vt:lpstr>
      <vt:lpstr>[Company Name], [Laboratory Name] Organizational Structure</vt:lpstr>
      <vt:lpstr>[Laboratory Name]  Organizational Structure</vt:lpstr>
      <vt:lpstr>Quality Control Laboratory Organizational Structure</vt:lpstr>
    </vt:vector>
  </TitlesOfParts>
  <Company>Deloit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[Company Name], [Laboratory Name] Organizational Structure</dc:title>
  <dc:creator/>
  <cp:lastModifiedBy>Fox, Elizabeth</cp:lastModifiedBy>
  <cp:revision>132</cp:revision>
  <cp:lastPrinted>2024-01-03T15:59:18Z</cp:lastPrinted>
  <dcterms:created xsi:type="dcterms:W3CDTF">2017-12-21T22:11:31Z</dcterms:created>
  <dcterms:modified xsi:type="dcterms:W3CDTF">2025-03-19T15:45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D24004269783F4484DD1848A00DFD3B</vt:lpwstr>
  </property>
  <property fmtid="{D5CDD505-2E9C-101B-9397-08002B2CF9AE}" pid="3" name="MediaServiceImageTags">
    <vt:lpwstr/>
  </property>
</Properties>
</file>